
<file path=[Content_Types].xml><?xml version="1.0" encoding="utf-8"?>
<Types xmlns="http://schemas.openxmlformats.org/package/2006/content-types">
  <Default Extension="png" ContentType="image/png"/>
  <Default Extension="wmf" ContentType="image/x-w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handoutMasterIdLst>
    <p:handoutMasterId r:id="rId10"/>
  </p:handoutMasterIdLst>
  <p:sldIdLst>
    <p:sldId id="655" r:id="rId2"/>
    <p:sldId id="664" r:id="rId3"/>
    <p:sldId id="656" r:id="rId4"/>
    <p:sldId id="658" r:id="rId5"/>
    <p:sldId id="657" r:id="rId6"/>
    <p:sldId id="659" r:id="rId7"/>
    <p:sldId id="663" r:id="rId8"/>
  </p:sldIdLst>
  <p:sldSz cx="6858000" cy="9144000" type="screen4x3"/>
  <p:notesSz cx="6794500" cy="9906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009900"/>
    <a:srgbClr val="000099"/>
    <a:srgbClr val="984807"/>
    <a:srgbClr val="C3D69B"/>
    <a:srgbClr val="006600"/>
    <a:srgbClr val="00FFFF"/>
    <a:srgbClr val="558ED5"/>
    <a:srgbClr val="6600CC"/>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5074" autoAdjust="0"/>
    <p:restoredTop sz="94444" autoAdjust="0"/>
  </p:normalViewPr>
  <p:slideViewPr>
    <p:cSldViewPr>
      <p:cViewPr>
        <p:scale>
          <a:sx n="100" d="100"/>
          <a:sy n="100" d="100"/>
        </p:scale>
        <p:origin x="-1332" y="72"/>
      </p:cViewPr>
      <p:guideLst>
        <p:guide orient="horz" pos="2880"/>
        <p:guide pos="2160"/>
      </p:guideLst>
    </p:cSldViewPr>
  </p:slideViewPr>
  <p:outlineViewPr>
    <p:cViewPr>
      <p:scale>
        <a:sx n="33" d="100"/>
        <a:sy n="33" d="100"/>
      </p:scale>
      <p:origin x="0" y="0"/>
    </p:cViewPr>
  </p:outlineViewPr>
  <p:notesTextViewPr>
    <p:cViewPr>
      <p:scale>
        <a:sx n="1" d="1"/>
        <a:sy n="1" d="1"/>
      </p:scale>
      <p:origin x="0" y="0"/>
    </p:cViewPr>
  </p:notesTextViewPr>
  <p:sorterViewPr>
    <p:cViewPr>
      <p:scale>
        <a:sx n="90" d="100"/>
        <a:sy n="9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handoutMaster" Target="handoutMasters/handoutMaster1.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4283" cy="49461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48645" y="0"/>
            <a:ext cx="2944283" cy="494618"/>
          </a:xfrm>
          <a:prstGeom prst="rect">
            <a:avLst/>
          </a:prstGeom>
        </p:spPr>
        <p:txBody>
          <a:bodyPr vert="horz" lIns="91440" tIns="45720" rIns="91440" bIns="45720" rtlCol="0"/>
          <a:lstStyle>
            <a:lvl1pPr algn="r">
              <a:defRPr sz="1200"/>
            </a:lvl1pPr>
          </a:lstStyle>
          <a:p>
            <a:fld id="{8373B15C-38EF-4436-8604-B7FA5991849A}" type="datetimeFigureOut">
              <a:rPr lang="en-US" smtClean="0"/>
              <a:pPr/>
              <a:t>4/28/2016</a:t>
            </a:fld>
            <a:endParaRPr lang="en-US"/>
          </a:p>
        </p:txBody>
      </p:sp>
      <p:sp>
        <p:nvSpPr>
          <p:cNvPr id="4" name="Footer Placeholder 3"/>
          <p:cNvSpPr>
            <a:spLocks noGrp="1"/>
          </p:cNvSpPr>
          <p:nvPr>
            <p:ph type="ftr" sz="quarter" idx="2"/>
          </p:nvPr>
        </p:nvSpPr>
        <p:spPr>
          <a:xfrm>
            <a:off x="0" y="9409678"/>
            <a:ext cx="2944283" cy="494618"/>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48645" y="9409678"/>
            <a:ext cx="2944283" cy="494618"/>
          </a:xfrm>
          <a:prstGeom prst="rect">
            <a:avLst/>
          </a:prstGeom>
        </p:spPr>
        <p:txBody>
          <a:bodyPr vert="horz" lIns="91440" tIns="45720" rIns="91440" bIns="45720" rtlCol="0" anchor="b"/>
          <a:lstStyle>
            <a:lvl1pPr algn="r">
              <a:defRPr sz="1200"/>
            </a:lvl1pPr>
          </a:lstStyle>
          <a:p>
            <a:fld id="{BDE2FCEE-3576-41A8-89C0-69F3A8362B75}" type="slidenum">
              <a:rPr lang="en-US" smtClean="0"/>
              <a:pPr/>
              <a:t>‹#›</a:t>
            </a:fld>
            <a:endParaRPr lang="en-US"/>
          </a:p>
        </p:txBody>
      </p:sp>
    </p:spTree>
    <p:extLst>
      <p:ext uri="{BB962C8B-B14F-4D97-AF65-F5344CB8AC3E}">
        <p14:creationId xmlns:p14="http://schemas.microsoft.com/office/powerpoint/2010/main" val="3778290582"/>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4283" cy="495300"/>
          </a:xfrm>
          <a:prstGeom prst="rect">
            <a:avLst/>
          </a:prstGeom>
        </p:spPr>
        <p:txBody>
          <a:bodyPr vert="horz" lIns="96661" tIns="48331" rIns="96661" bIns="48331" rtlCol="0"/>
          <a:lstStyle>
            <a:lvl1pPr algn="l">
              <a:defRPr sz="1300"/>
            </a:lvl1pPr>
          </a:lstStyle>
          <a:p>
            <a:endParaRPr lang="en-US"/>
          </a:p>
        </p:txBody>
      </p:sp>
      <p:sp>
        <p:nvSpPr>
          <p:cNvPr id="3" name="Date Placeholder 2"/>
          <p:cNvSpPr>
            <a:spLocks noGrp="1"/>
          </p:cNvSpPr>
          <p:nvPr>
            <p:ph type="dt" idx="1"/>
          </p:nvPr>
        </p:nvSpPr>
        <p:spPr>
          <a:xfrm>
            <a:off x="3848645" y="0"/>
            <a:ext cx="2944283" cy="495300"/>
          </a:xfrm>
          <a:prstGeom prst="rect">
            <a:avLst/>
          </a:prstGeom>
        </p:spPr>
        <p:txBody>
          <a:bodyPr vert="horz" lIns="96661" tIns="48331" rIns="96661" bIns="48331" rtlCol="0"/>
          <a:lstStyle>
            <a:lvl1pPr algn="r">
              <a:defRPr sz="1300"/>
            </a:lvl1pPr>
          </a:lstStyle>
          <a:p>
            <a:fld id="{D8EBE152-F051-40CC-B8D1-6F11D1CA6F7A}" type="datetimeFigureOut">
              <a:rPr lang="en-US" smtClean="0"/>
              <a:pPr/>
              <a:t>4/28/2016</a:t>
            </a:fld>
            <a:endParaRPr lang="en-US"/>
          </a:p>
        </p:txBody>
      </p:sp>
      <p:sp>
        <p:nvSpPr>
          <p:cNvPr id="4" name="Slide Image Placeholder 3"/>
          <p:cNvSpPr>
            <a:spLocks noGrp="1" noRot="1" noChangeAspect="1"/>
          </p:cNvSpPr>
          <p:nvPr>
            <p:ph type="sldImg" idx="2"/>
          </p:nvPr>
        </p:nvSpPr>
        <p:spPr>
          <a:xfrm>
            <a:off x="2005013" y="742950"/>
            <a:ext cx="2784475" cy="3714750"/>
          </a:xfrm>
          <a:prstGeom prst="rect">
            <a:avLst/>
          </a:prstGeom>
          <a:noFill/>
          <a:ln w="12700">
            <a:solidFill>
              <a:prstClr val="black"/>
            </a:solidFill>
          </a:ln>
        </p:spPr>
        <p:txBody>
          <a:bodyPr vert="horz" lIns="96661" tIns="48331" rIns="96661" bIns="48331" rtlCol="0" anchor="ctr"/>
          <a:lstStyle/>
          <a:p>
            <a:endParaRPr lang="en-US"/>
          </a:p>
        </p:txBody>
      </p:sp>
      <p:sp>
        <p:nvSpPr>
          <p:cNvPr id="5" name="Notes Placeholder 4"/>
          <p:cNvSpPr>
            <a:spLocks noGrp="1"/>
          </p:cNvSpPr>
          <p:nvPr>
            <p:ph type="body" sz="quarter" idx="3"/>
          </p:nvPr>
        </p:nvSpPr>
        <p:spPr>
          <a:xfrm>
            <a:off x="679450" y="4705350"/>
            <a:ext cx="5435600" cy="4457700"/>
          </a:xfrm>
          <a:prstGeom prst="rect">
            <a:avLst/>
          </a:prstGeom>
        </p:spPr>
        <p:txBody>
          <a:bodyPr vert="horz" lIns="96661" tIns="48331" rIns="96661" bIns="48331"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9408981"/>
            <a:ext cx="2944283" cy="495300"/>
          </a:xfrm>
          <a:prstGeom prst="rect">
            <a:avLst/>
          </a:prstGeom>
        </p:spPr>
        <p:txBody>
          <a:bodyPr vert="horz" lIns="96661" tIns="48331" rIns="96661" bIns="48331" rtlCol="0" anchor="b"/>
          <a:lstStyle>
            <a:lvl1pPr algn="l">
              <a:defRPr sz="1300"/>
            </a:lvl1pPr>
          </a:lstStyle>
          <a:p>
            <a:endParaRPr lang="en-US"/>
          </a:p>
        </p:txBody>
      </p:sp>
      <p:sp>
        <p:nvSpPr>
          <p:cNvPr id="7" name="Slide Number Placeholder 6"/>
          <p:cNvSpPr>
            <a:spLocks noGrp="1"/>
          </p:cNvSpPr>
          <p:nvPr>
            <p:ph type="sldNum" sz="quarter" idx="5"/>
          </p:nvPr>
        </p:nvSpPr>
        <p:spPr>
          <a:xfrm>
            <a:off x="3848645" y="9408981"/>
            <a:ext cx="2944283" cy="495300"/>
          </a:xfrm>
          <a:prstGeom prst="rect">
            <a:avLst/>
          </a:prstGeom>
        </p:spPr>
        <p:txBody>
          <a:bodyPr vert="horz" lIns="96661" tIns="48331" rIns="96661" bIns="48331" rtlCol="0" anchor="b"/>
          <a:lstStyle>
            <a:lvl1pPr algn="r">
              <a:defRPr sz="1300"/>
            </a:lvl1pPr>
          </a:lstStyle>
          <a:p>
            <a:fld id="{CE26B62F-9DF2-48FE-9CC2-DF278E7A1433}" type="slidenum">
              <a:rPr lang="en-US" smtClean="0"/>
              <a:pPr/>
              <a:t>‹#›</a:t>
            </a:fld>
            <a:endParaRPr lang="en-US"/>
          </a:p>
        </p:txBody>
      </p:sp>
    </p:spTree>
    <p:extLst>
      <p:ext uri="{BB962C8B-B14F-4D97-AF65-F5344CB8AC3E}">
        <p14:creationId xmlns:p14="http://schemas.microsoft.com/office/powerpoint/2010/main" val="389632154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7440CCFE-A627-4DEC-BEE0-E1CB91828B3F}" type="datetime1">
              <a:rPr lang="en-US" smtClean="0"/>
              <a:pPr/>
              <a:t>4/28/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ACA62C2-8D3F-439D-94AC-C26847FF0122}" type="slidenum">
              <a:rPr lang="en-US" smtClean="0"/>
              <a:pPr/>
              <a:t>‹#›</a:t>
            </a:fld>
            <a:endParaRPr lang="en-US"/>
          </a:p>
        </p:txBody>
      </p:sp>
    </p:spTree>
    <p:extLst>
      <p:ext uri="{BB962C8B-B14F-4D97-AF65-F5344CB8AC3E}">
        <p14:creationId xmlns:p14="http://schemas.microsoft.com/office/powerpoint/2010/main" val="16885883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9D32278-0D45-4725-8C01-04CEED69D0C1}" type="datetime1">
              <a:rPr lang="en-US" smtClean="0"/>
              <a:pPr/>
              <a:t>4/28/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ACA62C2-8D3F-439D-94AC-C26847FF0122}" type="slidenum">
              <a:rPr lang="en-US" smtClean="0"/>
              <a:pPr/>
              <a:t>‹#›</a:t>
            </a:fld>
            <a:endParaRPr lang="en-US"/>
          </a:p>
        </p:txBody>
      </p:sp>
    </p:spTree>
    <p:extLst>
      <p:ext uri="{BB962C8B-B14F-4D97-AF65-F5344CB8AC3E}">
        <p14:creationId xmlns:p14="http://schemas.microsoft.com/office/powerpoint/2010/main" val="36755908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F008059-2E0D-4FD4-8CE9-FE1E9A4BBFE2}" type="datetime1">
              <a:rPr lang="en-US" smtClean="0"/>
              <a:pPr/>
              <a:t>4/28/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ACA62C2-8D3F-439D-94AC-C26847FF0122}" type="slidenum">
              <a:rPr lang="en-US" smtClean="0"/>
              <a:pPr/>
              <a:t>‹#›</a:t>
            </a:fld>
            <a:endParaRPr lang="en-US"/>
          </a:p>
        </p:txBody>
      </p:sp>
    </p:spTree>
    <p:extLst>
      <p:ext uri="{BB962C8B-B14F-4D97-AF65-F5344CB8AC3E}">
        <p14:creationId xmlns:p14="http://schemas.microsoft.com/office/powerpoint/2010/main" val="4804091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50CA10B-59F9-4C54-94F4-2C4E4232E0CF}" type="datetime1">
              <a:rPr lang="en-US" smtClean="0"/>
              <a:pPr/>
              <a:t>4/28/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ACA62C2-8D3F-439D-94AC-C26847FF0122}" type="slidenum">
              <a:rPr lang="en-US" smtClean="0"/>
              <a:pPr/>
              <a:t>‹#›</a:t>
            </a:fld>
            <a:endParaRPr lang="en-US"/>
          </a:p>
        </p:txBody>
      </p:sp>
    </p:spTree>
    <p:extLst>
      <p:ext uri="{BB962C8B-B14F-4D97-AF65-F5344CB8AC3E}">
        <p14:creationId xmlns:p14="http://schemas.microsoft.com/office/powerpoint/2010/main" val="11164531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D002A067-C4D7-40B4-AED5-64BA96B14E81}" type="datetime1">
              <a:rPr lang="en-US" smtClean="0"/>
              <a:pPr/>
              <a:t>4/28/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ACA62C2-8D3F-439D-94AC-C26847FF0122}" type="slidenum">
              <a:rPr lang="en-US" smtClean="0"/>
              <a:pPr/>
              <a:t>‹#›</a:t>
            </a:fld>
            <a:endParaRPr lang="en-US"/>
          </a:p>
        </p:txBody>
      </p:sp>
    </p:spTree>
    <p:extLst>
      <p:ext uri="{BB962C8B-B14F-4D97-AF65-F5344CB8AC3E}">
        <p14:creationId xmlns:p14="http://schemas.microsoft.com/office/powerpoint/2010/main" val="15648860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0CA72F1-559C-40B7-8706-1E0F6F2BA533}" type="datetime1">
              <a:rPr lang="en-US" smtClean="0"/>
              <a:pPr/>
              <a:t>4/28/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ACA62C2-8D3F-439D-94AC-C26847FF0122}" type="slidenum">
              <a:rPr lang="en-US" smtClean="0"/>
              <a:pPr/>
              <a:t>‹#›</a:t>
            </a:fld>
            <a:endParaRPr lang="en-US"/>
          </a:p>
        </p:txBody>
      </p:sp>
    </p:spTree>
    <p:extLst>
      <p:ext uri="{BB962C8B-B14F-4D97-AF65-F5344CB8AC3E}">
        <p14:creationId xmlns:p14="http://schemas.microsoft.com/office/powerpoint/2010/main" val="11220678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2DBE0C7A-11B0-4293-BF3C-F1F17E46639C}" type="datetime1">
              <a:rPr lang="en-US" smtClean="0"/>
              <a:pPr/>
              <a:t>4/28/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ACA62C2-8D3F-439D-94AC-C26847FF0122}" type="slidenum">
              <a:rPr lang="en-US" smtClean="0"/>
              <a:pPr/>
              <a:t>‹#›</a:t>
            </a:fld>
            <a:endParaRPr lang="en-US"/>
          </a:p>
        </p:txBody>
      </p:sp>
    </p:spTree>
    <p:extLst>
      <p:ext uri="{BB962C8B-B14F-4D97-AF65-F5344CB8AC3E}">
        <p14:creationId xmlns:p14="http://schemas.microsoft.com/office/powerpoint/2010/main" val="39674747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8B8495E4-5A9F-4A3A-A114-B2276AF36280}" type="datetime1">
              <a:rPr lang="en-US" smtClean="0"/>
              <a:pPr/>
              <a:t>4/28/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ACA62C2-8D3F-439D-94AC-C26847FF0122}" type="slidenum">
              <a:rPr lang="en-US" smtClean="0"/>
              <a:pPr/>
              <a:t>‹#›</a:t>
            </a:fld>
            <a:endParaRPr lang="en-US"/>
          </a:p>
        </p:txBody>
      </p:sp>
    </p:spTree>
    <p:extLst>
      <p:ext uri="{BB962C8B-B14F-4D97-AF65-F5344CB8AC3E}">
        <p14:creationId xmlns:p14="http://schemas.microsoft.com/office/powerpoint/2010/main" val="28056124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FB67E30-17CE-412C-A5AC-C5339C867472}" type="datetime1">
              <a:rPr lang="en-US" smtClean="0"/>
              <a:pPr/>
              <a:t>4/28/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ACA62C2-8D3F-439D-94AC-C26847FF0122}" type="slidenum">
              <a:rPr lang="en-US" smtClean="0"/>
              <a:pPr/>
              <a:t>‹#›</a:t>
            </a:fld>
            <a:endParaRPr lang="en-US"/>
          </a:p>
        </p:txBody>
      </p:sp>
    </p:spTree>
    <p:extLst>
      <p:ext uri="{BB962C8B-B14F-4D97-AF65-F5344CB8AC3E}">
        <p14:creationId xmlns:p14="http://schemas.microsoft.com/office/powerpoint/2010/main" val="20006788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0A3EB5C-4587-4D37-A8BE-96F44F4782AD}" type="datetime1">
              <a:rPr lang="en-US" smtClean="0"/>
              <a:pPr/>
              <a:t>4/28/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ACA62C2-8D3F-439D-94AC-C26847FF0122}" type="slidenum">
              <a:rPr lang="en-US" smtClean="0"/>
              <a:pPr/>
              <a:t>‹#›</a:t>
            </a:fld>
            <a:endParaRPr lang="en-US"/>
          </a:p>
        </p:txBody>
      </p:sp>
    </p:spTree>
    <p:extLst>
      <p:ext uri="{BB962C8B-B14F-4D97-AF65-F5344CB8AC3E}">
        <p14:creationId xmlns:p14="http://schemas.microsoft.com/office/powerpoint/2010/main" val="13949325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29ECECD-056A-475A-9956-D707866B37D5}" type="datetime1">
              <a:rPr lang="en-US" smtClean="0"/>
              <a:pPr/>
              <a:t>4/28/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ACA62C2-8D3F-439D-94AC-C26847FF0122}" type="slidenum">
              <a:rPr lang="en-US" smtClean="0"/>
              <a:pPr/>
              <a:t>‹#›</a:t>
            </a:fld>
            <a:endParaRPr lang="en-US"/>
          </a:p>
        </p:txBody>
      </p:sp>
    </p:spTree>
    <p:extLst>
      <p:ext uri="{BB962C8B-B14F-4D97-AF65-F5344CB8AC3E}">
        <p14:creationId xmlns:p14="http://schemas.microsoft.com/office/powerpoint/2010/main" val="7302534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EF0F96A2-CC89-4D24-AE65-56D640D21B64}" type="datetime1">
              <a:rPr lang="en-US" smtClean="0"/>
              <a:pPr/>
              <a:t>4/28/2016</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1ACA62C2-8D3F-439D-94AC-C26847FF0122}" type="slidenum">
              <a:rPr lang="en-US" smtClean="0"/>
              <a:pPr/>
              <a:t>‹#›</a:t>
            </a:fld>
            <a:endParaRPr lang="en-US"/>
          </a:p>
        </p:txBody>
      </p:sp>
    </p:spTree>
    <p:extLst>
      <p:ext uri="{BB962C8B-B14F-4D97-AF65-F5344CB8AC3E}">
        <p14:creationId xmlns:p14="http://schemas.microsoft.com/office/powerpoint/2010/main" val="164404431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 Id="rId5" Type="http://schemas.openxmlformats.org/officeDocument/2006/relationships/image" Target="../media/image6.png"/><Relationship Id="rId4" Type="http://schemas.openxmlformats.org/officeDocument/2006/relationships/image" Target="../media/image5.png"/></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7.xml"/><Relationship Id="rId5" Type="http://schemas.openxmlformats.org/officeDocument/2006/relationships/image" Target="../media/image12.png"/><Relationship Id="rId4" Type="http://schemas.openxmlformats.org/officeDocument/2006/relationships/image" Target="../media/image11.png"/></Relationships>
</file>

<file path=ppt/slides/_rels/slide6.xml.rels><?xml version="1.0" encoding="UTF-8" standalone="yes"?>
<Relationships xmlns="http://schemas.openxmlformats.org/package/2006/relationships"><Relationship Id="rId3" Type="http://schemas.openxmlformats.org/officeDocument/2006/relationships/image" Target="../media/image14.png"/><Relationship Id="rId7" Type="http://schemas.openxmlformats.org/officeDocument/2006/relationships/image" Target="../media/image18.png"/><Relationship Id="rId2" Type="http://schemas.openxmlformats.org/officeDocument/2006/relationships/image" Target="../media/image13.png"/><Relationship Id="rId1" Type="http://schemas.openxmlformats.org/officeDocument/2006/relationships/slideLayout" Target="../slideLayouts/slideLayout7.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_rels/slide7.xml.rels><?xml version="1.0" encoding="UTF-8" standalone="yes"?>
<Relationships xmlns="http://schemas.openxmlformats.org/package/2006/relationships"><Relationship Id="rId3" Type="http://schemas.openxmlformats.org/officeDocument/2006/relationships/image" Target="../media/image20.wmf"/><Relationship Id="rId2" Type="http://schemas.openxmlformats.org/officeDocument/2006/relationships/image" Target="../media/image19.w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nummernplatzhalter 1"/>
          <p:cNvSpPr>
            <a:spLocks noGrp="1"/>
          </p:cNvSpPr>
          <p:nvPr>
            <p:ph type="sldNum" sz="quarter" idx="12"/>
          </p:nvPr>
        </p:nvSpPr>
        <p:spPr/>
        <p:txBody>
          <a:bodyPr/>
          <a:lstStyle/>
          <a:p>
            <a:fld id="{1ACA62C2-8D3F-439D-94AC-C26847FF0122}" type="slidenum">
              <a:rPr lang="en-US" smtClean="0"/>
              <a:pPr/>
              <a:t>1</a:t>
            </a:fld>
            <a:endParaRPr lang="en-US"/>
          </a:p>
        </p:txBody>
      </p:sp>
      <p:pic>
        <p:nvPicPr>
          <p:cNvPr id="6"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50000" y="860626"/>
            <a:ext cx="2743200" cy="332809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Rectangle 2"/>
          <p:cNvSpPr/>
          <p:nvPr/>
        </p:nvSpPr>
        <p:spPr>
          <a:xfrm>
            <a:off x="585804" y="3872805"/>
            <a:ext cx="4297680" cy="1446550"/>
          </a:xfrm>
          <a:prstGeom prst="rect">
            <a:avLst/>
          </a:prstGeom>
        </p:spPr>
        <p:txBody>
          <a:bodyPr wrap="square">
            <a:spAutoFit/>
          </a:bodyPr>
          <a:lstStyle/>
          <a:p>
            <a:pPr algn="just"/>
            <a:r>
              <a:rPr lang="en-GB" sz="1100" b="1" dirty="0">
                <a:latin typeface="Arial" panose="020B0604020202020204" pitchFamily="34" charset="0"/>
                <a:cs typeface="Arial" panose="020B0604020202020204" pitchFamily="34" charset="0"/>
              </a:rPr>
              <a:t>Supplementary Figure S1. </a:t>
            </a:r>
            <a:r>
              <a:rPr lang="en-GB" sz="1100" dirty="0">
                <a:latin typeface="Arial" panose="020B0604020202020204" pitchFamily="34" charset="0"/>
                <a:cs typeface="Arial" panose="020B0604020202020204" pitchFamily="34" charset="0"/>
              </a:rPr>
              <a:t>Developmental PSs belonging to nervous system development.</a:t>
            </a:r>
            <a:r>
              <a:rPr lang="en-GB" sz="1100" b="1" dirty="0">
                <a:latin typeface="Arial" panose="020B0604020202020204" pitchFamily="34" charset="0"/>
                <a:cs typeface="Arial" panose="020B0604020202020204" pitchFamily="34" charset="0"/>
              </a:rPr>
              <a:t> </a:t>
            </a:r>
            <a:r>
              <a:rPr lang="en-GB" sz="1100" dirty="0">
                <a:latin typeface="Arial" panose="020B0604020202020204" pitchFamily="34" charset="0"/>
                <a:cs typeface="Arial" panose="020B0604020202020204" pitchFamily="34" charset="0"/>
              </a:rPr>
              <a:t>Stem cells were randomly differentiated for 14 days or specifically differentiated towards </a:t>
            </a:r>
            <a:r>
              <a:rPr lang="en-GB" sz="1100" dirty="0" err="1">
                <a:latin typeface="Arial" panose="020B0604020202020204" pitchFamily="34" charset="0"/>
                <a:cs typeface="Arial" panose="020B0604020202020204" pitchFamily="34" charset="0"/>
              </a:rPr>
              <a:t>neuroectodermal</a:t>
            </a:r>
            <a:r>
              <a:rPr lang="en-GB" sz="1100" dirty="0">
                <a:latin typeface="Arial" panose="020B0604020202020204" pitchFamily="34" charset="0"/>
                <a:cs typeface="Arial" panose="020B0604020202020204" pitchFamily="34" charset="0"/>
              </a:rPr>
              <a:t> progenitor cells for 6 days. Transcriptome profiles were obtained for day 0 and day 14 (UKK) or day 6 (UKN1) of differentiation. Genes belonging to the nervous system development (fold change ≥ ±2, FDR-corrected p value &lt;0.05) were identified and are represented in the figure.</a:t>
            </a:r>
            <a:endParaRPr 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786852320"/>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nummernplatzhalter 1"/>
          <p:cNvSpPr>
            <a:spLocks noGrp="1"/>
          </p:cNvSpPr>
          <p:nvPr>
            <p:ph type="sldNum" sz="quarter" idx="12"/>
          </p:nvPr>
        </p:nvSpPr>
        <p:spPr/>
        <p:txBody>
          <a:bodyPr/>
          <a:lstStyle/>
          <a:p>
            <a:fld id="{1ACA62C2-8D3F-439D-94AC-C26847FF0122}" type="slidenum">
              <a:rPr lang="en-US" smtClean="0"/>
              <a:pPr/>
              <a:t>2</a:t>
            </a:fld>
            <a:endParaRPr lang="en-US"/>
          </a:p>
        </p:txBody>
      </p:sp>
      <p:pic>
        <p:nvPicPr>
          <p:cNvPr id="7" name="Picture 3"/>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46466" y="750095"/>
            <a:ext cx="4297680" cy="315573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 name="Rectangle 7"/>
          <p:cNvSpPr/>
          <p:nvPr/>
        </p:nvSpPr>
        <p:spPr>
          <a:xfrm>
            <a:off x="646469" y="4255294"/>
            <a:ext cx="4297680" cy="1615827"/>
          </a:xfrm>
          <a:prstGeom prst="rect">
            <a:avLst/>
          </a:prstGeom>
        </p:spPr>
        <p:txBody>
          <a:bodyPr>
            <a:spAutoFit/>
          </a:bodyPr>
          <a:lstStyle/>
          <a:p>
            <a:pPr algn="just"/>
            <a:r>
              <a:rPr lang="en-GB" sz="1100" b="1" dirty="0">
                <a:latin typeface="Arial" panose="020B0604020202020204" pitchFamily="34" charset="0"/>
                <a:cs typeface="Arial" panose="020B0604020202020204" pitchFamily="34" charset="0"/>
              </a:rPr>
              <a:t>Supplementary Figure S2.</a:t>
            </a:r>
            <a:r>
              <a:rPr lang="en-GB" sz="1100" dirty="0">
                <a:latin typeface="Arial" panose="020B0604020202020204" pitchFamily="34" charset="0"/>
                <a:cs typeface="Arial" panose="020B0604020202020204" pitchFamily="34" charset="0"/>
              </a:rPr>
              <a:t> Tissue classification based on </a:t>
            </a:r>
            <a:r>
              <a:rPr lang="en-GB" sz="1100" dirty="0" err="1">
                <a:latin typeface="Arial" panose="020B0604020202020204" pitchFamily="34" charset="0"/>
                <a:cs typeface="Arial" panose="020B0604020202020204" pitchFamily="34" charset="0"/>
              </a:rPr>
              <a:t>CellNet</a:t>
            </a:r>
            <a:r>
              <a:rPr lang="en-GB" sz="1100" dirty="0">
                <a:latin typeface="Arial" panose="020B0604020202020204" pitchFamily="34" charset="0"/>
                <a:cs typeface="Arial" panose="020B0604020202020204" pitchFamily="34" charset="0"/>
              </a:rPr>
              <a:t> analysis. Embryonic stem cell (ESC) and tissue classification probability for day 0 and day of differentiation (6 or 14) was obtained by </a:t>
            </a:r>
            <a:r>
              <a:rPr lang="en-GB" sz="1100" dirty="0" err="1">
                <a:latin typeface="Arial" panose="020B0604020202020204" pitchFamily="34" charset="0"/>
                <a:cs typeface="Arial" panose="020B0604020202020204" pitchFamily="34" charset="0"/>
              </a:rPr>
              <a:t>CellNet</a:t>
            </a:r>
            <a:r>
              <a:rPr lang="en-GB" sz="1100" dirty="0">
                <a:latin typeface="Arial" panose="020B0604020202020204" pitchFamily="34" charset="0"/>
                <a:cs typeface="Arial" panose="020B0604020202020204" pitchFamily="34" charset="0"/>
              </a:rPr>
              <a:t> analysis. Although the tissue classification scores were &lt;0.1, they nevertheless revealed an increase during differentiation (day 14 or day 6) compared with those at day 0. In addition, higher tissue classification scores for neuron, lung, and heart tissue were found in the UKK system compared with those of the UKN1 system.</a:t>
            </a:r>
            <a:endParaRPr 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18912778"/>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Group 11"/>
          <p:cNvGrpSpPr/>
          <p:nvPr/>
        </p:nvGrpSpPr>
        <p:grpSpPr>
          <a:xfrm>
            <a:off x="3429000" y="3615739"/>
            <a:ext cx="3200400" cy="2861261"/>
            <a:chOff x="3482340" y="4613202"/>
            <a:chExt cx="3200400" cy="2861261"/>
          </a:xfrm>
        </p:grpSpPr>
        <p:pic>
          <p:nvPicPr>
            <p:cNvPr id="31747" name="Picture 3"/>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482340" y="4613202"/>
              <a:ext cx="3200400" cy="286126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4" name="TextBox 43"/>
            <p:cNvSpPr txBox="1"/>
            <p:nvPr/>
          </p:nvSpPr>
          <p:spPr>
            <a:xfrm>
              <a:off x="4443278" y="5704224"/>
              <a:ext cx="897524" cy="276999"/>
            </a:xfrm>
            <a:prstGeom prst="rect">
              <a:avLst/>
            </a:prstGeom>
            <a:noFill/>
          </p:spPr>
          <p:txBody>
            <a:bodyPr wrap="square" rtlCol="0">
              <a:spAutoFit/>
            </a:bodyPr>
            <a:lstStyle/>
            <a:p>
              <a:r>
                <a:rPr lang="en-US" sz="1200" dirty="0" smtClean="0">
                  <a:latin typeface="Arial" panose="020B0604020202020204" pitchFamily="34" charset="0"/>
                  <a:cs typeface="Arial" panose="020B0604020202020204" pitchFamily="34" charset="0"/>
                </a:rPr>
                <a:t>-2.6  to3.8</a:t>
              </a:r>
              <a:endParaRPr lang="en-US" sz="1200" dirty="0">
                <a:latin typeface="Arial" panose="020B0604020202020204" pitchFamily="34" charset="0"/>
                <a:cs typeface="Arial" panose="020B0604020202020204" pitchFamily="34" charset="0"/>
              </a:endParaRPr>
            </a:p>
          </p:txBody>
        </p:sp>
        <p:sp>
          <p:nvSpPr>
            <p:cNvPr id="45" name="Right Brace 44"/>
            <p:cNvSpPr/>
            <p:nvPr/>
          </p:nvSpPr>
          <p:spPr>
            <a:xfrm rot="16200000" flipV="1">
              <a:off x="4737259" y="5938336"/>
              <a:ext cx="309562" cy="381000"/>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grpSp>
        <p:nvGrpSpPr>
          <p:cNvPr id="14" name="Group 13"/>
          <p:cNvGrpSpPr/>
          <p:nvPr/>
        </p:nvGrpSpPr>
        <p:grpSpPr>
          <a:xfrm>
            <a:off x="228600" y="3539539"/>
            <a:ext cx="3200400" cy="2861261"/>
            <a:chOff x="228600" y="4572000"/>
            <a:chExt cx="3200400" cy="2861261"/>
          </a:xfrm>
        </p:grpSpPr>
        <p:pic>
          <p:nvPicPr>
            <p:cNvPr id="26629" name="Picture 5"/>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28600" y="4572000"/>
              <a:ext cx="3200400" cy="286126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 name="TextBox 4"/>
            <p:cNvSpPr txBox="1"/>
            <p:nvPr/>
          </p:nvSpPr>
          <p:spPr>
            <a:xfrm>
              <a:off x="2133601" y="5565725"/>
              <a:ext cx="914399" cy="276999"/>
            </a:xfrm>
            <a:prstGeom prst="rect">
              <a:avLst/>
            </a:prstGeom>
            <a:noFill/>
          </p:spPr>
          <p:txBody>
            <a:bodyPr wrap="square" rtlCol="0">
              <a:spAutoFit/>
            </a:bodyPr>
            <a:lstStyle/>
            <a:p>
              <a:r>
                <a:rPr lang="en-US" sz="1200" dirty="0" smtClean="0">
                  <a:latin typeface="Arial" panose="020B0604020202020204" pitchFamily="34" charset="0"/>
                  <a:cs typeface="Arial" panose="020B0604020202020204" pitchFamily="34" charset="0"/>
                </a:rPr>
                <a:t>-2.1 to 3.4</a:t>
              </a:r>
              <a:endParaRPr lang="en-US" sz="1200" dirty="0">
                <a:latin typeface="Arial" panose="020B0604020202020204" pitchFamily="34" charset="0"/>
                <a:cs typeface="Arial" panose="020B0604020202020204" pitchFamily="34" charset="0"/>
              </a:endParaRPr>
            </a:p>
          </p:txBody>
        </p:sp>
        <p:sp>
          <p:nvSpPr>
            <p:cNvPr id="43" name="Right Brace 42"/>
            <p:cNvSpPr/>
            <p:nvPr/>
          </p:nvSpPr>
          <p:spPr>
            <a:xfrm rot="16200000" flipV="1">
              <a:off x="2397919" y="5783555"/>
              <a:ext cx="309562" cy="381000"/>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grpSp>
        <p:nvGrpSpPr>
          <p:cNvPr id="15" name="Group 14"/>
          <p:cNvGrpSpPr/>
          <p:nvPr/>
        </p:nvGrpSpPr>
        <p:grpSpPr>
          <a:xfrm>
            <a:off x="3437438" y="569421"/>
            <a:ext cx="3200400" cy="2841933"/>
            <a:chOff x="3437438" y="1102821"/>
            <a:chExt cx="3200400" cy="2841933"/>
          </a:xfrm>
        </p:grpSpPr>
        <p:pic>
          <p:nvPicPr>
            <p:cNvPr id="31746" name="Picture 2"/>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437438" y="1102821"/>
              <a:ext cx="3200400" cy="284193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1" name="TextBox 40"/>
            <p:cNvSpPr txBox="1"/>
            <p:nvPr/>
          </p:nvSpPr>
          <p:spPr>
            <a:xfrm>
              <a:off x="5143500" y="1371600"/>
              <a:ext cx="1016043" cy="276999"/>
            </a:xfrm>
            <a:prstGeom prst="rect">
              <a:avLst/>
            </a:prstGeom>
            <a:noFill/>
          </p:spPr>
          <p:txBody>
            <a:bodyPr wrap="square" rtlCol="0">
              <a:spAutoFit/>
            </a:bodyPr>
            <a:lstStyle/>
            <a:p>
              <a:r>
                <a:rPr lang="en-US" sz="1200" dirty="0" smtClean="0">
                  <a:latin typeface="Arial" panose="020B0604020202020204" pitchFamily="34" charset="0"/>
                  <a:cs typeface="Arial" panose="020B0604020202020204" pitchFamily="34" charset="0"/>
                </a:rPr>
                <a:t>-7.4  to13.0</a:t>
              </a:r>
              <a:endParaRPr lang="en-US" sz="1200" dirty="0">
                <a:latin typeface="Arial" panose="020B0604020202020204" pitchFamily="34" charset="0"/>
                <a:cs typeface="Arial" panose="020B0604020202020204" pitchFamily="34" charset="0"/>
              </a:endParaRPr>
            </a:p>
          </p:txBody>
        </p:sp>
        <p:sp>
          <p:nvSpPr>
            <p:cNvPr id="42" name="Right Brace 41"/>
            <p:cNvSpPr/>
            <p:nvPr/>
          </p:nvSpPr>
          <p:spPr>
            <a:xfrm rot="16200000" flipV="1">
              <a:off x="5454357" y="1567573"/>
              <a:ext cx="309562" cy="381000"/>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sp>
        <p:nvSpPr>
          <p:cNvPr id="2" name="Slide Number Placeholder 1"/>
          <p:cNvSpPr>
            <a:spLocks noGrp="1"/>
          </p:cNvSpPr>
          <p:nvPr>
            <p:ph type="sldNum" sz="quarter" idx="12"/>
          </p:nvPr>
        </p:nvSpPr>
        <p:spPr/>
        <p:txBody>
          <a:bodyPr/>
          <a:lstStyle/>
          <a:p>
            <a:fld id="{1ACA62C2-8D3F-439D-94AC-C26847FF0122}" type="slidenum">
              <a:rPr lang="en-US" smtClean="0"/>
              <a:pPr/>
              <a:t>3</a:t>
            </a:fld>
            <a:endParaRPr lang="en-US"/>
          </a:p>
        </p:txBody>
      </p:sp>
      <p:sp>
        <p:nvSpPr>
          <p:cNvPr id="3" name="TextBox 2"/>
          <p:cNvSpPr txBox="1"/>
          <p:nvPr/>
        </p:nvSpPr>
        <p:spPr>
          <a:xfrm>
            <a:off x="609600" y="3380601"/>
            <a:ext cx="3200400" cy="276999"/>
          </a:xfrm>
          <a:prstGeom prst="rect">
            <a:avLst/>
          </a:prstGeom>
          <a:noFill/>
        </p:spPr>
        <p:txBody>
          <a:bodyPr wrap="square" rtlCol="0">
            <a:spAutoFit/>
          </a:bodyPr>
          <a:lstStyle/>
          <a:p>
            <a:r>
              <a:rPr lang="en-US" sz="1200" b="1" dirty="0" smtClean="0">
                <a:latin typeface="Arial" panose="020B0604020202020204" pitchFamily="34" charset="0"/>
                <a:cs typeface="Arial" panose="020B0604020202020204" pitchFamily="34" charset="0"/>
              </a:rPr>
              <a:t>UKK: compounds deregulated PSs</a:t>
            </a:r>
            <a:endParaRPr lang="en-US" sz="1200" b="1" dirty="0">
              <a:latin typeface="Arial" panose="020B0604020202020204" pitchFamily="34" charset="0"/>
              <a:cs typeface="Arial" panose="020B0604020202020204" pitchFamily="34" charset="0"/>
            </a:endParaRPr>
          </a:p>
        </p:txBody>
      </p:sp>
      <p:sp>
        <p:nvSpPr>
          <p:cNvPr id="24" name="TextBox 23"/>
          <p:cNvSpPr txBox="1"/>
          <p:nvPr/>
        </p:nvSpPr>
        <p:spPr>
          <a:xfrm>
            <a:off x="3810000" y="408801"/>
            <a:ext cx="2924175" cy="276999"/>
          </a:xfrm>
          <a:prstGeom prst="rect">
            <a:avLst/>
          </a:prstGeom>
          <a:noFill/>
        </p:spPr>
        <p:txBody>
          <a:bodyPr wrap="square" rtlCol="0">
            <a:spAutoFit/>
          </a:bodyPr>
          <a:lstStyle/>
          <a:p>
            <a:r>
              <a:rPr lang="en-US" sz="1200" b="1" dirty="0" smtClean="0">
                <a:latin typeface="Arial" panose="020B0604020202020204" pitchFamily="34" charset="0"/>
                <a:cs typeface="Arial" panose="020B0604020202020204" pitchFamily="34" charset="0"/>
              </a:rPr>
              <a:t>UKN1: developmental PSs</a:t>
            </a:r>
            <a:endParaRPr lang="en-US" sz="1200" b="1" dirty="0">
              <a:latin typeface="Arial" panose="020B0604020202020204" pitchFamily="34" charset="0"/>
              <a:cs typeface="Arial" panose="020B0604020202020204" pitchFamily="34" charset="0"/>
            </a:endParaRPr>
          </a:p>
        </p:txBody>
      </p:sp>
      <p:sp>
        <p:nvSpPr>
          <p:cNvPr id="30" name="TextBox 29"/>
          <p:cNvSpPr txBox="1"/>
          <p:nvPr/>
        </p:nvSpPr>
        <p:spPr>
          <a:xfrm>
            <a:off x="3810000" y="3380601"/>
            <a:ext cx="3276600" cy="276999"/>
          </a:xfrm>
          <a:prstGeom prst="rect">
            <a:avLst/>
          </a:prstGeom>
          <a:noFill/>
        </p:spPr>
        <p:txBody>
          <a:bodyPr wrap="square" rtlCol="0">
            <a:spAutoFit/>
          </a:bodyPr>
          <a:lstStyle/>
          <a:p>
            <a:r>
              <a:rPr lang="en-US" sz="1200" b="1" dirty="0" smtClean="0">
                <a:latin typeface="Arial" panose="020B0604020202020204" pitchFamily="34" charset="0"/>
                <a:cs typeface="Arial" panose="020B0604020202020204" pitchFamily="34" charset="0"/>
              </a:rPr>
              <a:t>UKN1: compounds deregulated PSs</a:t>
            </a:r>
            <a:endParaRPr lang="en-US" sz="1200" b="1" dirty="0">
              <a:latin typeface="Arial" panose="020B0604020202020204" pitchFamily="34" charset="0"/>
              <a:cs typeface="Arial" panose="020B0604020202020204" pitchFamily="34" charset="0"/>
            </a:endParaRPr>
          </a:p>
        </p:txBody>
      </p:sp>
      <p:sp>
        <p:nvSpPr>
          <p:cNvPr id="49" name="TextBox 48"/>
          <p:cNvSpPr txBox="1"/>
          <p:nvPr/>
        </p:nvSpPr>
        <p:spPr>
          <a:xfrm>
            <a:off x="3439343" y="378023"/>
            <a:ext cx="381000" cy="307777"/>
          </a:xfrm>
          <a:prstGeom prst="rect">
            <a:avLst/>
          </a:prstGeom>
          <a:noFill/>
        </p:spPr>
        <p:txBody>
          <a:bodyPr wrap="square" rtlCol="0">
            <a:spAutoFit/>
          </a:bodyPr>
          <a:lstStyle/>
          <a:p>
            <a:r>
              <a:rPr lang="en-US" sz="1400" dirty="0" smtClean="0">
                <a:latin typeface="Arial" panose="020B0604020202020204" pitchFamily="34" charset="0"/>
                <a:cs typeface="Arial" panose="020B0604020202020204" pitchFamily="34" charset="0"/>
              </a:rPr>
              <a:t>B</a:t>
            </a:r>
            <a:endParaRPr lang="en-US" sz="1400" dirty="0">
              <a:latin typeface="Arial" panose="020B0604020202020204" pitchFamily="34" charset="0"/>
              <a:cs typeface="Arial" panose="020B0604020202020204" pitchFamily="34" charset="0"/>
            </a:endParaRPr>
          </a:p>
        </p:txBody>
      </p:sp>
      <p:sp>
        <p:nvSpPr>
          <p:cNvPr id="50" name="TextBox 49"/>
          <p:cNvSpPr txBox="1"/>
          <p:nvPr/>
        </p:nvSpPr>
        <p:spPr>
          <a:xfrm>
            <a:off x="228600" y="3349823"/>
            <a:ext cx="381000" cy="307777"/>
          </a:xfrm>
          <a:prstGeom prst="rect">
            <a:avLst/>
          </a:prstGeom>
          <a:noFill/>
        </p:spPr>
        <p:txBody>
          <a:bodyPr wrap="square" rtlCol="0">
            <a:spAutoFit/>
          </a:bodyPr>
          <a:lstStyle/>
          <a:p>
            <a:r>
              <a:rPr lang="en-US" sz="1400" dirty="0" smtClean="0">
                <a:latin typeface="Arial" panose="020B0604020202020204" pitchFamily="34" charset="0"/>
                <a:cs typeface="Arial" panose="020B0604020202020204" pitchFamily="34" charset="0"/>
              </a:rPr>
              <a:t>C</a:t>
            </a:r>
            <a:endParaRPr lang="en-US" sz="1400" dirty="0">
              <a:latin typeface="Arial" panose="020B0604020202020204" pitchFamily="34" charset="0"/>
              <a:cs typeface="Arial" panose="020B0604020202020204" pitchFamily="34" charset="0"/>
            </a:endParaRPr>
          </a:p>
        </p:txBody>
      </p:sp>
      <p:sp>
        <p:nvSpPr>
          <p:cNvPr id="51" name="TextBox 50"/>
          <p:cNvSpPr txBox="1"/>
          <p:nvPr/>
        </p:nvSpPr>
        <p:spPr>
          <a:xfrm>
            <a:off x="3429000" y="3352800"/>
            <a:ext cx="3810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D</a:t>
            </a:r>
          </a:p>
        </p:txBody>
      </p:sp>
      <p:grpSp>
        <p:nvGrpSpPr>
          <p:cNvPr id="16" name="Group 15"/>
          <p:cNvGrpSpPr/>
          <p:nvPr/>
        </p:nvGrpSpPr>
        <p:grpSpPr>
          <a:xfrm>
            <a:off x="228600" y="533400"/>
            <a:ext cx="3200400" cy="2861261"/>
            <a:chOff x="228600" y="1066800"/>
            <a:chExt cx="3200400" cy="2861261"/>
          </a:xfrm>
        </p:grpSpPr>
        <p:pic>
          <p:nvPicPr>
            <p:cNvPr id="26630" name="Picture 6"/>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228600" y="1066800"/>
              <a:ext cx="3200400" cy="286126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5" name="TextBox 34"/>
            <p:cNvSpPr txBox="1"/>
            <p:nvPr/>
          </p:nvSpPr>
          <p:spPr>
            <a:xfrm>
              <a:off x="1813560" y="1919883"/>
              <a:ext cx="844868" cy="276999"/>
            </a:xfrm>
            <a:prstGeom prst="rect">
              <a:avLst/>
            </a:prstGeom>
            <a:noFill/>
          </p:spPr>
          <p:txBody>
            <a:bodyPr wrap="square" rtlCol="0">
              <a:spAutoFit/>
            </a:bodyPr>
            <a:lstStyle/>
            <a:p>
              <a:r>
                <a:rPr lang="en-US" sz="1200" dirty="0" smtClean="0">
                  <a:latin typeface="Arial" panose="020B0604020202020204" pitchFamily="34" charset="0"/>
                  <a:cs typeface="Arial" panose="020B0604020202020204" pitchFamily="34" charset="0"/>
                </a:rPr>
                <a:t>-3.7  to 9</a:t>
              </a:r>
              <a:endParaRPr lang="en-US" sz="1200" dirty="0">
                <a:latin typeface="Arial" panose="020B0604020202020204" pitchFamily="34" charset="0"/>
                <a:cs typeface="Arial" panose="020B0604020202020204" pitchFamily="34" charset="0"/>
              </a:endParaRPr>
            </a:p>
          </p:txBody>
        </p:sp>
        <p:sp>
          <p:nvSpPr>
            <p:cNvPr id="10" name="Right Brace 9"/>
            <p:cNvSpPr/>
            <p:nvPr/>
          </p:nvSpPr>
          <p:spPr>
            <a:xfrm rot="16200000" flipV="1">
              <a:off x="2016919" y="2152149"/>
              <a:ext cx="309562" cy="381000"/>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sp>
        <p:nvSpPr>
          <p:cNvPr id="4" name="Rectangle 3"/>
          <p:cNvSpPr/>
          <p:nvPr/>
        </p:nvSpPr>
        <p:spPr>
          <a:xfrm>
            <a:off x="275138" y="6629400"/>
            <a:ext cx="6400800" cy="2123658"/>
          </a:xfrm>
          <a:prstGeom prst="rect">
            <a:avLst/>
          </a:prstGeom>
        </p:spPr>
        <p:txBody>
          <a:bodyPr wrap="square">
            <a:spAutoFit/>
          </a:bodyPr>
          <a:lstStyle/>
          <a:p>
            <a:pPr algn="just"/>
            <a:r>
              <a:rPr lang="en-GB" sz="1100" b="1" dirty="0">
                <a:latin typeface="Arial" panose="020B0604020202020204" pitchFamily="34" charset="0"/>
                <a:cs typeface="Arial" panose="020B0604020202020204" pitchFamily="34" charset="0"/>
              </a:rPr>
              <a:t>Supplementary Figure S3. </a:t>
            </a:r>
            <a:r>
              <a:rPr lang="en-GB" sz="1100" dirty="0">
                <a:latin typeface="Arial" panose="020B0604020202020204" pitchFamily="34" charset="0"/>
                <a:cs typeface="Arial" panose="020B0604020202020204" pitchFamily="34" charset="0"/>
              </a:rPr>
              <a:t>Frequency distribution plots of deregulated </a:t>
            </a:r>
            <a:r>
              <a:rPr lang="en-GB" sz="1100" dirty="0" smtClean="0">
                <a:latin typeface="Arial" panose="020B0604020202020204" pitchFamily="34" charset="0"/>
                <a:cs typeface="Arial" panose="020B0604020202020204" pitchFamily="34" charset="0"/>
              </a:rPr>
              <a:t>probe sets (PSs).</a:t>
            </a:r>
            <a:r>
              <a:rPr lang="en-GB" sz="1100" b="1" dirty="0" smtClean="0">
                <a:latin typeface="Arial" panose="020B0604020202020204" pitchFamily="34" charset="0"/>
                <a:cs typeface="Arial" panose="020B0604020202020204" pitchFamily="34" charset="0"/>
              </a:rPr>
              <a:t> </a:t>
            </a:r>
            <a:r>
              <a:rPr lang="en-GB" sz="1100" dirty="0" smtClean="0">
                <a:latin typeface="Arial" panose="020B0604020202020204" pitchFamily="34" charset="0"/>
                <a:cs typeface="Arial" panose="020B0604020202020204" pitchFamily="34" charset="0"/>
              </a:rPr>
              <a:t>Numbers </a:t>
            </a:r>
            <a:r>
              <a:rPr lang="en-GB" sz="1100" dirty="0">
                <a:latin typeface="Arial" panose="020B0604020202020204" pitchFamily="34" charset="0"/>
                <a:cs typeface="Arial" panose="020B0604020202020204" pitchFamily="34" charset="0"/>
              </a:rPr>
              <a:t>of all deregulated PSs were plotted as the frequency in 100 bins obtained with equal distribution from the maximum to minimum fold change values. (A) For UKK developmental genes, 100 bins are constituted with fold change values ranging from -168.3 to +148.3. The majority of developmental genes fall into the bins with fold change values ranging from -3.7 to +9. (B) For UKN1 developmental genes, 100 bins are constituted with fold changes values ranging from -334.4 to +176.4. The majority of developmental genes fall in the bins with fold change values ranging from -7.4 to +13. (C) For mercurial- and </a:t>
            </a:r>
            <a:r>
              <a:rPr lang="en-GB" sz="1100" dirty="0" err="1">
                <a:latin typeface="Arial" panose="020B0604020202020204" pitchFamily="34" charset="0"/>
                <a:cs typeface="Arial" panose="020B0604020202020204" pitchFamily="34" charset="0"/>
              </a:rPr>
              <a:t>HDACi</a:t>
            </a:r>
            <a:r>
              <a:rPr lang="en-GB" sz="1100" dirty="0">
                <a:latin typeface="Arial" panose="020B0604020202020204" pitchFamily="34" charset="0"/>
                <a:cs typeface="Arial" panose="020B0604020202020204" pitchFamily="34" charset="0"/>
              </a:rPr>
              <a:t>-deregulated genes in the UKK system, 100 bins are constituted with fold changes values ranging from -47.4 to +21.2. The majority of these fall into the bins with fold change values ranging from -2.1 to +3.4. (D) For mercurial- and </a:t>
            </a:r>
            <a:r>
              <a:rPr lang="en-GB" sz="1100" dirty="0" err="1">
                <a:latin typeface="Arial" panose="020B0604020202020204" pitchFamily="34" charset="0"/>
                <a:cs typeface="Arial" panose="020B0604020202020204" pitchFamily="34" charset="0"/>
              </a:rPr>
              <a:t>HDACi</a:t>
            </a:r>
            <a:r>
              <a:rPr lang="en-GB" sz="1100" dirty="0">
                <a:latin typeface="Arial" panose="020B0604020202020204" pitchFamily="34" charset="0"/>
                <a:cs typeface="Arial" panose="020B0604020202020204" pitchFamily="34" charset="0"/>
              </a:rPr>
              <a:t>-deregulated genes in the UKN1 system, 100 bins are constituted with fold changes values ranging from -34.4 to +71.7. Most genes fall into the bins with fold change values ranging from -2.6 to +3.8</a:t>
            </a:r>
            <a:r>
              <a:rPr lang="en-GB" sz="1100" dirty="0" smtClean="0">
                <a:latin typeface="Arial" panose="020B0604020202020204" pitchFamily="34" charset="0"/>
                <a:cs typeface="Arial" panose="020B0604020202020204" pitchFamily="34" charset="0"/>
              </a:rPr>
              <a:t>.</a:t>
            </a:r>
            <a:endParaRPr lang="en-US" sz="1100" dirty="0">
              <a:latin typeface="Arial" panose="020B0604020202020204" pitchFamily="34" charset="0"/>
              <a:cs typeface="Arial" panose="020B0604020202020204" pitchFamily="34" charset="0"/>
            </a:endParaRPr>
          </a:p>
        </p:txBody>
      </p:sp>
      <p:sp>
        <p:nvSpPr>
          <p:cNvPr id="23" name="TextBox 22"/>
          <p:cNvSpPr txBox="1"/>
          <p:nvPr/>
        </p:nvSpPr>
        <p:spPr>
          <a:xfrm>
            <a:off x="609600" y="381000"/>
            <a:ext cx="2924175" cy="276999"/>
          </a:xfrm>
          <a:prstGeom prst="rect">
            <a:avLst/>
          </a:prstGeom>
          <a:noFill/>
        </p:spPr>
        <p:txBody>
          <a:bodyPr wrap="square" rtlCol="0">
            <a:spAutoFit/>
          </a:bodyPr>
          <a:lstStyle/>
          <a:p>
            <a:r>
              <a:rPr lang="en-US" sz="1200" b="1" dirty="0" smtClean="0">
                <a:latin typeface="Arial" panose="020B0604020202020204" pitchFamily="34" charset="0"/>
                <a:cs typeface="Arial" panose="020B0604020202020204" pitchFamily="34" charset="0"/>
              </a:rPr>
              <a:t>UKK: developmental PSs</a:t>
            </a:r>
            <a:endParaRPr lang="en-US" sz="1200" b="1" dirty="0">
              <a:latin typeface="Arial" panose="020B0604020202020204" pitchFamily="34" charset="0"/>
              <a:cs typeface="Arial" panose="020B0604020202020204" pitchFamily="34" charset="0"/>
            </a:endParaRPr>
          </a:p>
        </p:txBody>
      </p:sp>
      <p:sp>
        <p:nvSpPr>
          <p:cNvPr id="48" name="TextBox 47"/>
          <p:cNvSpPr txBox="1"/>
          <p:nvPr/>
        </p:nvSpPr>
        <p:spPr>
          <a:xfrm>
            <a:off x="228600" y="350222"/>
            <a:ext cx="381000" cy="307777"/>
          </a:xfrm>
          <a:prstGeom prst="rect">
            <a:avLst/>
          </a:prstGeom>
          <a:noFill/>
        </p:spPr>
        <p:txBody>
          <a:bodyPr wrap="square" rtlCol="0">
            <a:spAutoFit/>
          </a:bodyPr>
          <a:lstStyle/>
          <a:p>
            <a:r>
              <a:rPr lang="en-US" sz="1400" dirty="0" smtClean="0">
                <a:latin typeface="Arial" panose="020B0604020202020204" pitchFamily="34" charset="0"/>
                <a:cs typeface="Arial" panose="020B0604020202020204" pitchFamily="34" charset="0"/>
              </a:rPr>
              <a:t>A</a:t>
            </a:r>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201962558"/>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33400" y="685800"/>
            <a:ext cx="4572000" cy="33544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7"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57200" y="3898095"/>
            <a:ext cx="4572000" cy="326470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Foliennummernplatzhalter 1"/>
          <p:cNvSpPr>
            <a:spLocks noGrp="1"/>
          </p:cNvSpPr>
          <p:nvPr>
            <p:ph type="sldNum" sz="quarter" idx="12"/>
          </p:nvPr>
        </p:nvSpPr>
        <p:spPr/>
        <p:txBody>
          <a:bodyPr/>
          <a:lstStyle/>
          <a:p>
            <a:fld id="{1ACA62C2-8D3F-439D-94AC-C26847FF0122}" type="slidenum">
              <a:rPr lang="en-US" smtClean="0"/>
              <a:pPr/>
              <a:t>4</a:t>
            </a:fld>
            <a:endParaRPr lang="en-US"/>
          </a:p>
        </p:txBody>
      </p:sp>
      <p:sp>
        <p:nvSpPr>
          <p:cNvPr id="9" name="TextBox 8"/>
          <p:cNvSpPr txBox="1"/>
          <p:nvPr/>
        </p:nvSpPr>
        <p:spPr>
          <a:xfrm>
            <a:off x="304800" y="606623"/>
            <a:ext cx="381000" cy="307777"/>
          </a:xfrm>
          <a:prstGeom prst="rect">
            <a:avLst/>
          </a:prstGeom>
          <a:noFill/>
        </p:spPr>
        <p:txBody>
          <a:bodyPr wrap="square" rtlCol="0">
            <a:spAutoFit/>
          </a:bodyPr>
          <a:lstStyle/>
          <a:p>
            <a:r>
              <a:rPr lang="en-US" sz="1400" dirty="0" smtClean="0">
                <a:latin typeface="Arial" panose="020B0604020202020204" pitchFamily="34" charset="0"/>
                <a:cs typeface="Arial" panose="020B0604020202020204" pitchFamily="34" charset="0"/>
              </a:rPr>
              <a:t>A</a:t>
            </a:r>
            <a:endParaRPr lang="en-US" sz="1400" dirty="0">
              <a:latin typeface="Arial" panose="020B0604020202020204" pitchFamily="34" charset="0"/>
              <a:cs typeface="Arial" panose="020B0604020202020204" pitchFamily="34" charset="0"/>
            </a:endParaRPr>
          </a:p>
        </p:txBody>
      </p:sp>
      <p:sp>
        <p:nvSpPr>
          <p:cNvPr id="10" name="TextBox 9"/>
          <p:cNvSpPr txBox="1"/>
          <p:nvPr/>
        </p:nvSpPr>
        <p:spPr>
          <a:xfrm>
            <a:off x="304800" y="3883223"/>
            <a:ext cx="381000" cy="307777"/>
          </a:xfrm>
          <a:prstGeom prst="rect">
            <a:avLst/>
          </a:prstGeom>
          <a:noFill/>
        </p:spPr>
        <p:txBody>
          <a:bodyPr wrap="square" rtlCol="0">
            <a:spAutoFit/>
          </a:bodyPr>
          <a:lstStyle/>
          <a:p>
            <a:r>
              <a:rPr lang="en-US" sz="1400" dirty="0" smtClean="0">
                <a:latin typeface="Arial" panose="020B0604020202020204" pitchFamily="34" charset="0"/>
                <a:cs typeface="Arial" panose="020B0604020202020204" pitchFamily="34" charset="0"/>
              </a:rPr>
              <a:t>B</a:t>
            </a:r>
            <a:endParaRPr lang="en-US" sz="1400" dirty="0">
              <a:latin typeface="Arial" panose="020B0604020202020204" pitchFamily="34" charset="0"/>
              <a:cs typeface="Arial" panose="020B0604020202020204" pitchFamily="34" charset="0"/>
            </a:endParaRPr>
          </a:p>
        </p:txBody>
      </p:sp>
      <p:grpSp>
        <p:nvGrpSpPr>
          <p:cNvPr id="207" name="Gruppieren 6"/>
          <p:cNvGrpSpPr/>
          <p:nvPr/>
        </p:nvGrpSpPr>
        <p:grpSpPr>
          <a:xfrm>
            <a:off x="4114800" y="454968"/>
            <a:ext cx="2599762" cy="230832"/>
            <a:chOff x="914400" y="152400"/>
            <a:chExt cx="2599762" cy="230832"/>
          </a:xfrm>
        </p:grpSpPr>
        <p:sp>
          <p:nvSpPr>
            <p:cNvPr id="208" name="Rechteck 10"/>
            <p:cNvSpPr/>
            <p:nvPr/>
          </p:nvSpPr>
          <p:spPr>
            <a:xfrm>
              <a:off x="914400" y="191616"/>
              <a:ext cx="228600" cy="152400"/>
            </a:xfrm>
            <a:prstGeom prst="rect">
              <a:avLst/>
            </a:prstGeom>
            <a:solidFill>
              <a:srgbClr val="0000CC"/>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9" name="Textfeld 11"/>
            <p:cNvSpPr txBox="1"/>
            <p:nvPr/>
          </p:nvSpPr>
          <p:spPr>
            <a:xfrm>
              <a:off x="1143000" y="152400"/>
              <a:ext cx="2371162" cy="230832"/>
            </a:xfrm>
            <a:prstGeom prst="rect">
              <a:avLst/>
            </a:prstGeom>
            <a:noFill/>
          </p:spPr>
          <p:txBody>
            <a:bodyPr wrap="none" rtlCol="0">
              <a:spAutoFit/>
            </a:bodyPr>
            <a:lstStyle/>
            <a:p>
              <a:r>
                <a:rPr lang="en-US" sz="900" dirty="0" smtClean="0">
                  <a:latin typeface="Arial" pitchFamily="34" charset="0"/>
                  <a:cs typeface="Arial" pitchFamily="34" charset="0"/>
                </a:rPr>
                <a:t>Down-reg. D-genes with absolute numbers</a:t>
              </a:r>
              <a:endParaRPr lang="en-US" sz="900" dirty="0">
                <a:latin typeface="Arial" pitchFamily="34" charset="0"/>
                <a:cs typeface="Arial" pitchFamily="34" charset="0"/>
              </a:endParaRPr>
            </a:p>
          </p:txBody>
        </p:sp>
      </p:grpSp>
      <p:grpSp>
        <p:nvGrpSpPr>
          <p:cNvPr id="210" name="Gruppieren 5"/>
          <p:cNvGrpSpPr/>
          <p:nvPr/>
        </p:nvGrpSpPr>
        <p:grpSpPr>
          <a:xfrm>
            <a:off x="4114800" y="228600"/>
            <a:ext cx="2514600" cy="230832"/>
            <a:chOff x="914400" y="381000"/>
            <a:chExt cx="2514600" cy="230832"/>
          </a:xfrm>
        </p:grpSpPr>
        <p:sp>
          <p:nvSpPr>
            <p:cNvPr id="211" name="Rechteck 12"/>
            <p:cNvSpPr/>
            <p:nvPr/>
          </p:nvSpPr>
          <p:spPr>
            <a:xfrm>
              <a:off x="914400" y="420216"/>
              <a:ext cx="228600" cy="1524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2" name="Textfeld 13"/>
            <p:cNvSpPr txBox="1"/>
            <p:nvPr/>
          </p:nvSpPr>
          <p:spPr>
            <a:xfrm>
              <a:off x="1143000" y="381000"/>
              <a:ext cx="2286000" cy="230832"/>
            </a:xfrm>
            <a:prstGeom prst="rect">
              <a:avLst/>
            </a:prstGeom>
            <a:noFill/>
          </p:spPr>
          <p:txBody>
            <a:bodyPr wrap="square" rtlCol="0">
              <a:spAutoFit/>
            </a:bodyPr>
            <a:lstStyle/>
            <a:p>
              <a:r>
                <a:rPr lang="en-US" sz="900" dirty="0" smtClean="0">
                  <a:latin typeface="Arial" pitchFamily="34" charset="0"/>
                  <a:cs typeface="Arial" pitchFamily="34" charset="0"/>
                </a:rPr>
                <a:t>Up-reg. D-genes with absolute numbers</a:t>
              </a:r>
              <a:endParaRPr lang="en-US" sz="900" dirty="0">
                <a:latin typeface="Arial" pitchFamily="34" charset="0"/>
                <a:cs typeface="Arial" pitchFamily="34" charset="0"/>
              </a:endParaRPr>
            </a:p>
          </p:txBody>
        </p:sp>
      </p:grpSp>
      <p:sp>
        <p:nvSpPr>
          <p:cNvPr id="3" name="Rectangle 2"/>
          <p:cNvSpPr/>
          <p:nvPr/>
        </p:nvSpPr>
        <p:spPr>
          <a:xfrm>
            <a:off x="228600" y="7086600"/>
            <a:ext cx="6400800" cy="246221"/>
          </a:xfrm>
          <a:prstGeom prst="rect">
            <a:avLst/>
          </a:prstGeom>
        </p:spPr>
        <p:txBody>
          <a:bodyPr>
            <a:spAutoFit/>
          </a:bodyPr>
          <a:lstStyle/>
          <a:p>
            <a:pPr algn="just"/>
            <a:r>
              <a:rPr lang="en-GB" sz="1000" dirty="0" smtClean="0">
                <a:latin typeface="Arial" panose="020B0604020202020204" pitchFamily="34" charset="0"/>
                <a:cs typeface="Arial" panose="020B0604020202020204" pitchFamily="34" charset="0"/>
              </a:rPr>
              <a:t>.</a:t>
            </a:r>
            <a:endParaRPr lang="en-US" sz="1000" dirty="0">
              <a:latin typeface="Arial" panose="020B0604020202020204" pitchFamily="34" charset="0"/>
              <a:cs typeface="Arial" panose="020B0604020202020204" pitchFamily="34" charset="0"/>
            </a:endParaRPr>
          </a:p>
        </p:txBody>
      </p:sp>
      <p:sp>
        <p:nvSpPr>
          <p:cNvPr id="14" name="Textfeld 11"/>
          <p:cNvSpPr txBox="1"/>
          <p:nvPr/>
        </p:nvSpPr>
        <p:spPr>
          <a:xfrm>
            <a:off x="4114800" y="685800"/>
            <a:ext cx="2608406" cy="369332"/>
          </a:xfrm>
          <a:prstGeom prst="rect">
            <a:avLst/>
          </a:prstGeom>
          <a:noFill/>
        </p:spPr>
        <p:txBody>
          <a:bodyPr wrap="none" rtlCol="0">
            <a:spAutoFit/>
          </a:bodyPr>
          <a:lstStyle/>
          <a:p>
            <a:r>
              <a:rPr lang="en-US" sz="900" dirty="0" smtClean="0">
                <a:latin typeface="Arial" pitchFamily="34" charset="0"/>
                <a:cs typeface="Arial" pitchFamily="34" charset="0"/>
              </a:rPr>
              <a:t>* The numbers </a:t>
            </a:r>
            <a:r>
              <a:rPr lang="en-US" sz="900" dirty="0">
                <a:latin typeface="Arial" pitchFamily="34" charset="0"/>
                <a:cs typeface="Arial" pitchFamily="34" charset="0"/>
              </a:rPr>
              <a:t>on the X-axis (2;5;10</a:t>
            </a:r>
            <a:r>
              <a:rPr lang="en-US" sz="900" dirty="0" smtClean="0">
                <a:latin typeface="Arial" pitchFamily="34" charset="0"/>
                <a:cs typeface="Arial" pitchFamily="34" charset="0"/>
              </a:rPr>
              <a:t>)</a:t>
            </a:r>
          </a:p>
          <a:p>
            <a:r>
              <a:rPr lang="en-US" sz="900" dirty="0" smtClean="0">
                <a:latin typeface="Arial" pitchFamily="34" charset="0"/>
                <a:cs typeface="Arial" pitchFamily="34" charset="0"/>
              </a:rPr>
              <a:t> represents  the fold change values of D-genes.</a:t>
            </a:r>
            <a:endParaRPr lang="en-US" sz="900" dirty="0">
              <a:latin typeface="Arial" pitchFamily="34" charset="0"/>
              <a:cs typeface="Arial" pitchFamily="34" charset="0"/>
            </a:endParaRPr>
          </a:p>
        </p:txBody>
      </p:sp>
      <p:sp>
        <p:nvSpPr>
          <p:cNvPr id="7" name="TextBox 6"/>
          <p:cNvSpPr txBox="1"/>
          <p:nvPr/>
        </p:nvSpPr>
        <p:spPr>
          <a:xfrm>
            <a:off x="304800" y="7020342"/>
            <a:ext cx="6019800" cy="1954381"/>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Supplementary Figure S4.</a:t>
            </a:r>
            <a:r>
              <a:rPr lang="en-GB" sz="1100" dirty="0">
                <a:latin typeface="Arial" panose="020B0604020202020204" pitchFamily="34" charset="0"/>
                <a:cs typeface="Arial" panose="020B0604020202020204" pitchFamily="34" charset="0"/>
              </a:rPr>
              <a:t> Overlap analysis of developmental genes and unified genes influenced by </a:t>
            </a:r>
            <a:r>
              <a:rPr lang="en-GB" sz="1100" dirty="0" err="1">
                <a:latin typeface="Arial" panose="020B0604020202020204" pitchFamily="34" charset="0"/>
                <a:cs typeface="Arial" panose="020B0604020202020204" pitchFamily="34" charset="0"/>
              </a:rPr>
              <a:t>mercurials</a:t>
            </a:r>
            <a:r>
              <a:rPr lang="en-GB" sz="1100" dirty="0">
                <a:latin typeface="Arial" panose="020B0604020202020204" pitchFamily="34" charset="0"/>
                <a:cs typeface="Arial" panose="020B0604020202020204" pitchFamily="34" charset="0"/>
              </a:rPr>
              <a:t> and </a:t>
            </a:r>
            <a:r>
              <a:rPr lang="en-GB" sz="1100" dirty="0" err="1">
                <a:latin typeface="Arial" panose="020B0604020202020204" pitchFamily="34" charset="0"/>
                <a:cs typeface="Arial" panose="020B0604020202020204" pitchFamily="34" charset="0"/>
              </a:rPr>
              <a:t>HDACis</a:t>
            </a:r>
            <a:r>
              <a:rPr lang="en-GB" sz="1100" dirty="0">
                <a:latin typeface="Arial" panose="020B0604020202020204" pitchFamily="34" charset="0"/>
                <a:cs typeface="Arial" panose="020B0604020202020204" pitchFamily="34" charset="0"/>
              </a:rPr>
              <a:t>.</a:t>
            </a:r>
            <a:r>
              <a:rPr lang="en-GB" sz="1100" b="1" dirty="0">
                <a:latin typeface="Arial" panose="020B0604020202020204" pitchFamily="34" charset="0"/>
                <a:cs typeface="Arial" panose="020B0604020202020204" pitchFamily="34" charset="0"/>
              </a:rPr>
              <a:t> </a:t>
            </a:r>
            <a:r>
              <a:rPr lang="en-GB" sz="1100" dirty="0">
                <a:latin typeface="Arial" panose="020B0604020202020204" pitchFamily="34" charset="0"/>
                <a:cs typeface="Arial" panose="020B0604020202020204" pitchFamily="34" charset="0"/>
              </a:rPr>
              <a:t>Differentiating cells were treated by </a:t>
            </a:r>
            <a:r>
              <a:rPr lang="en-GB" sz="1100" dirty="0" err="1">
                <a:latin typeface="Arial" panose="020B0604020202020204" pitchFamily="34" charset="0"/>
                <a:cs typeface="Arial" panose="020B0604020202020204" pitchFamily="34" charset="0"/>
              </a:rPr>
              <a:t>mercurials</a:t>
            </a:r>
            <a:r>
              <a:rPr lang="en-GB" sz="1100" dirty="0">
                <a:latin typeface="Arial" panose="020B0604020202020204" pitchFamily="34" charset="0"/>
                <a:cs typeface="Arial" panose="020B0604020202020204" pitchFamily="34" charset="0"/>
              </a:rPr>
              <a:t> and </a:t>
            </a:r>
            <a:r>
              <a:rPr lang="en-GB" sz="1100" dirty="0" err="1">
                <a:latin typeface="Arial" panose="020B0604020202020204" pitchFamily="34" charset="0"/>
                <a:cs typeface="Arial" panose="020B0604020202020204" pitchFamily="34" charset="0"/>
              </a:rPr>
              <a:t>HDACis</a:t>
            </a:r>
            <a:r>
              <a:rPr lang="en-GB" sz="1100" dirty="0">
                <a:latin typeface="Arial" panose="020B0604020202020204" pitchFamily="34" charset="0"/>
                <a:cs typeface="Arial" panose="020B0604020202020204" pitchFamily="34" charset="0"/>
              </a:rPr>
              <a:t>, as indicated in Fig. 1A, and were used for transcriptome analysis. Genes affected by the differentiation process (D-genes) were identified as described in Suppl. Table 1, and toxicant-affected genes (T-genes) were identified as described in Fig. 4. (</a:t>
            </a:r>
            <a:r>
              <a:rPr lang="en-GB" sz="1100" b="1" dirty="0">
                <a:latin typeface="Arial" panose="020B0604020202020204" pitchFamily="34" charset="0"/>
                <a:cs typeface="Arial" panose="020B0604020202020204" pitchFamily="34" charset="0"/>
              </a:rPr>
              <a:t>A</a:t>
            </a:r>
            <a:r>
              <a:rPr lang="en-GB" sz="1100" dirty="0">
                <a:latin typeface="Arial" panose="020B0604020202020204" pitchFamily="34" charset="0"/>
                <a:cs typeface="Arial" panose="020B0604020202020204" pitchFamily="34" charset="0"/>
              </a:rPr>
              <a:t>) The overlap of up-regulated mercurial T-genes with up- (red) and down- (blue) regulated D-genes as well as the overlap of down-regulated mercurial T-genes with up- and down-regulated D-genes was calculated for each system. The data are expressed as the fraction of D-genes affected by toxicants. (</a:t>
            </a:r>
            <a:r>
              <a:rPr lang="en-GB" sz="1100" b="1" dirty="0">
                <a:latin typeface="Arial" panose="020B0604020202020204" pitchFamily="34" charset="0"/>
                <a:cs typeface="Arial" panose="020B0604020202020204" pitchFamily="34" charset="0"/>
              </a:rPr>
              <a:t>B</a:t>
            </a:r>
            <a:r>
              <a:rPr lang="en-GB" sz="1100" dirty="0">
                <a:latin typeface="Arial" panose="020B0604020202020204" pitchFamily="34" charset="0"/>
                <a:cs typeface="Arial" panose="020B0604020202020204" pitchFamily="34" charset="0"/>
              </a:rPr>
              <a:t>) The same procedure was performed for the </a:t>
            </a:r>
            <a:r>
              <a:rPr lang="en-GB" sz="1100" dirty="0" err="1">
                <a:latin typeface="Arial" panose="020B0604020202020204" pitchFamily="34" charset="0"/>
                <a:cs typeface="Arial" panose="020B0604020202020204" pitchFamily="34" charset="0"/>
              </a:rPr>
              <a:t>HDACis</a:t>
            </a:r>
            <a:r>
              <a:rPr lang="en-GB" sz="1100" dirty="0">
                <a:latin typeface="Arial" panose="020B0604020202020204" pitchFamily="34" charset="0"/>
                <a:cs typeface="Arial" panose="020B0604020202020204" pitchFamily="34" charset="0"/>
              </a:rPr>
              <a:t>. Blue bars represent D-genes down-regulated and red bars indicate D-genes up-regulated during normal differentiation. The numbers on top of the bars indicate the absolute number of PSs affected.</a:t>
            </a:r>
            <a:endParaRPr 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22885535"/>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429000" y="1015668"/>
            <a:ext cx="3200400" cy="17275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Foliennummernplatzhalter 1"/>
          <p:cNvSpPr>
            <a:spLocks noGrp="1"/>
          </p:cNvSpPr>
          <p:nvPr>
            <p:ph type="sldNum" sz="quarter" idx="12"/>
          </p:nvPr>
        </p:nvSpPr>
        <p:spPr/>
        <p:txBody>
          <a:bodyPr/>
          <a:lstStyle/>
          <a:p>
            <a:fld id="{1ACA62C2-8D3F-439D-94AC-C26847FF0122}" type="slidenum">
              <a:rPr lang="en-US" smtClean="0"/>
              <a:pPr/>
              <a:t>5</a:t>
            </a:fld>
            <a:endParaRPr lang="en-US"/>
          </a:p>
        </p:txBody>
      </p:sp>
      <p:sp>
        <p:nvSpPr>
          <p:cNvPr id="9" name="TextBox 8"/>
          <p:cNvSpPr txBox="1"/>
          <p:nvPr/>
        </p:nvSpPr>
        <p:spPr>
          <a:xfrm>
            <a:off x="86543" y="685800"/>
            <a:ext cx="381000" cy="307777"/>
          </a:xfrm>
          <a:prstGeom prst="rect">
            <a:avLst/>
          </a:prstGeom>
          <a:noFill/>
        </p:spPr>
        <p:txBody>
          <a:bodyPr wrap="square" rtlCol="0">
            <a:spAutoFit/>
          </a:bodyPr>
          <a:lstStyle/>
          <a:p>
            <a:r>
              <a:rPr lang="en-US" sz="1400" dirty="0" smtClean="0">
                <a:latin typeface="Arial" panose="020B0604020202020204" pitchFamily="34" charset="0"/>
                <a:cs typeface="Arial" panose="020B0604020202020204" pitchFamily="34" charset="0"/>
              </a:rPr>
              <a:t>A</a:t>
            </a:r>
            <a:endParaRPr lang="en-US" sz="1400" dirty="0">
              <a:latin typeface="Arial" panose="020B0604020202020204" pitchFamily="34" charset="0"/>
              <a:cs typeface="Arial" panose="020B0604020202020204" pitchFamily="34" charset="0"/>
            </a:endParaRPr>
          </a:p>
        </p:txBody>
      </p:sp>
      <p:sp>
        <p:nvSpPr>
          <p:cNvPr id="10" name="TextBox 9"/>
          <p:cNvSpPr txBox="1"/>
          <p:nvPr/>
        </p:nvSpPr>
        <p:spPr>
          <a:xfrm>
            <a:off x="3439343" y="685800"/>
            <a:ext cx="381000" cy="307777"/>
          </a:xfrm>
          <a:prstGeom prst="rect">
            <a:avLst/>
          </a:prstGeom>
          <a:noFill/>
        </p:spPr>
        <p:txBody>
          <a:bodyPr wrap="square" rtlCol="0">
            <a:spAutoFit/>
          </a:bodyPr>
          <a:lstStyle/>
          <a:p>
            <a:r>
              <a:rPr lang="en-US" sz="1400" dirty="0" smtClean="0">
                <a:latin typeface="Arial" panose="020B0604020202020204" pitchFamily="34" charset="0"/>
                <a:cs typeface="Arial" panose="020B0604020202020204" pitchFamily="34" charset="0"/>
              </a:rPr>
              <a:t>B</a:t>
            </a:r>
            <a:endParaRPr lang="en-US" sz="1400" dirty="0">
              <a:latin typeface="Arial" panose="020B0604020202020204" pitchFamily="34" charset="0"/>
              <a:cs typeface="Arial" panose="020B0604020202020204" pitchFamily="34" charset="0"/>
            </a:endParaRPr>
          </a:p>
        </p:txBody>
      </p:sp>
      <p:sp>
        <p:nvSpPr>
          <p:cNvPr id="13" name="TextBox 12"/>
          <p:cNvSpPr txBox="1"/>
          <p:nvPr/>
        </p:nvSpPr>
        <p:spPr>
          <a:xfrm>
            <a:off x="76200" y="3048000"/>
            <a:ext cx="381000" cy="307777"/>
          </a:xfrm>
          <a:prstGeom prst="rect">
            <a:avLst/>
          </a:prstGeom>
          <a:noFill/>
        </p:spPr>
        <p:txBody>
          <a:bodyPr wrap="square" rtlCol="0">
            <a:spAutoFit/>
          </a:bodyPr>
          <a:lstStyle/>
          <a:p>
            <a:r>
              <a:rPr lang="en-US" sz="1400" dirty="0" smtClean="0">
                <a:latin typeface="Arial" panose="020B0604020202020204" pitchFamily="34" charset="0"/>
                <a:cs typeface="Arial" panose="020B0604020202020204" pitchFamily="34" charset="0"/>
              </a:rPr>
              <a:t>C</a:t>
            </a:r>
            <a:endParaRPr lang="en-US" sz="1400" dirty="0">
              <a:latin typeface="Arial" panose="020B0604020202020204" pitchFamily="34" charset="0"/>
              <a:cs typeface="Arial" panose="020B0604020202020204" pitchFamily="34" charset="0"/>
            </a:endParaRPr>
          </a:p>
        </p:txBody>
      </p:sp>
      <p:sp>
        <p:nvSpPr>
          <p:cNvPr id="14" name="TextBox 13"/>
          <p:cNvSpPr txBox="1"/>
          <p:nvPr/>
        </p:nvSpPr>
        <p:spPr>
          <a:xfrm>
            <a:off x="3429000" y="3048000"/>
            <a:ext cx="3810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D</a:t>
            </a:r>
          </a:p>
        </p:txBody>
      </p:sp>
      <p:pic>
        <p:nvPicPr>
          <p:cNvPr id="26630" name="Picture 6"/>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09078" y="3300363"/>
            <a:ext cx="3200400" cy="286314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6631" name="Picture 7"/>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429000" y="3278122"/>
            <a:ext cx="3200400" cy="286126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9700" name="Picture 4"/>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259080" y="954019"/>
            <a:ext cx="3200400" cy="178918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Rectangle 2"/>
          <p:cNvSpPr/>
          <p:nvPr/>
        </p:nvSpPr>
        <p:spPr>
          <a:xfrm>
            <a:off x="228600" y="6477000"/>
            <a:ext cx="6400800" cy="2292935"/>
          </a:xfrm>
          <a:prstGeom prst="rect">
            <a:avLst/>
          </a:prstGeom>
        </p:spPr>
        <p:txBody>
          <a:bodyPr>
            <a:spAutoFit/>
          </a:bodyPr>
          <a:lstStyle/>
          <a:p>
            <a:pPr algn="just"/>
            <a:r>
              <a:rPr lang="en-GB" sz="1100" b="1" dirty="0">
                <a:latin typeface="Arial" panose="020B0604020202020204" pitchFamily="34" charset="0"/>
                <a:cs typeface="Arial" panose="020B0604020202020204" pitchFamily="34" charset="0"/>
              </a:rPr>
              <a:t>Supplementary Figure S5.</a:t>
            </a:r>
            <a:r>
              <a:rPr lang="en-GB" sz="1100" dirty="0">
                <a:latin typeface="Arial" panose="020B0604020202020204" pitchFamily="34" charset="0"/>
                <a:cs typeface="Arial" panose="020B0604020202020204" pitchFamily="34" charset="0"/>
              </a:rPr>
              <a:t> Overlap analysis of baseline expression values (log2 scale) of developmental genes and unified genes influenced by </a:t>
            </a:r>
            <a:r>
              <a:rPr lang="en-GB" sz="1100" dirty="0" err="1">
                <a:latin typeface="Arial" panose="020B0604020202020204" pitchFamily="34" charset="0"/>
                <a:cs typeface="Arial" panose="020B0604020202020204" pitchFamily="34" charset="0"/>
              </a:rPr>
              <a:t>mercurials</a:t>
            </a:r>
            <a:r>
              <a:rPr lang="en-GB" sz="1100" dirty="0">
                <a:latin typeface="Arial" panose="020B0604020202020204" pitchFamily="34" charset="0"/>
                <a:cs typeface="Arial" panose="020B0604020202020204" pitchFamily="34" charset="0"/>
              </a:rPr>
              <a:t> and </a:t>
            </a:r>
            <a:r>
              <a:rPr lang="en-GB" sz="1100" dirty="0" err="1">
                <a:latin typeface="Arial" panose="020B0604020202020204" pitchFamily="34" charset="0"/>
                <a:cs typeface="Arial" panose="020B0604020202020204" pitchFamily="34" charset="0"/>
              </a:rPr>
              <a:t>HDACis</a:t>
            </a:r>
            <a:r>
              <a:rPr lang="en-GB" sz="1100" dirty="0">
                <a:latin typeface="Arial" panose="020B0604020202020204" pitchFamily="34" charset="0"/>
                <a:cs typeface="Arial" panose="020B0604020202020204" pitchFamily="34" charset="0"/>
              </a:rPr>
              <a:t>.</a:t>
            </a:r>
            <a:r>
              <a:rPr lang="en-GB" sz="1100" b="1" dirty="0">
                <a:latin typeface="Arial" panose="020B0604020202020204" pitchFamily="34" charset="0"/>
                <a:cs typeface="Arial" panose="020B0604020202020204" pitchFamily="34" charset="0"/>
              </a:rPr>
              <a:t> </a:t>
            </a:r>
            <a:r>
              <a:rPr lang="en-GB" sz="1100" dirty="0">
                <a:latin typeface="Arial" panose="020B0604020202020204" pitchFamily="34" charset="0"/>
                <a:cs typeface="Arial" panose="020B0604020202020204" pitchFamily="34" charset="0"/>
              </a:rPr>
              <a:t>The developmental genes were subcategorised based on baseline expression values (log2 scale) in the four groups </a:t>
            </a:r>
            <a:r>
              <a:rPr lang="en-GB" sz="1100" dirty="0" err="1">
                <a:latin typeface="Arial" panose="020B0604020202020204" pitchFamily="34" charset="0"/>
                <a:cs typeface="Arial" panose="020B0604020202020204" pitchFamily="34" charset="0"/>
              </a:rPr>
              <a:t>i</a:t>
            </a:r>
            <a:r>
              <a:rPr lang="en-GB" sz="1100" dirty="0">
                <a:latin typeface="Arial" panose="020B0604020202020204" pitchFamily="34" charset="0"/>
                <a:cs typeface="Arial" panose="020B0604020202020204" pitchFamily="34" charset="0"/>
              </a:rPr>
              <a:t>) day 0 &gt;6, day 6 or 14 &lt;6; ii) day 0 &lt;6, day 6 or 14 &gt;6; iii) day 0 &lt;6, day 6 or 14 &lt;6; and iv) day 0 &gt;6, day 6 or 14 &gt;6. These groups were further overlapped with unified genes for </a:t>
            </a:r>
            <a:r>
              <a:rPr lang="en-GB" sz="1100" dirty="0" err="1">
                <a:latin typeface="Arial" panose="020B0604020202020204" pitchFamily="34" charset="0"/>
                <a:cs typeface="Arial" panose="020B0604020202020204" pitchFamily="34" charset="0"/>
              </a:rPr>
              <a:t>mercurials</a:t>
            </a:r>
            <a:r>
              <a:rPr lang="en-GB" sz="1100" dirty="0">
                <a:latin typeface="Arial" panose="020B0604020202020204" pitchFamily="34" charset="0"/>
                <a:cs typeface="Arial" panose="020B0604020202020204" pitchFamily="34" charset="0"/>
              </a:rPr>
              <a:t> and </a:t>
            </a:r>
            <a:r>
              <a:rPr lang="en-GB" sz="1100" dirty="0" err="1">
                <a:latin typeface="Arial" panose="020B0604020202020204" pitchFamily="34" charset="0"/>
                <a:cs typeface="Arial" panose="020B0604020202020204" pitchFamily="34" charset="0"/>
              </a:rPr>
              <a:t>HDACis</a:t>
            </a:r>
            <a:r>
              <a:rPr lang="en-GB" sz="1100" dirty="0">
                <a:latin typeface="Arial" panose="020B0604020202020204" pitchFamily="34" charset="0"/>
                <a:cs typeface="Arial" panose="020B0604020202020204" pitchFamily="34" charset="0"/>
              </a:rPr>
              <a:t> and plotted for visualization as percent overlap vs baseline expression groups. (</a:t>
            </a:r>
            <a:r>
              <a:rPr lang="en-GB" sz="1100" b="1" dirty="0">
                <a:latin typeface="Arial" panose="020B0604020202020204" pitchFamily="34" charset="0"/>
                <a:cs typeface="Arial" panose="020B0604020202020204" pitchFamily="34" charset="0"/>
              </a:rPr>
              <a:t>A</a:t>
            </a:r>
            <a:r>
              <a:rPr lang="en-GB" sz="1100" dirty="0">
                <a:latin typeface="Arial" panose="020B0604020202020204" pitchFamily="34" charset="0"/>
                <a:cs typeface="Arial" panose="020B0604020202020204" pitchFamily="34" charset="0"/>
              </a:rPr>
              <a:t>) The percent influence of developmental genes in the groups </a:t>
            </a:r>
            <a:r>
              <a:rPr lang="en-GB" sz="1100" dirty="0" err="1">
                <a:latin typeface="Arial" panose="020B0604020202020204" pitchFamily="34" charset="0"/>
                <a:cs typeface="Arial" panose="020B0604020202020204" pitchFamily="34" charset="0"/>
              </a:rPr>
              <a:t>i</a:t>
            </a:r>
            <a:r>
              <a:rPr lang="en-GB" sz="1100" dirty="0">
                <a:latin typeface="Arial" panose="020B0604020202020204" pitchFamily="34" charset="0"/>
                <a:cs typeface="Arial" panose="020B0604020202020204" pitchFamily="34" charset="0"/>
              </a:rPr>
              <a:t> and ii with </a:t>
            </a:r>
            <a:r>
              <a:rPr lang="en-GB" sz="1100" dirty="0" err="1">
                <a:latin typeface="Arial" panose="020B0604020202020204" pitchFamily="34" charset="0"/>
                <a:cs typeface="Arial" panose="020B0604020202020204" pitchFamily="34" charset="0"/>
              </a:rPr>
              <a:t>mercurials</a:t>
            </a:r>
            <a:r>
              <a:rPr lang="en-GB" sz="1100" dirty="0">
                <a:latin typeface="Arial" panose="020B0604020202020204" pitchFamily="34" charset="0"/>
                <a:cs typeface="Arial" panose="020B0604020202020204" pitchFamily="34" charset="0"/>
              </a:rPr>
              <a:t> was higher in the UKN1 test system and appears to be more sensitive compared with the UKK test system. (</a:t>
            </a:r>
            <a:r>
              <a:rPr lang="en-GB" sz="1100" b="1" dirty="0">
                <a:latin typeface="Arial" panose="020B0604020202020204" pitchFamily="34" charset="0"/>
                <a:cs typeface="Arial" panose="020B0604020202020204" pitchFamily="34" charset="0"/>
              </a:rPr>
              <a:t>B</a:t>
            </a:r>
            <a:r>
              <a:rPr lang="en-GB" sz="1100" dirty="0">
                <a:latin typeface="Arial" panose="020B0604020202020204" pitchFamily="34" charset="0"/>
                <a:cs typeface="Arial" panose="020B0604020202020204" pitchFamily="34" charset="0"/>
              </a:rPr>
              <a:t>) The percent influence of developmental genes in groups </a:t>
            </a:r>
            <a:r>
              <a:rPr lang="en-GB" sz="1100" dirty="0" err="1">
                <a:latin typeface="Arial" panose="020B0604020202020204" pitchFamily="34" charset="0"/>
                <a:cs typeface="Arial" panose="020B0604020202020204" pitchFamily="34" charset="0"/>
              </a:rPr>
              <a:t>i</a:t>
            </a:r>
            <a:r>
              <a:rPr lang="en-GB" sz="1100" dirty="0">
                <a:latin typeface="Arial" panose="020B0604020202020204" pitchFamily="34" charset="0"/>
                <a:cs typeface="Arial" panose="020B0604020202020204" pitchFamily="34" charset="0"/>
              </a:rPr>
              <a:t> and ii with </a:t>
            </a:r>
            <a:r>
              <a:rPr lang="en-GB" sz="1100" dirty="0" err="1">
                <a:latin typeface="Arial" panose="020B0604020202020204" pitchFamily="34" charset="0"/>
                <a:cs typeface="Arial" panose="020B0604020202020204" pitchFamily="34" charset="0"/>
              </a:rPr>
              <a:t>HDACis</a:t>
            </a:r>
            <a:r>
              <a:rPr lang="en-GB" sz="1100" dirty="0">
                <a:latin typeface="Arial" panose="020B0604020202020204" pitchFamily="34" charset="0"/>
                <a:cs typeface="Arial" panose="020B0604020202020204" pitchFamily="34" charset="0"/>
              </a:rPr>
              <a:t> was also higher in the UKN1 test system, but both systems appear to be sensitive to </a:t>
            </a:r>
            <a:r>
              <a:rPr lang="en-GB" sz="1100" dirty="0" err="1">
                <a:latin typeface="Arial" panose="020B0604020202020204" pitchFamily="34" charset="0"/>
                <a:cs typeface="Arial" panose="020B0604020202020204" pitchFamily="34" charset="0"/>
              </a:rPr>
              <a:t>HDACis</a:t>
            </a:r>
            <a:r>
              <a:rPr lang="en-GB" sz="1100" dirty="0">
                <a:latin typeface="Arial" panose="020B0604020202020204" pitchFamily="34" charset="0"/>
                <a:cs typeface="Arial" panose="020B0604020202020204" pitchFamily="34" charset="0"/>
              </a:rPr>
              <a:t>. (</a:t>
            </a:r>
            <a:r>
              <a:rPr lang="en-GB" sz="1100" b="1" dirty="0">
                <a:latin typeface="Arial" panose="020B0604020202020204" pitchFamily="34" charset="0"/>
                <a:cs typeface="Arial" panose="020B0604020202020204" pitchFamily="34" charset="0"/>
              </a:rPr>
              <a:t>C, D</a:t>
            </a:r>
            <a:r>
              <a:rPr lang="en-GB" sz="1100" dirty="0">
                <a:latin typeface="Arial" panose="020B0604020202020204" pitchFamily="34" charset="0"/>
                <a:cs typeface="Arial" panose="020B0604020202020204" pitchFamily="34" charset="0"/>
              </a:rPr>
              <a:t>) The numbers of all PSs belonging to untreated controls in the UKK and UKN1 test systems were plotted as frequencies in 100 bins obtained with equal distribution from the maximum to minimum fold change values. Frequency vs bins plots were obtained and are graphically represented in the figures.</a:t>
            </a:r>
            <a:endParaRPr 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66995888"/>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38" name="Picture 14"/>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52400" y="2976022"/>
            <a:ext cx="3200400" cy="220557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3" name="Picture 9"/>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429000" y="2971800"/>
            <a:ext cx="3200400" cy="220304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2" name="Picture 8"/>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429000" y="5187644"/>
            <a:ext cx="3200400" cy="212755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0" name="Picture 6"/>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228600" y="5194303"/>
            <a:ext cx="3200400" cy="21208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218" name="Picture 2"/>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228600" y="838200"/>
            <a:ext cx="3200400" cy="20926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 name="TextBox 8"/>
          <p:cNvSpPr txBox="1"/>
          <p:nvPr/>
        </p:nvSpPr>
        <p:spPr>
          <a:xfrm>
            <a:off x="76200" y="685800"/>
            <a:ext cx="381000" cy="307777"/>
          </a:xfrm>
          <a:prstGeom prst="rect">
            <a:avLst/>
          </a:prstGeom>
          <a:noFill/>
        </p:spPr>
        <p:txBody>
          <a:bodyPr wrap="square" rtlCol="0">
            <a:spAutoFit/>
          </a:bodyPr>
          <a:lstStyle/>
          <a:p>
            <a:r>
              <a:rPr lang="en-US" sz="1400" dirty="0" smtClean="0">
                <a:latin typeface="Arial" panose="020B0604020202020204" pitchFamily="34" charset="0"/>
                <a:cs typeface="Arial" panose="020B0604020202020204" pitchFamily="34" charset="0"/>
              </a:rPr>
              <a:t>A</a:t>
            </a:r>
            <a:endParaRPr lang="en-US" sz="1400" dirty="0">
              <a:latin typeface="Arial" panose="020B0604020202020204" pitchFamily="34" charset="0"/>
              <a:cs typeface="Arial" panose="020B0604020202020204" pitchFamily="34" charset="0"/>
            </a:endParaRPr>
          </a:p>
        </p:txBody>
      </p:sp>
      <p:pic>
        <p:nvPicPr>
          <p:cNvPr id="9219" name="Picture 3"/>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3429000" y="887244"/>
            <a:ext cx="3200400" cy="208455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Foliennummernplatzhalter 1"/>
          <p:cNvSpPr>
            <a:spLocks noGrp="1"/>
          </p:cNvSpPr>
          <p:nvPr>
            <p:ph type="sldNum" sz="quarter" idx="12"/>
          </p:nvPr>
        </p:nvSpPr>
        <p:spPr>
          <a:xfrm>
            <a:off x="5219700" y="8597902"/>
            <a:ext cx="1600200" cy="486833"/>
          </a:xfrm>
        </p:spPr>
        <p:txBody>
          <a:bodyPr/>
          <a:lstStyle/>
          <a:p>
            <a:fld id="{1ACA62C2-8D3F-439D-94AC-C26847FF0122}" type="slidenum">
              <a:rPr lang="en-US" smtClean="0"/>
              <a:pPr/>
              <a:t>6</a:t>
            </a:fld>
            <a:endParaRPr lang="en-US"/>
          </a:p>
        </p:txBody>
      </p:sp>
      <p:sp>
        <p:nvSpPr>
          <p:cNvPr id="26" name="TextBox 25"/>
          <p:cNvSpPr txBox="1"/>
          <p:nvPr/>
        </p:nvSpPr>
        <p:spPr>
          <a:xfrm>
            <a:off x="76200" y="2819400"/>
            <a:ext cx="3810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C</a:t>
            </a:r>
          </a:p>
        </p:txBody>
      </p:sp>
      <p:sp>
        <p:nvSpPr>
          <p:cNvPr id="27" name="TextBox 26"/>
          <p:cNvSpPr txBox="1"/>
          <p:nvPr/>
        </p:nvSpPr>
        <p:spPr>
          <a:xfrm>
            <a:off x="3352800" y="2822377"/>
            <a:ext cx="381000" cy="307777"/>
          </a:xfrm>
          <a:prstGeom prst="rect">
            <a:avLst/>
          </a:prstGeom>
          <a:noFill/>
        </p:spPr>
        <p:txBody>
          <a:bodyPr wrap="square" rtlCol="0">
            <a:spAutoFit/>
          </a:bodyPr>
          <a:lstStyle/>
          <a:p>
            <a:r>
              <a:rPr lang="en-US" sz="1400" dirty="0" smtClean="0">
                <a:latin typeface="Arial" panose="020B0604020202020204" pitchFamily="34" charset="0"/>
                <a:cs typeface="Arial" panose="020B0604020202020204" pitchFamily="34" charset="0"/>
              </a:rPr>
              <a:t>D</a:t>
            </a:r>
            <a:endParaRPr lang="en-US" sz="1400" dirty="0">
              <a:latin typeface="Arial" panose="020B0604020202020204" pitchFamily="34" charset="0"/>
              <a:cs typeface="Arial" panose="020B0604020202020204" pitchFamily="34" charset="0"/>
            </a:endParaRPr>
          </a:p>
        </p:txBody>
      </p:sp>
      <p:sp>
        <p:nvSpPr>
          <p:cNvPr id="31" name="TextBox 30"/>
          <p:cNvSpPr txBox="1"/>
          <p:nvPr/>
        </p:nvSpPr>
        <p:spPr>
          <a:xfrm>
            <a:off x="152400" y="5029200"/>
            <a:ext cx="381000" cy="307777"/>
          </a:xfrm>
          <a:prstGeom prst="rect">
            <a:avLst/>
          </a:prstGeom>
          <a:noFill/>
        </p:spPr>
        <p:txBody>
          <a:bodyPr wrap="square" rtlCol="0">
            <a:spAutoFit/>
          </a:bodyPr>
          <a:lstStyle/>
          <a:p>
            <a:r>
              <a:rPr lang="en-US" sz="1400" dirty="0" smtClean="0">
                <a:latin typeface="Arial" panose="020B0604020202020204" pitchFamily="34" charset="0"/>
                <a:cs typeface="Arial" panose="020B0604020202020204" pitchFamily="34" charset="0"/>
              </a:rPr>
              <a:t>E</a:t>
            </a:r>
            <a:endParaRPr lang="en-US" sz="1400" dirty="0">
              <a:latin typeface="Arial" panose="020B0604020202020204" pitchFamily="34" charset="0"/>
              <a:cs typeface="Arial" panose="020B0604020202020204" pitchFamily="34" charset="0"/>
            </a:endParaRPr>
          </a:p>
        </p:txBody>
      </p:sp>
      <p:sp>
        <p:nvSpPr>
          <p:cNvPr id="32" name="TextBox 31"/>
          <p:cNvSpPr txBox="1"/>
          <p:nvPr/>
        </p:nvSpPr>
        <p:spPr>
          <a:xfrm>
            <a:off x="3352800" y="5029200"/>
            <a:ext cx="381000" cy="307777"/>
          </a:xfrm>
          <a:prstGeom prst="rect">
            <a:avLst/>
          </a:prstGeom>
          <a:noFill/>
        </p:spPr>
        <p:txBody>
          <a:bodyPr wrap="square" rtlCol="0">
            <a:spAutoFit/>
          </a:bodyPr>
          <a:lstStyle/>
          <a:p>
            <a:r>
              <a:rPr lang="en-US" sz="1400" dirty="0" smtClean="0">
                <a:latin typeface="Arial" panose="020B0604020202020204" pitchFamily="34" charset="0"/>
                <a:cs typeface="Arial" panose="020B0604020202020204" pitchFamily="34" charset="0"/>
              </a:rPr>
              <a:t>F</a:t>
            </a:r>
            <a:endParaRPr lang="en-US" sz="1400" dirty="0">
              <a:latin typeface="Arial" panose="020B0604020202020204" pitchFamily="34" charset="0"/>
              <a:cs typeface="Arial" panose="020B0604020202020204" pitchFamily="34" charset="0"/>
            </a:endParaRPr>
          </a:p>
        </p:txBody>
      </p:sp>
      <p:sp>
        <p:nvSpPr>
          <p:cNvPr id="146" name="Textfeld 57"/>
          <p:cNvSpPr txBox="1"/>
          <p:nvPr/>
        </p:nvSpPr>
        <p:spPr>
          <a:xfrm>
            <a:off x="4114800" y="112693"/>
            <a:ext cx="2438400" cy="523220"/>
          </a:xfrm>
          <a:prstGeom prst="rect">
            <a:avLst/>
          </a:prstGeom>
          <a:noFill/>
        </p:spPr>
        <p:txBody>
          <a:bodyPr wrap="square" rtlCol="0">
            <a:spAutoFit/>
          </a:bodyPr>
          <a:lstStyle/>
          <a:p>
            <a:r>
              <a:rPr lang="en-US" sz="700" dirty="0" smtClean="0">
                <a:solidFill>
                  <a:srgbClr val="009900"/>
                </a:solidFill>
                <a:latin typeface="Arial" pitchFamily="34" charset="0"/>
                <a:cs typeface="Arial" pitchFamily="34" charset="0"/>
              </a:rPr>
              <a:t>D-genes: for specific developments in UKN1 as follows : </a:t>
            </a:r>
          </a:p>
          <a:p>
            <a:r>
              <a:rPr lang="en-US" sz="700" dirty="0" smtClean="0">
                <a:solidFill>
                  <a:srgbClr val="009900"/>
                </a:solidFill>
                <a:latin typeface="Arial" pitchFamily="34" charset="0"/>
                <a:cs typeface="Arial" pitchFamily="34" charset="0"/>
              </a:rPr>
              <a:t>Neurogenesis	: </a:t>
            </a:r>
            <a:r>
              <a:rPr lang="en-US" sz="700" dirty="0">
                <a:solidFill>
                  <a:srgbClr val="009900"/>
                </a:solidFill>
                <a:latin typeface="Arial" pitchFamily="34" charset="0"/>
                <a:cs typeface="Arial" pitchFamily="34" charset="0"/>
              </a:rPr>
              <a:t>419  Axonogenesis 	</a:t>
            </a:r>
            <a:r>
              <a:rPr lang="en-US" sz="700" dirty="0" smtClean="0">
                <a:solidFill>
                  <a:srgbClr val="009900"/>
                </a:solidFill>
                <a:latin typeface="Arial" pitchFamily="34" charset="0"/>
                <a:cs typeface="Arial" pitchFamily="34" charset="0"/>
              </a:rPr>
              <a:t>        : </a:t>
            </a:r>
            <a:r>
              <a:rPr lang="en-US" sz="700" dirty="0">
                <a:solidFill>
                  <a:srgbClr val="009900"/>
                </a:solidFill>
                <a:latin typeface="Arial" pitchFamily="34" charset="0"/>
                <a:cs typeface="Arial" pitchFamily="34" charset="0"/>
              </a:rPr>
              <a:t>139</a:t>
            </a:r>
          </a:p>
          <a:p>
            <a:r>
              <a:rPr lang="en-US" sz="700" dirty="0" smtClean="0">
                <a:solidFill>
                  <a:srgbClr val="009900"/>
                </a:solidFill>
                <a:latin typeface="Arial" pitchFamily="34" charset="0"/>
                <a:cs typeface="Arial" pitchFamily="34" charset="0"/>
              </a:rPr>
              <a:t>NC differentiation 	: </a:t>
            </a:r>
            <a:r>
              <a:rPr lang="en-US" sz="700" dirty="0">
                <a:solidFill>
                  <a:srgbClr val="009900"/>
                </a:solidFill>
                <a:latin typeface="Arial" pitchFamily="34" charset="0"/>
                <a:cs typeface="Arial" pitchFamily="34" charset="0"/>
              </a:rPr>
              <a:t>31    Neural tube formation </a:t>
            </a:r>
            <a:r>
              <a:rPr lang="en-US" sz="700" dirty="0" smtClean="0">
                <a:solidFill>
                  <a:srgbClr val="009900"/>
                </a:solidFill>
                <a:latin typeface="Arial" pitchFamily="34" charset="0"/>
                <a:cs typeface="Arial" pitchFamily="34" charset="0"/>
              </a:rPr>
              <a:t>:   31</a:t>
            </a:r>
            <a:endParaRPr lang="en-US" sz="700" dirty="0">
              <a:solidFill>
                <a:srgbClr val="009900"/>
              </a:solidFill>
              <a:latin typeface="Arial" pitchFamily="34" charset="0"/>
              <a:cs typeface="Arial" pitchFamily="34" charset="0"/>
            </a:endParaRPr>
          </a:p>
          <a:p>
            <a:r>
              <a:rPr lang="en-US" sz="700" dirty="0" smtClean="0">
                <a:solidFill>
                  <a:srgbClr val="009900"/>
                </a:solidFill>
                <a:latin typeface="Arial" pitchFamily="34" charset="0"/>
                <a:cs typeface="Arial" pitchFamily="34" charset="0"/>
              </a:rPr>
              <a:t>Sensory organ dev. 	: </a:t>
            </a:r>
            <a:r>
              <a:rPr lang="en-US" sz="700" dirty="0">
                <a:solidFill>
                  <a:srgbClr val="009900"/>
                </a:solidFill>
                <a:latin typeface="Arial" pitchFamily="34" charset="0"/>
                <a:cs typeface="Arial" pitchFamily="34" charset="0"/>
              </a:rPr>
              <a:t>147   Telencephalon dev</a:t>
            </a:r>
            <a:r>
              <a:rPr lang="en-US" sz="700" dirty="0" smtClean="0">
                <a:solidFill>
                  <a:srgbClr val="009900"/>
                </a:solidFill>
                <a:latin typeface="Arial" pitchFamily="34" charset="0"/>
                <a:cs typeface="Arial" pitchFamily="34" charset="0"/>
              </a:rPr>
              <a:t>.   :   81</a:t>
            </a:r>
            <a:endParaRPr lang="en-US" sz="700" dirty="0">
              <a:solidFill>
                <a:srgbClr val="009900"/>
              </a:solidFill>
              <a:latin typeface="Arial" pitchFamily="34" charset="0"/>
              <a:cs typeface="Arial" pitchFamily="34" charset="0"/>
            </a:endParaRPr>
          </a:p>
        </p:txBody>
      </p:sp>
      <p:sp>
        <p:nvSpPr>
          <p:cNvPr id="147" name="Textfeld 57"/>
          <p:cNvSpPr txBox="1"/>
          <p:nvPr/>
        </p:nvSpPr>
        <p:spPr>
          <a:xfrm>
            <a:off x="647700" y="131058"/>
            <a:ext cx="2400300" cy="630942"/>
          </a:xfrm>
          <a:prstGeom prst="rect">
            <a:avLst/>
          </a:prstGeom>
          <a:noFill/>
        </p:spPr>
        <p:txBody>
          <a:bodyPr wrap="square" rtlCol="0">
            <a:spAutoFit/>
          </a:bodyPr>
          <a:lstStyle/>
          <a:p>
            <a:r>
              <a:rPr lang="en-US" sz="700" dirty="0" smtClean="0">
                <a:solidFill>
                  <a:srgbClr val="009900"/>
                </a:solidFill>
                <a:latin typeface="Arial" pitchFamily="34" charset="0"/>
                <a:cs typeface="Arial" pitchFamily="34" charset="0"/>
              </a:rPr>
              <a:t>T-genes : see bars (B,D;F); O-genes</a:t>
            </a:r>
            <a:r>
              <a:rPr lang="en-US" sz="700" dirty="0">
                <a:solidFill>
                  <a:srgbClr val="009900"/>
                </a:solidFill>
                <a:latin typeface="Arial" pitchFamily="34" charset="0"/>
                <a:cs typeface="Arial" pitchFamily="34" charset="0"/>
              </a:rPr>
              <a:t>: see bars (A;C,E) </a:t>
            </a:r>
          </a:p>
          <a:p>
            <a:r>
              <a:rPr lang="en-US" sz="700" dirty="0" smtClean="0">
                <a:solidFill>
                  <a:srgbClr val="009900"/>
                </a:solidFill>
                <a:latin typeface="Arial" pitchFamily="34" charset="0"/>
                <a:cs typeface="Arial" pitchFamily="34" charset="0"/>
              </a:rPr>
              <a:t>D-genes: for specific developments in UKK as follows : </a:t>
            </a:r>
          </a:p>
          <a:p>
            <a:r>
              <a:rPr lang="en-US" sz="700" dirty="0" smtClean="0">
                <a:solidFill>
                  <a:srgbClr val="009900"/>
                </a:solidFill>
                <a:latin typeface="Arial" pitchFamily="34" charset="0"/>
                <a:cs typeface="Arial" pitchFamily="34" charset="0"/>
              </a:rPr>
              <a:t>Nervous syst. dev.	: 689     Heart dev. : 130</a:t>
            </a:r>
          </a:p>
          <a:p>
            <a:r>
              <a:rPr lang="en-US" sz="700" dirty="0" smtClean="0">
                <a:solidFill>
                  <a:srgbClr val="009900"/>
                </a:solidFill>
                <a:latin typeface="Arial" pitchFamily="34" charset="0"/>
                <a:cs typeface="Arial" pitchFamily="34" charset="0"/>
              </a:rPr>
              <a:t>Sensory organ dev. 	: 144     Skin dev.   :   27</a:t>
            </a:r>
          </a:p>
          <a:p>
            <a:r>
              <a:rPr lang="en-US" sz="700" dirty="0" smtClean="0">
                <a:solidFill>
                  <a:srgbClr val="009900"/>
                </a:solidFill>
                <a:latin typeface="Arial" pitchFamily="34" charset="0"/>
                <a:cs typeface="Arial" pitchFamily="34" charset="0"/>
              </a:rPr>
              <a:t>Limb dev. 	: 94       Liver dev.  :   40</a:t>
            </a:r>
          </a:p>
        </p:txBody>
      </p:sp>
      <p:graphicFrame>
        <p:nvGraphicFramePr>
          <p:cNvPr id="4" name="Table 3"/>
          <p:cNvGraphicFramePr>
            <a:graphicFrameLocks noGrp="1"/>
          </p:cNvGraphicFramePr>
          <p:nvPr>
            <p:extLst>
              <p:ext uri="{D42A27DB-BD31-4B8C-83A1-F6EECF244321}">
                <p14:modId xmlns:p14="http://schemas.microsoft.com/office/powerpoint/2010/main" val="1891215179"/>
              </p:ext>
            </p:extLst>
          </p:nvPr>
        </p:nvGraphicFramePr>
        <p:xfrm>
          <a:off x="4953000" y="609600"/>
          <a:ext cx="1470660" cy="396000"/>
        </p:xfrm>
        <a:graphic>
          <a:graphicData uri="http://schemas.openxmlformats.org/drawingml/2006/table">
            <a:tbl>
              <a:tblPr/>
              <a:tblGrid>
                <a:gridCol w="855387"/>
                <a:gridCol w="615273"/>
              </a:tblGrid>
              <a:tr h="396000">
                <a:tc>
                  <a:txBody>
                    <a:bodyPr/>
                    <a:lstStyle/>
                    <a:p>
                      <a:pPr algn="l" fontAlgn="ctr"/>
                      <a:r>
                        <a:rPr lang="en-GB" sz="700" b="0" i="0" u="none" strike="noStrike" dirty="0" smtClean="0">
                          <a:solidFill>
                            <a:srgbClr val="009900"/>
                          </a:solidFill>
                          <a:latin typeface="Arial"/>
                        </a:rPr>
                        <a:t>Fisher's exact test</a:t>
                      </a:r>
                      <a:endParaRPr lang="en-GB" sz="700" b="0" i="0" u="none" strike="noStrike" dirty="0">
                        <a:solidFill>
                          <a:srgbClr val="009900"/>
                        </a:solidFill>
                        <a:latin typeface="Arial"/>
                      </a:endParaRPr>
                    </a:p>
                  </a:txBody>
                  <a:tcPr marL="18000" marR="18000" marT="18000" marB="1800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700" b="0" i="0" u="none" strike="noStrike" dirty="0" smtClean="0">
                          <a:solidFill>
                            <a:srgbClr val="009900"/>
                          </a:solidFill>
                          <a:latin typeface="Arial"/>
                        </a:rPr>
                        <a:t>*&lt;0.05</a:t>
                      </a:r>
                    </a:p>
                    <a:p>
                      <a:pPr algn="ctr" fontAlgn="ctr"/>
                      <a:r>
                        <a:rPr lang="en-GB" sz="700" b="0" i="0" u="none" strike="noStrike" dirty="0" smtClean="0">
                          <a:solidFill>
                            <a:srgbClr val="009900"/>
                          </a:solidFill>
                          <a:latin typeface="Arial"/>
                        </a:rPr>
                        <a:t>**&lt;0.01</a:t>
                      </a:r>
                    </a:p>
                    <a:p>
                      <a:pPr algn="ctr" fontAlgn="ctr"/>
                      <a:r>
                        <a:rPr lang="en-GB" sz="700" b="0" i="0" u="none" strike="noStrike" dirty="0" smtClean="0">
                          <a:solidFill>
                            <a:srgbClr val="009900"/>
                          </a:solidFill>
                          <a:latin typeface="Arial"/>
                        </a:rPr>
                        <a:t>***&lt;0.001</a:t>
                      </a:r>
                      <a:endParaRPr lang="en-GB" sz="700" b="0" i="0" u="none" strike="noStrike" dirty="0">
                        <a:solidFill>
                          <a:srgbClr val="009900"/>
                        </a:solidFill>
                        <a:latin typeface="Arial"/>
                      </a:endParaRPr>
                    </a:p>
                  </a:txBody>
                  <a:tcPr marL="18000" marR="18000" marT="18000" marB="1800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bl>
          </a:graphicData>
        </a:graphic>
      </p:graphicFrame>
      <p:sp>
        <p:nvSpPr>
          <p:cNvPr id="3" name="Rectangle 2"/>
          <p:cNvSpPr/>
          <p:nvPr/>
        </p:nvSpPr>
        <p:spPr>
          <a:xfrm>
            <a:off x="142875" y="7318680"/>
            <a:ext cx="6410325" cy="1825319"/>
          </a:xfrm>
          <a:prstGeom prst="rect">
            <a:avLst/>
          </a:prstGeom>
        </p:spPr>
        <p:txBody>
          <a:bodyPr wrap="square">
            <a:spAutoFit/>
          </a:bodyPr>
          <a:lstStyle/>
          <a:p>
            <a:pPr algn="just"/>
            <a:r>
              <a:rPr lang="en-GB" sz="1100" b="1" dirty="0">
                <a:latin typeface="Arial" panose="020B0604020202020204" pitchFamily="34" charset="0"/>
                <a:cs typeface="Arial" panose="020B0604020202020204" pitchFamily="34" charset="0"/>
              </a:rPr>
              <a:t>Supplementary Figure S6.</a:t>
            </a:r>
            <a:r>
              <a:rPr lang="en-GB" sz="1100" dirty="0">
                <a:latin typeface="Arial" panose="020B0604020202020204" pitchFamily="34" charset="0"/>
                <a:cs typeface="Arial" panose="020B0604020202020204" pitchFamily="34" charset="0"/>
              </a:rPr>
              <a:t> Characterization of toxicants based on developmental index and potency as a measure for specific developmental toxicity. The list of specific developmental PSs belonging to gene ontology categories (nervous system development, sensory organ, limb, heart, skin and liver development in the UKK test system; neurogenesis, neural tube formation, </a:t>
            </a:r>
            <a:r>
              <a:rPr lang="en-GB" sz="1100" dirty="0" err="1">
                <a:latin typeface="Arial" panose="020B0604020202020204" pitchFamily="34" charset="0"/>
                <a:cs typeface="Arial" panose="020B0604020202020204" pitchFamily="34" charset="0"/>
              </a:rPr>
              <a:t>axonogenesis</a:t>
            </a:r>
            <a:r>
              <a:rPr lang="en-GB" sz="1100" dirty="0">
                <a:latin typeface="Arial" panose="020B0604020202020204" pitchFamily="34" charset="0"/>
                <a:cs typeface="Arial" panose="020B0604020202020204" pitchFamily="34" charset="0"/>
              </a:rPr>
              <a:t>, neural crest cell differentiation, telencephalon and sensory organ development in the UKN1 test system) was obtained by uploading developmental genes into the online tool `DAVID´. The developmental potency (</a:t>
            </a:r>
            <a:r>
              <a:rPr lang="en-GB" sz="1100" i="1" dirty="0" err="1">
                <a:latin typeface="Arial" panose="020B0604020202020204" pitchFamily="34" charset="0"/>
                <a:cs typeface="Arial" panose="020B0604020202020204" pitchFamily="34" charset="0"/>
              </a:rPr>
              <a:t>D</a:t>
            </a:r>
            <a:r>
              <a:rPr lang="en-GB" sz="1100" i="1" baseline="-25000" dirty="0" err="1">
                <a:latin typeface="Arial" panose="020B0604020202020204" pitchFamily="34" charset="0"/>
                <a:cs typeface="Arial" panose="020B0604020202020204" pitchFamily="34" charset="0"/>
              </a:rPr>
              <a:t>p</a:t>
            </a:r>
            <a:r>
              <a:rPr lang="en-GB" sz="1100" dirty="0">
                <a:latin typeface="Arial" panose="020B0604020202020204" pitchFamily="34" charset="0"/>
                <a:cs typeface="Arial" panose="020B0604020202020204" pitchFamily="34" charset="0"/>
              </a:rPr>
              <a:t>) and developmental index (</a:t>
            </a:r>
            <a:r>
              <a:rPr lang="en-GB" sz="1100" i="1" dirty="0">
                <a:latin typeface="Arial" panose="020B0604020202020204" pitchFamily="34" charset="0"/>
                <a:cs typeface="Arial" panose="020B0604020202020204" pitchFamily="34" charset="0"/>
              </a:rPr>
              <a:t>D</a:t>
            </a:r>
            <a:r>
              <a:rPr lang="en-GB" sz="1100" i="1" baseline="-25000" dirty="0">
                <a:latin typeface="Arial" panose="020B0604020202020204" pitchFamily="34" charset="0"/>
                <a:cs typeface="Arial" panose="020B0604020202020204" pitchFamily="34" charset="0"/>
              </a:rPr>
              <a:t>i</a:t>
            </a:r>
            <a:r>
              <a:rPr lang="en-GB" sz="1100" dirty="0">
                <a:latin typeface="Arial" panose="020B0604020202020204" pitchFamily="34" charset="0"/>
                <a:cs typeface="Arial" panose="020B0604020202020204" pitchFamily="34" charset="0"/>
              </a:rPr>
              <a:t>) values were obtained as per the formula in Fig. 7A. (</a:t>
            </a:r>
            <a:r>
              <a:rPr lang="en-GB" sz="1100" b="1" dirty="0">
                <a:latin typeface="Arial" panose="020B0604020202020204" pitchFamily="34" charset="0"/>
                <a:cs typeface="Arial" panose="020B0604020202020204" pitchFamily="34" charset="0"/>
              </a:rPr>
              <a:t>A, B</a:t>
            </a:r>
            <a:r>
              <a:rPr lang="en-GB" sz="1100" dirty="0">
                <a:latin typeface="Arial" panose="020B0604020202020204" pitchFamily="34" charset="0"/>
                <a:cs typeface="Arial" panose="020B0604020202020204" pitchFamily="34" charset="0"/>
              </a:rPr>
              <a:t>) </a:t>
            </a:r>
            <a:r>
              <a:rPr lang="en-GB" sz="1100" i="1" dirty="0" err="1">
                <a:latin typeface="Arial" panose="020B0604020202020204" pitchFamily="34" charset="0"/>
                <a:cs typeface="Arial" panose="020B0604020202020204" pitchFamily="34" charset="0"/>
              </a:rPr>
              <a:t>D</a:t>
            </a:r>
            <a:r>
              <a:rPr lang="en-GB" sz="1100" i="1" baseline="-25000" dirty="0" err="1">
                <a:latin typeface="Arial" panose="020B0604020202020204" pitchFamily="34" charset="0"/>
                <a:cs typeface="Arial" panose="020B0604020202020204" pitchFamily="34" charset="0"/>
              </a:rPr>
              <a:t>p</a:t>
            </a:r>
            <a:r>
              <a:rPr lang="en-GB" sz="1100" dirty="0">
                <a:latin typeface="Arial" panose="020B0604020202020204" pitchFamily="34" charset="0"/>
                <a:cs typeface="Arial" panose="020B0604020202020204" pitchFamily="34" charset="0"/>
              </a:rPr>
              <a:t> and </a:t>
            </a:r>
            <a:r>
              <a:rPr lang="en-GB" sz="1100" i="1" dirty="0">
                <a:latin typeface="Arial" panose="020B0604020202020204" pitchFamily="34" charset="0"/>
                <a:cs typeface="Arial" panose="020B0604020202020204" pitchFamily="34" charset="0"/>
              </a:rPr>
              <a:t>D</a:t>
            </a:r>
            <a:r>
              <a:rPr lang="en-GB" sz="1100" i="1" baseline="-25000" dirty="0">
                <a:latin typeface="Arial" panose="020B0604020202020204" pitchFamily="34" charset="0"/>
                <a:cs typeface="Arial" panose="020B0604020202020204" pitchFamily="34" charset="0"/>
              </a:rPr>
              <a:t>i</a:t>
            </a:r>
            <a:r>
              <a:rPr lang="en-GB" sz="1100" dirty="0">
                <a:latin typeface="Arial" panose="020B0604020202020204" pitchFamily="34" charset="0"/>
                <a:cs typeface="Arial" panose="020B0604020202020204" pitchFamily="34" charset="0"/>
              </a:rPr>
              <a:t> for thalidomide in the UKK test system. (</a:t>
            </a:r>
            <a:r>
              <a:rPr lang="en-GB" sz="1100" b="1" dirty="0">
                <a:latin typeface="Arial" panose="020B0604020202020204" pitchFamily="34" charset="0"/>
                <a:cs typeface="Arial" panose="020B0604020202020204" pitchFamily="34" charset="0"/>
              </a:rPr>
              <a:t>C, D</a:t>
            </a:r>
            <a:r>
              <a:rPr lang="en-GB" sz="1100" dirty="0">
                <a:latin typeface="Arial" panose="020B0604020202020204" pitchFamily="34" charset="0"/>
                <a:cs typeface="Arial" panose="020B0604020202020204" pitchFamily="34" charset="0"/>
              </a:rPr>
              <a:t>) </a:t>
            </a:r>
            <a:r>
              <a:rPr lang="en-GB" sz="1100" i="1" dirty="0" err="1">
                <a:latin typeface="Arial" panose="020B0604020202020204" pitchFamily="34" charset="0"/>
                <a:cs typeface="Arial" panose="020B0604020202020204" pitchFamily="34" charset="0"/>
              </a:rPr>
              <a:t>D</a:t>
            </a:r>
            <a:r>
              <a:rPr lang="en-GB" sz="1100" i="1" baseline="-25000" dirty="0" err="1">
                <a:latin typeface="Arial" panose="020B0604020202020204" pitchFamily="34" charset="0"/>
                <a:cs typeface="Arial" panose="020B0604020202020204" pitchFamily="34" charset="0"/>
              </a:rPr>
              <a:t>p</a:t>
            </a:r>
            <a:r>
              <a:rPr lang="en-GB" sz="1100" dirty="0">
                <a:latin typeface="Arial" panose="020B0604020202020204" pitchFamily="34" charset="0"/>
                <a:cs typeface="Arial" panose="020B0604020202020204" pitchFamily="34" charset="0"/>
              </a:rPr>
              <a:t> and </a:t>
            </a:r>
            <a:r>
              <a:rPr lang="en-GB" sz="1100" i="1" dirty="0">
                <a:latin typeface="Arial" panose="020B0604020202020204" pitchFamily="34" charset="0"/>
                <a:cs typeface="Arial" panose="020B0604020202020204" pitchFamily="34" charset="0"/>
              </a:rPr>
              <a:t>D</a:t>
            </a:r>
            <a:r>
              <a:rPr lang="en-GB" sz="1100" i="1" baseline="-25000" dirty="0">
                <a:latin typeface="Arial" panose="020B0604020202020204" pitchFamily="34" charset="0"/>
                <a:cs typeface="Arial" panose="020B0604020202020204" pitchFamily="34" charset="0"/>
              </a:rPr>
              <a:t>i</a:t>
            </a:r>
            <a:r>
              <a:rPr lang="en-GB" sz="1100" dirty="0">
                <a:latin typeface="Arial" panose="020B0604020202020204" pitchFamily="34" charset="0"/>
                <a:cs typeface="Arial" panose="020B0604020202020204" pitchFamily="34" charset="0"/>
              </a:rPr>
              <a:t> for </a:t>
            </a:r>
            <a:r>
              <a:rPr lang="en-GB" sz="1100" dirty="0" err="1">
                <a:latin typeface="Arial" panose="020B0604020202020204" pitchFamily="34" charset="0"/>
                <a:cs typeface="Arial" panose="020B0604020202020204" pitchFamily="34" charset="0"/>
              </a:rPr>
              <a:t>mercurials</a:t>
            </a:r>
            <a:r>
              <a:rPr lang="en-GB" sz="1100" dirty="0">
                <a:latin typeface="Arial" panose="020B0604020202020204" pitchFamily="34" charset="0"/>
                <a:cs typeface="Arial" panose="020B0604020202020204" pitchFamily="34" charset="0"/>
              </a:rPr>
              <a:t> and </a:t>
            </a:r>
            <a:r>
              <a:rPr lang="en-GB" sz="1100" dirty="0" err="1">
                <a:latin typeface="Arial" panose="020B0604020202020204" pitchFamily="34" charset="0"/>
                <a:cs typeface="Arial" panose="020B0604020202020204" pitchFamily="34" charset="0"/>
              </a:rPr>
              <a:t>HDACis</a:t>
            </a:r>
            <a:r>
              <a:rPr lang="en-GB" sz="1100" dirty="0">
                <a:latin typeface="Arial" panose="020B0604020202020204" pitchFamily="34" charset="0"/>
                <a:cs typeface="Arial" panose="020B0604020202020204" pitchFamily="34" charset="0"/>
              </a:rPr>
              <a:t> in the UKK test system. (</a:t>
            </a:r>
            <a:r>
              <a:rPr lang="en-GB" sz="1100" b="1" dirty="0">
                <a:latin typeface="Arial" panose="020B0604020202020204" pitchFamily="34" charset="0"/>
                <a:cs typeface="Arial" panose="020B0604020202020204" pitchFamily="34" charset="0"/>
              </a:rPr>
              <a:t>E, F</a:t>
            </a:r>
            <a:r>
              <a:rPr lang="en-GB" sz="1100" dirty="0">
                <a:latin typeface="Arial" panose="020B0604020202020204" pitchFamily="34" charset="0"/>
                <a:cs typeface="Arial" panose="020B0604020202020204" pitchFamily="34" charset="0"/>
              </a:rPr>
              <a:t>) </a:t>
            </a:r>
            <a:r>
              <a:rPr lang="en-GB" sz="1100" i="1" dirty="0" err="1">
                <a:latin typeface="Arial" panose="020B0604020202020204" pitchFamily="34" charset="0"/>
                <a:cs typeface="Arial" panose="020B0604020202020204" pitchFamily="34" charset="0"/>
              </a:rPr>
              <a:t>D</a:t>
            </a:r>
            <a:r>
              <a:rPr lang="en-GB" sz="1100" i="1" baseline="-25000" dirty="0" err="1">
                <a:latin typeface="Arial" panose="020B0604020202020204" pitchFamily="34" charset="0"/>
                <a:cs typeface="Arial" panose="020B0604020202020204" pitchFamily="34" charset="0"/>
              </a:rPr>
              <a:t>p</a:t>
            </a:r>
            <a:r>
              <a:rPr lang="en-GB" sz="1100" dirty="0">
                <a:latin typeface="Arial" panose="020B0604020202020204" pitchFamily="34" charset="0"/>
                <a:cs typeface="Arial" panose="020B0604020202020204" pitchFamily="34" charset="0"/>
              </a:rPr>
              <a:t> and </a:t>
            </a:r>
            <a:r>
              <a:rPr lang="en-GB" sz="1100" i="1" dirty="0">
                <a:latin typeface="Arial" panose="020B0604020202020204" pitchFamily="34" charset="0"/>
                <a:cs typeface="Arial" panose="020B0604020202020204" pitchFamily="34" charset="0"/>
              </a:rPr>
              <a:t>D</a:t>
            </a:r>
            <a:r>
              <a:rPr lang="en-GB" sz="1100" i="1" baseline="-25000" dirty="0">
                <a:latin typeface="Arial" panose="020B0604020202020204" pitchFamily="34" charset="0"/>
                <a:cs typeface="Arial" panose="020B0604020202020204" pitchFamily="34" charset="0"/>
              </a:rPr>
              <a:t>i</a:t>
            </a:r>
            <a:r>
              <a:rPr lang="en-GB" sz="1100" dirty="0">
                <a:latin typeface="Arial" panose="020B0604020202020204" pitchFamily="34" charset="0"/>
                <a:cs typeface="Arial" panose="020B0604020202020204" pitchFamily="34" charset="0"/>
              </a:rPr>
              <a:t> for </a:t>
            </a:r>
            <a:r>
              <a:rPr lang="en-GB" sz="1100" dirty="0" err="1">
                <a:latin typeface="Arial" panose="020B0604020202020204" pitchFamily="34" charset="0"/>
                <a:cs typeface="Arial" panose="020B0604020202020204" pitchFamily="34" charset="0"/>
              </a:rPr>
              <a:t>mercurials</a:t>
            </a:r>
            <a:r>
              <a:rPr lang="en-GB" sz="1100" dirty="0">
                <a:latin typeface="Arial" panose="020B0604020202020204" pitchFamily="34" charset="0"/>
                <a:cs typeface="Arial" panose="020B0604020202020204" pitchFamily="34" charset="0"/>
              </a:rPr>
              <a:t> and </a:t>
            </a:r>
            <a:r>
              <a:rPr lang="en-GB" sz="1100" dirty="0" err="1">
                <a:latin typeface="Arial" panose="020B0604020202020204" pitchFamily="34" charset="0"/>
                <a:cs typeface="Arial" panose="020B0604020202020204" pitchFamily="34" charset="0"/>
              </a:rPr>
              <a:t>HDACis</a:t>
            </a:r>
            <a:r>
              <a:rPr lang="en-GB" sz="1100" dirty="0">
                <a:latin typeface="Arial" panose="020B0604020202020204" pitchFamily="34" charset="0"/>
                <a:cs typeface="Arial" panose="020B0604020202020204" pitchFamily="34" charset="0"/>
              </a:rPr>
              <a:t> in the UKN1 test system. </a:t>
            </a:r>
            <a:endParaRPr lang="en-US" sz="1100" dirty="0">
              <a:latin typeface="Arial" panose="020B0604020202020204" pitchFamily="34" charset="0"/>
              <a:cs typeface="Arial" panose="020B0604020202020204" pitchFamily="34" charset="0"/>
            </a:endParaRPr>
          </a:p>
        </p:txBody>
      </p:sp>
      <p:sp>
        <p:nvSpPr>
          <p:cNvPr id="10" name="TextBox 9"/>
          <p:cNvSpPr txBox="1"/>
          <p:nvPr/>
        </p:nvSpPr>
        <p:spPr>
          <a:xfrm>
            <a:off x="3352800" y="685800"/>
            <a:ext cx="381000" cy="307777"/>
          </a:xfrm>
          <a:prstGeom prst="rect">
            <a:avLst/>
          </a:prstGeom>
          <a:noFill/>
        </p:spPr>
        <p:txBody>
          <a:bodyPr wrap="square" rtlCol="0">
            <a:spAutoFit/>
          </a:bodyPr>
          <a:lstStyle/>
          <a:p>
            <a:r>
              <a:rPr lang="en-US" sz="1400" dirty="0" smtClean="0">
                <a:latin typeface="Arial" panose="020B0604020202020204" pitchFamily="34" charset="0"/>
                <a:cs typeface="Arial" panose="020B0604020202020204" pitchFamily="34" charset="0"/>
              </a:rPr>
              <a:t>B</a:t>
            </a:r>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60289061"/>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nummernplatzhalter 1"/>
          <p:cNvSpPr>
            <a:spLocks noGrp="1"/>
          </p:cNvSpPr>
          <p:nvPr>
            <p:ph type="sldNum" sz="quarter" idx="12"/>
          </p:nvPr>
        </p:nvSpPr>
        <p:spPr>
          <a:xfrm>
            <a:off x="5105400" y="8686800"/>
            <a:ext cx="1600200" cy="486833"/>
          </a:xfrm>
        </p:spPr>
        <p:txBody>
          <a:bodyPr/>
          <a:lstStyle/>
          <a:p>
            <a:fld id="{1ACA62C2-8D3F-439D-94AC-C26847FF0122}" type="slidenum">
              <a:rPr lang="en-US" smtClean="0"/>
              <a:pPr/>
              <a:t>7</a:t>
            </a:fld>
            <a:endParaRPr lang="en-US" dirty="0"/>
          </a:p>
        </p:txBody>
      </p:sp>
      <p:sp>
        <p:nvSpPr>
          <p:cNvPr id="31" name="Rechteck 30"/>
          <p:cNvSpPr/>
          <p:nvPr/>
        </p:nvSpPr>
        <p:spPr>
          <a:xfrm>
            <a:off x="508431" y="4671600"/>
            <a:ext cx="457200" cy="2286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p:cNvSpPr/>
          <p:nvPr/>
        </p:nvSpPr>
        <p:spPr>
          <a:xfrm>
            <a:off x="4495800" y="5454402"/>
            <a:ext cx="2133600" cy="3308598"/>
          </a:xfrm>
          <a:prstGeom prst="rect">
            <a:avLst/>
          </a:prstGeom>
        </p:spPr>
        <p:txBody>
          <a:bodyPr wrap="square">
            <a:spAutoFit/>
          </a:bodyPr>
          <a:lstStyle/>
          <a:p>
            <a:pPr algn="just"/>
            <a:r>
              <a:rPr lang="en-GB" sz="1100" b="1" dirty="0">
                <a:latin typeface="Arial" panose="020B0604020202020204" pitchFamily="34" charset="0"/>
                <a:cs typeface="Arial" panose="020B0604020202020204" pitchFamily="34" charset="0"/>
              </a:rPr>
              <a:t>Supplementary Figure S7.</a:t>
            </a:r>
            <a:r>
              <a:rPr lang="en-GB" sz="1100" dirty="0">
                <a:latin typeface="Arial" panose="020B0604020202020204" pitchFamily="34" charset="0"/>
                <a:cs typeface="Arial" panose="020B0604020202020204" pitchFamily="34" charset="0"/>
              </a:rPr>
              <a:t> TF networks in the UKK and UKN1 systems. Human stem cells were differentiated and treated as shown in Fig. 1A, and toxicant consensus genes were identified from the transcriptome data as described in Fig. 4. Then, a generic human TF network was designed as described in Fig. 5C. The TFs that are found both amongst UKK (top) and UKN1 (bottom) D-genes (regulated by ≥ ±5-fold, p &lt;0.05) were selected and highlighted in the TF networks (red: up-regulation; blue: down-regulation).</a:t>
            </a:r>
            <a:endParaRPr lang="en-US" sz="1100" b="1" dirty="0">
              <a:latin typeface="Arial" panose="020B0604020202020204" pitchFamily="34" charset="0"/>
              <a:cs typeface="Arial" panose="020B0604020202020204" pitchFamily="34" charset="0"/>
            </a:endParaRPr>
          </a:p>
        </p:txBody>
      </p:sp>
      <p:grpSp>
        <p:nvGrpSpPr>
          <p:cNvPr id="37" name="Gruppieren 28"/>
          <p:cNvGrpSpPr/>
          <p:nvPr/>
        </p:nvGrpSpPr>
        <p:grpSpPr>
          <a:xfrm>
            <a:off x="838200" y="99600"/>
            <a:ext cx="4744270" cy="4320000"/>
            <a:chOff x="990600" y="228600"/>
            <a:chExt cx="4744270" cy="4320000"/>
          </a:xfrm>
        </p:grpSpPr>
        <p:pic>
          <p:nvPicPr>
            <p:cNvPr id="38" name="Grafik 2"/>
            <p:cNvPicPr>
              <a:picLocks noChangeAspect="1"/>
            </p:cNvPicPr>
            <p:nvPr/>
          </p:nvPicPr>
          <p:blipFill>
            <a:blip r:embed="rId2"/>
            <a:stretch>
              <a:fillRect/>
            </a:stretch>
          </p:blipFill>
          <p:spPr>
            <a:xfrm>
              <a:off x="1214565" y="228600"/>
              <a:ext cx="4520305" cy="4320000"/>
            </a:xfrm>
            <a:prstGeom prst="rect">
              <a:avLst/>
            </a:prstGeom>
          </p:spPr>
        </p:pic>
        <p:sp>
          <p:nvSpPr>
            <p:cNvPr id="39" name="Ellipse 8"/>
            <p:cNvSpPr/>
            <p:nvPr/>
          </p:nvSpPr>
          <p:spPr>
            <a:xfrm>
              <a:off x="1367237" y="1781034"/>
              <a:ext cx="448014" cy="1087449"/>
            </a:xfrm>
            <a:custGeom>
              <a:avLst/>
              <a:gdLst>
                <a:gd name="connsiteX0" fmla="*/ 0 w 533400"/>
                <a:gd name="connsiteY0" fmla="*/ 495300 h 990600"/>
                <a:gd name="connsiteX1" fmla="*/ 266700 w 533400"/>
                <a:gd name="connsiteY1" fmla="*/ 0 h 990600"/>
                <a:gd name="connsiteX2" fmla="*/ 533400 w 533400"/>
                <a:gd name="connsiteY2" fmla="*/ 495300 h 990600"/>
                <a:gd name="connsiteX3" fmla="*/ 266700 w 533400"/>
                <a:gd name="connsiteY3" fmla="*/ 990600 h 990600"/>
                <a:gd name="connsiteX4" fmla="*/ 0 w 533400"/>
                <a:gd name="connsiteY4" fmla="*/ 495300 h 990600"/>
                <a:gd name="connsiteX0" fmla="*/ 12658 w 546058"/>
                <a:gd name="connsiteY0" fmla="*/ 540687 h 1035987"/>
                <a:gd name="connsiteX1" fmla="*/ 67143 w 546058"/>
                <a:gd name="connsiteY1" fmla="*/ 78552 h 1035987"/>
                <a:gd name="connsiteX2" fmla="*/ 279358 w 546058"/>
                <a:gd name="connsiteY2" fmla="*/ 45387 h 1035987"/>
                <a:gd name="connsiteX3" fmla="*/ 546058 w 546058"/>
                <a:gd name="connsiteY3" fmla="*/ 540687 h 1035987"/>
                <a:gd name="connsiteX4" fmla="*/ 279358 w 546058"/>
                <a:gd name="connsiteY4" fmla="*/ 1035987 h 1035987"/>
                <a:gd name="connsiteX5" fmla="*/ 12658 w 546058"/>
                <a:gd name="connsiteY5" fmla="*/ 540687 h 1035987"/>
                <a:gd name="connsiteX0" fmla="*/ 4363 w 537763"/>
                <a:gd name="connsiteY0" fmla="*/ 540687 h 1087741"/>
                <a:gd name="connsiteX1" fmla="*/ 58848 w 537763"/>
                <a:gd name="connsiteY1" fmla="*/ 78552 h 1087741"/>
                <a:gd name="connsiteX2" fmla="*/ 271063 w 537763"/>
                <a:gd name="connsiteY2" fmla="*/ 45387 h 1087741"/>
                <a:gd name="connsiteX3" fmla="*/ 537763 w 537763"/>
                <a:gd name="connsiteY3" fmla="*/ 540687 h 1087741"/>
                <a:gd name="connsiteX4" fmla="*/ 271063 w 537763"/>
                <a:gd name="connsiteY4" fmla="*/ 1035987 h 1087741"/>
                <a:gd name="connsiteX5" fmla="*/ 148867 w 537763"/>
                <a:gd name="connsiteY5" fmla="*/ 1016642 h 1087741"/>
                <a:gd name="connsiteX6" fmla="*/ 4363 w 537763"/>
                <a:gd name="connsiteY6" fmla="*/ 540687 h 1087741"/>
                <a:gd name="connsiteX0" fmla="*/ 4363 w 447744"/>
                <a:gd name="connsiteY0" fmla="*/ 543064 h 1087858"/>
                <a:gd name="connsiteX1" fmla="*/ 58848 w 447744"/>
                <a:gd name="connsiteY1" fmla="*/ 80929 h 1087858"/>
                <a:gd name="connsiteX2" fmla="*/ 271063 w 447744"/>
                <a:gd name="connsiteY2" fmla="*/ 47764 h 1087858"/>
                <a:gd name="connsiteX3" fmla="*/ 447744 w 447744"/>
                <a:gd name="connsiteY3" fmla="*/ 576228 h 1087858"/>
                <a:gd name="connsiteX4" fmla="*/ 271063 w 447744"/>
                <a:gd name="connsiteY4" fmla="*/ 1038364 h 1087858"/>
                <a:gd name="connsiteX5" fmla="*/ 148867 w 447744"/>
                <a:gd name="connsiteY5" fmla="*/ 1019019 h 1087858"/>
                <a:gd name="connsiteX6" fmla="*/ 4363 w 447744"/>
                <a:gd name="connsiteY6" fmla="*/ 543064 h 1087858"/>
                <a:gd name="connsiteX0" fmla="*/ 4363 w 448014"/>
                <a:gd name="connsiteY0" fmla="*/ 543064 h 1069417"/>
                <a:gd name="connsiteX1" fmla="*/ 58848 w 448014"/>
                <a:gd name="connsiteY1" fmla="*/ 80929 h 1069417"/>
                <a:gd name="connsiteX2" fmla="*/ 271063 w 448014"/>
                <a:gd name="connsiteY2" fmla="*/ 47764 h 1069417"/>
                <a:gd name="connsiteX3" fmla="*/ 447744 w 448014"/>
                <a:gd name="connsiteY3" fmla="*/ 576228 h 1069417"/>
                <a:gd name="connsiteX4" fmla="*/ 338380 w 448014"/>
                <a:gd name="connsiteY4" fmla="*/ 1033232 h 1069417"/>
                <a:gd name="connsiteX5" fmla="*/ 271063 w 448014"/>
                <a:gd name="connsiteY5" fmla="*/ 1038364 h 1069417"/>
                <a:gd name="connsiteX6" fmla="*/ 148867 w 448014"/>
                <a:gd name="connsiteY6" fmla="*/ 1019019 h 1069417"/>
                <a:gd name="connsiteX7" fmla="*/ 4363 w 448014"/>
                <a:gd name="connsiteY7" fmla="*/ 543064 h 1069417"/>
                <a:gd name="connsiteX0" fmla="*/ 4363 w 448014"/>
                <a:gd name="connsiteY0" fmla="*/ 543064 h 1087449"/>
                <a:gd name="connsiteX1" fmla="*/ 58848 w 448014"/>
                <a:gd name="connsiteY1" fmla="*/ 80929 h 1087449"/>
                <a:gd name="connsiteX2" fmla="*/ 271063 w 448014"/>
                <a:gd name="connsiteY2" fmla="*/ 47764 h 1087449"/>
                <a:gd name="connsiteX3" fmla="*/ 447744 w 448014"/>
                <a:gd name="connsiteY3" fmla="*/ 576228 h 1087449"/>
                <a:gd name="connsiteX4" fmla="*/ 338380 w 448014"/>
                <a:gd name="connsiteY4" fmla="*/ 1033232 h 1087449"/>
                <a:gd name="connsiteX5" fmla="*/ 271063 w 448014"/>
                <a:gd name="connsiteY5" fmla="*/ 1081004 h 1087449"/>
                <a:gd name="connsiteX6" fmla="*/ 148867 w 448014"/>
                <a:gd name="connsiteY6" fmla="*/ 1019019 h 1087449"/>
                <a:gd name="connsiteX7" fmla="*/ 4363 w 448014"/>
                <a:gd name="connsiteY7" fmla="*/ 543064 h 108744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448014" h="1087449">
                  <a:moveTo>
                    <a:pt x="4363" y="543064"/>
                  </a:moveTo>
                  <a:cubicBezTo>
                    <a:pt x="-10640" y="386716"/>
                    <a:pt x="14398" y="163479"/>
                    <a:pt x="58848" y="80929"/>
                  </a:cubicBezTo>
                  <a:cubicBezTo>
                    <a:pt x="103298" y="-1621"/>
                    <a:pt x="206247" y="-34786"/>
                    <a:pt x="271063" y="47764"/>
                  </a:cubicBezTo>
                  <a:cubicBezTo>
                    <a:pt x="335879" y="130314"/>
                    <a:pt x="442052" y="417511"/>
                    <a:pt x="447744" y="576228"/>
                  </a:cubicBezTo>
                  <a:cubicBezTo>
                    <a:pt x="453436" y="734945"/>
                    <a:pt x="367827" y="956209"/>
                    <a:pt x="338380" y="1033232"/>
                  </a:cubicBezTo>
                  <a:cubicBezTo>
                    <a:pt x="308933" y="1110255"/>
                    <a:pt x="302648" y="1083373"/>
                    <a:pt x="271063" y="1081004"/>
                  </a:cubicBezTo>
                  <a:cubicBezTo>
                    <a:pt x="239478" y="1078635"/>
                    <a:pt x="193317" y="1101569"/>
                    <a:pt x="148867" y="1019019"/>
                  </a:cubicBezTo>
                  <a:cubicBezTo>
                    <a:pt x="104417" y="936469"/>
                    <a:pt x="19366" y="699412"/>
                    <a:pt x="4363" y="543064"/>
                  </a:cubicBezTo>
                  <a:close/>
                </a:path>
              </a:pathLst>
            </a:cu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Ellipse 8"/>
            <p:cNvSpPr/>
            <p:nvPr/>
          </p:nvSpPr>
          <p:spPr>
            <a:xfrm>
              <a:off x="1823824" y="2848875"/>
              <a:ext cx="837635" cy="621747"/>
            </a:xfrm>
            <a:custGeom>
              <a:avLst/>
              <a:gdLst>
                <a:gd name="connsiteX0" fmla="*/ 0 w 533400"/>
                <a:gd name="connsiteY0" fmla="*/ 495300 h 990600"/>
                <a:gd name="connsiteX1" fmla="*/ 266700 w 533400"/>
                <a:gd name="connsiteY1" fmla="*/ 0 h 990600"/>
                <a:gd name="connsiteX2" fmla="*/ 533400 w 533400"/>
                <a:gd name="connsiteY2" fmla="*/ 495300 h 990600"/>
                <a:gd name="connsiteX3" fmla="*/ 266700 w 533400"/>
                <a:gd name="connsiteY3" fmla="*/ 990600 h 990600"/>
                <a:gd name="connsiteX4" fmla="*/ 0 w 533400"/>
                <a:gd name="connsiteY4" fmla="*/ 495300 h 990600"/>
                <a:gd name="connsiteX0" fmla="*/ 12658 w 546058"/>
                <a:gd name="connsiteY0" fmla="*/ 540687 h 1035987"/>
                <a:gd name="connsiteX1" fmla="*/ 67143 w 546058"/>
                <a:gd name="connsiteY1" fmla="*/ 78552 h 1035987"/>
                <a:gd name="connsiteX2" fmla="*/ 279358 w 546058"/>
                <a:gd name="connsiteY2" fmla="*/ 45387 h 1035987"/>
                <a:gd name="connsiteX3" fmla="*/ 546058 w 546058"/>
                <a:gd name="connsiteY3" fmla="*/ 540687 h 1035987"/>
                <a:gd name="connsiteX4" fmla="*/ 279358 w 546058"/>
                <a:gd name="connsiteY4" fmla="*/ 1035987 h 1035987"/>
                <a:gd name="connsiteX5" fmla="*/ 12658 w 546058"/>
                <a:gd name="connsiteY5" fmla="*/ 540687 h 1035987"/>
                <a:gd name="connsiteX0" fmla="*/ 4363 w 537763"/>
                <a:gd name="connsiteY0" fmla="*/ 540687 h 1087741"/>
                <a:gd name="connsiteX1" fmla="*/ 58848 w 537763"/>
                <a:gd name="connsiteY1" fmla="*/ 78552 h 1087741"/>
                <a:gd name="connsiteX2" fmla="*/ 271063 w 537763"/>
                <a:gd name="connsiteY2" fmla="*/ 45387 h 1087741"/>
                <a:gd name="connsiteX3" fmla="*/ 537763 w 537763"/>
                <a:gd name="connsiteY3" fmla="*/ 540687 h 1087741"/>
                <a:gd name="connsiteX4" fmla="*/ 271063 w 537763"/>
                <a:gd name="connsiteY4" fmla="*/ 1035987 h 1087741"/>
                <a:gd name="connsiteX5" fmla="*/ 148867 w 537763"/>
                <a:gd name="connsiteY5" fmla="*/ 1016642 h 1087741"/>
                <a:gd name="connsiteX6" fmla="*/ 4363 w 537763"/>
                <a:gd name="connsiteY6" fmla="*/ 540687 h 1087741"/>
                <a:gd name="connsiteX0" fmla="*/ 4363 w 447744"/>
                <a:gd name="connsiteY0" fmla="*/ 543064 h 1087858"/>
                <a:gd name="connsiteX1" fmla="*/ 58848 w 447744"/>
                <a:gd name="connsiteY1" fmla="*/ 80929 h 1087858"/>
                <a:gd name="connsiteX2" fmla="*/ 271063 w 447744"/>
                <a:gd name="connsiteY2" fmla="*/ 47764 h 1087858"/>
                <a:gd name="connsiteX3" fmla="*/ 447744 w 447744"/>
                <a:gd name="connsiteY3" fmla="*/ 576228 h 1087858"/>
                <a:gd name="connsiteX4" fmla="*/ 271063 w 447744"/>
                <a:gd name="connsiteY4" fmla="*/ 1038364 h 1087858"/>
                <a:gd name="connsiteX5" fmla="*/ 148867 w 447744"/>
                <a:gd name="connsiteY5" fmla="*/ 1019019 h 1087858"/>
                <a:gd name="connsiteX6" fmla="*/ 4363 w 447744"/>
                <a:gd name="connsiteY6" fmla="*/ 543064 h 1087858"/>
                <a:gd name="connsiteX0" fmla="*/ 4363 w 448014"/>
                <a:gd name="connsiteY0" fmla="*/ 543064 h 1069417"/>
                <a:gd name="connsiteX1" fmla="*/ 58848 w 448014"/>
                <a:gd name="connsiteY1" fmla="*/ 80929 h 1069417"/>
                <a:gd name="connsiteX2" fmla="*/ 271063 w 448014"/>
                <a:gd name="connsiteY2" fmla="*/ 47764 h 1069417"/>
                <a:gd name="connsiteX3" fmla="*/ 447744 w 448014"/>
                <a:gd name="connsiteY3" fmla="*/ 576228 h 1069417"/>
                <a:gd name="connsiteX4" fmla="*/ 338380 w 448014"/>
                <a:gd name="connsiteY4" fmla="*/ 1033232 h 1069417"/>
                <a:gd name="connsiteX5" fmla="*/ 271063 w 448014"/>
                <a:gd name="connsiteY5" fmla="*/ 1038364 h 1069417"/>
                <a:gd name="connsiteX6" fmla="*/ 148867 w 448014"/>
                <a:gd name="connsiteY6" fmla="*/ 1019019 h 1069417"/>
                <a:gd name="connsiteX7" fmla="*/ 4363 w 448014"/>
                <a:gd name="connsiteY7" fmla="*/ 543064 h 1069417"/>
                <a:gd name="connsiteX0" fmla="*/ 4363 w 448014"/>
                <a:gd name="connsiteY0" fmla="*/ 543064 h 1087449"/>
                <a:gd name="connsiteX1" fmla="*/ 58848 w 448014"/>
                <a:gd name="connsiteY1" fmla="*/ 80929 h 1087449"/>
                <a:gd name="connsiteX2" fmla="*/ 271063 w 448014"/>
                <a:gd name="connsiteY2" fmla="*/ 47764 h 1087449"/>
                <a:gd name="connsiteX3" fmla="*/ 447744 w 448014"/>
                <a:gd name="connsiteY3" fmla="*/ 576228 h 1087449"/>
                <a:gd name="connsiteX4" fmla="*/ 338380 w 448014"/>
                <a:gd name="connsiteY4" fmla="*/ 1033232 h 1087449"/>
                <a:gd name="connsiteX5" fmla="*/ 271063 w 448014"/>
                <a:gd name="connsiteY5" fmla="*/ 1081004 h 1087449"/>
                <a:gd name="connsiteX6" fmla="*/ 148867 w 448014"/>
                <a:gd name="connsiteY6" fmla="*/ 1019019 h 1087449"/>
                <a:gd name="connsiteX7" fmla="*/ 4363 w 448014"/>
                <a:gd name="connsiteY7" fmla="*/ 543064 h 1087449"/>
                <a:gd name="connsiteX0" fmla="*/ 390296 w 833947"/>
                <a:gd name="connsiteY0" fmla="*/ 539837 h 1084222"/>
                <a:gd name="connsiteX1" fmla="*/ 195 w 833947"/>
                <a:gd name="connsiteY1" fmla="*/ 380932 h 1084222"/>
                <a:gd name="connsiteX2" fmla="*/ 444781 w 833947"/>
                <a:gd name="connsiteY2" fmla="*/ 77702 h 1084222"/>
                <a:gd name="connsiteX3" fmla="*/ 656996 w 833947"/>
                <a:gd name="connsiteY3" fmla="*/ 44537 h 1084222"/>
                <a:gd name="connsiteX4" fmla="*/ 833677 w 833947"/>
                <a:gd name="connsiteY4" fmla="*/ 573001 h 1084222"/>
                <a:gd name="connsiteX5" fmla="*/ 724313 w 833947"/>
                <a:gd name="connsiteY5" fmla="*/ 1030005 h 1084222"/>
                <a:gd name="connsiteX6" fmla="*/ 656996 w 833947"/>
                <a:gd name="connsiteY6" fmla="*/ 1077777 h 1084222"/>
                <a:gd name="connsiteX7" fmla="*/ 534800 w 833947"/>
                <a:gd name="connsiteY7" fmla="*/ 1015792 h 1084222"/>
                <a:gd name="connsiteX8" fmla="*/ 390296 w 833947"/>
                <a:gd name="connsiteY8" fmla="*/ 539837 h 1084222"/>
                <a:gd name="connsiteX0" fmla="*/ 338217 w 833985"/>
                <a:gd name="connsiteY0" fmla="*/ 563526 h 1084222"/>
                <a:gd name="connsiteX1" fmla="*/ 233 w 833985"/>
                <a:gd name="connsiteY1" fmla="*/ 380932 h 1084222"/>
                <a:gd name="connsiteX2" fmla="*/ 444819 w 833985"/>
                <a:gd name="connsiteY2" fmla="*/ 77702 h 1084222"/>
                <a:gd name="connsiteX3" fmla="*/ 657034 w 833985"/>
                <a:gd name="connsiteY3" fmla="*/ 44537 h 1084222"/>
                <a:gd name="connsiteX4" fmla="*/ 833715 w 833985"/>
                <a:gd name="connsiteY4" fmla="*/ 573001 h 1084222"/>
                <a:gd name="connsiteX5" fmla="*/ 724351 w 833985"/>
                <a:gd name="connsiteY5" fmla="*/ 1030005 h 1084222"/>
                <a:gd name="connsiteX6" fmla="*/ 657034 w 833985"/>
                <a:gd name="connsiteY6" fmla="*/ 1077777 h 1084222"/>
                <a:gd name="connsiteX7" fmla="*/ 534838 w 833985"/>
                <a:gd name="connsiteY7" fmla="*/ 1015792 h 1084222"/>
                <a:gd name="connsiteX8" fmla="*/ 338217 w 833985"/>
                <a:gd name="connsiteY8" fmla="*/ 563526 h 1084222"/>
                <a:gd name="connsiteX0" fmla="*/ 338220 w 833988"/>
                <a:gd name="connsiteY0" fmla="*/ 563526 h 1084222"/>
                <a:gd name="connsiteX1" fmla="*/ 236 w 833988"/>
                <a:gd name="connsiteY1" fmla="*/ 380932 h 1084222"/>
                <a:gd name="connsiteX2" fmla="*/ 444822 w 833988"/>
                <a:gd name="connsiteY2" fmla="*/ 77702 h 1084222"/>
                <a:gd name="connsiteX3" fmla="*/ 657037 w 833988"/>
                <a:gd name="connsiteY3" fmla="*/ 44537 h 1084222"/>
                <a:gd name="connsiteX4" fmla="*/ 833718 w 833988"/>
                <a:gd name="connsiteY4" fmla="*/ 573001 h 1084222"/>
                <a:gd name="connsiteX5" fmla="*/ 724354 w 833988"/>
                <a:gd name="connsiteY5" fmla="*/ 1030005 h 1084222"/>
                <a:gd name="connsiteX6" fmla="*/ 657037 w 833988"/>
                <a:gd name="connsiteY6" fmla="*/ 1077777 h 1084222"/>
                <a:gd name="connsiteX7" fmla="*/ 534841 w 833988"/>
                <a:gd name="connsiteY7" fmla="*/ 1015792 h 1084222"/>
                <a:gd name="connsiteX8" fmla="*/ 554563 w 833988"/>
                <a:gd name="connsiteY8" fmla="*/ 831024 h 1084222"/>
                <a:gd name="connsiteX9" fmla="*/ 338220 w 833988"/>
                <a:gd name="connsiteY9" fmla="*/ 563526 h 1084222"/>
                <a:gd name="connsiteX0" fmla="*/ 338220 w 833988"/>
                <a:gd name="connsiteY0" fmla="*/ 529573 h 1050269"/>
                <a:gd name="connsiteX1" fmla="*/ 236 w 833988"/>
                <a:gd name="connsiteY1" fmla="*/ 346979 h 1050269"/>
                <a:gd name="connsiteX2" fmla="*/ 373755 w 833988"/>
                <a:gd name="connsiteY2" fmla="*/ 204835 h 1050269"/>
                <a:gd name="connsiteX3" fmla="*/ 657037 w 833988"/>
                <a:gd name="connsiteY3" fmla="*/ 10584 h 1050269"/>
                <a:gd name="connsiteX4" fmla="*/ 833718 w 833988"/>
                <a:gd name="connsiteY4" fmla="*/ 539048 h 1050269"/>
                <a:gd name="connsiteX5" fmla="*/ 724354 w 833988"/>
                <a:gd name="connsiteY5" fmla="*/ 996052 h 1050269"/>
                <a:gd name="connsiteX6" fmla="*/ 657037 w 833988"/>
                <a:gd name="connsiteY6" fmla="*/ 1043824 h 1050269"/>
                <a:gd name="connsiteX7" fmla="*/ 534841 w 833988"/>
                <a:gd name="connsiteY7" fmla="*/ 981839 h 1050269"/>
                <a:gd name="connsiteX8" fmla="*/ 554563 w 833988"/>
                <a:gd name="connsiteY8" fmla="*/ 797071 h 1050269"/>
                <a:gd name="connsiteX9" fmla="*/ 338220 w 833988"/>
                <a:gd name="connsiteY9" fmla="*/ 529573 h 1050269"/>
                <a:gd name="connsiteX0" fmla="*/ 338220 w 833988"/>
                <a:gd name="connsiteY0" fmla="*/ 384880 h 905576"/>
                <a:gd name="connsiteX1" fmla="*/ 236 w 833988"/>
                <a:gd name="connsiteY1" fmla="*/ 202286 h 905576"/>
                <a:gd name="connsiteX2" fmla="*/ 373755 w 833988"/>
                <a:gd name="connsiteY2" fmla="*/ 60142 h 905576"/>
                <a:gd name="connsiteX3" fmla="*/ 652300 w 833988"/>
                <a:gd name="connsiteY3" fmla="*/ 36453 h 905576"/>
                <a:gd name="connsiteX4" fmla="*/ 833718 w 833988"/>
                <a:gd name="connsiteY4" fmla="*/ 394355 h 905576"/>
                <a:gd name="connsiteX5" fmla="*/ 724354 w 833988"/>
                <a:gd name="connsiteY5" fmla="*/ 851359 h 905576"/>
                <a:gd name="connsiteX6" fmla="*/ 657037 w 833988"/>
                <a:gd name="connsiteY6" fmla="*/ 899131 h 905576"/>
                <a:gd name="connsiteX7" fmla="*/ 534841 w 833988"/>
                <a:gd name="connsiteY7" fmla="*/ 837146 h 905576"/>
                <a:gd name="connsiteX8" fmla="*/ 554563 w 833988"/>
                <a:gd name="connsiteY8" fmla="*/ 652378 h 905576"/>
                <a:gd name="connsiteX9" fmla="*/ 338220 w 833988"/>
                <a:gd name="connsiteY9" fmla="*/ 384880 h 905576"/>
                <a:gd name="connsiteX0" fmla="*/ 338220 w 833988"/>
                <a:gd name="connsiteY0" fmla="*/ 384880 h 864287"/>
                <a:gd name="connsiteX1" fmla="*/ 236 w 833988"/>
                <a:gd name="connsiteY1" fmla="*/ 202286 h 864287"/>
                <a:gd name="connsiteX2" fmla="*/ 373755 w 833988"/>
                <a:gd name="connsiteY2" fmla="*/ 60142 h 864287"/>
                <a:gd name="connsiteX3" fmla="*/ 652300 w 833988"/>
                <a:gd name="connsiteY3" fmla="*/ 36453 h 864287"/>
                <a:gd name="connsiteX4" fmla="*/ 833718 w 833988"/>
                <a:gd name="connsiteY4" fmla="*/ 394355 h 864287"/>
                <a:gd name="connsiteX5" fmla="*/ 724354 w 833988"/>
                <a:gd name="connsiteY5" fmla="*/ 851359 h 864287"/>
                <a:gd name="connsiteX6" fmla="*/ 652299 w 833988"/>
                <a:gd name="connsiteY6" fmla="*/ 633813 h 864287"/>
                <a:gd name="connsiteX7" fmla="*/ 534841 w 833988"/>
                <a:gd name="connsiteY7" fmla="*/ 837146 h 864287"/>
                <a:gd name="connsiteX8" fmla="*/ 554563 w 833988"/>
                <a:gd name="connsiteY8" fmla="*/ 652378 h 864287"/>
                <a:gd name="connsiteX9" fmla="*/ 338220 w 833988"/>
                <a:gd name="connsiteY9" fmla="*/ 384880 h 864287"/>
                <a:gd name="connsiteX0" fmla="*/ 338220 w 833988"/>
                <a:gd name="connsiteY0" fmla="*/ 384880 h 864287"/>
                <a:gd name="connsiteX1" fmla="*/ 236 w 833988"/>
                <a:gd name="connsiteY1" fmla="*/ 202286 h 864287"/>
                <a:gd name="connsiteX2" fmla="*/ 373755 w 833988"/>
                <a:gd name="connsiteY2" fmla="*/ 60142 h 864287"/>
                <a:gd name="connsiteX3" fmla="*/ 652300 w 833988"/>
                <a:gd name="connsiteY3" fmla="*/ 36453 h 864287"/>
                <a:gd name="connsiteX4" fmla="*/ 833718 w 833988"/>
                <a:gd name="connsiteY4" fmla="*/ 394355 h 864287"/>
                <a:gd name="connsiteX5" fmla="*/ 724354 w 833988"/>
                <a:gd name="connsiteY5" fmla="*/ 851359 h 864287"/>
                <a:gd name="connsiteX6" fmla="*/ 652299 w 833988"/>
                <a:gd name="connsiteY6" fmla="*/ 633813 h 864287"/>
                <a:gd name="connsiteX7" fmla="*/ 534841 w 833988"/>
                <a:gd name="connsiteY7" fmla="*/ 837146 h 864287"/>
                <a:gd name="connsiteX8" fmla="*/ 554563 w 833988"/>
                <a:gd name="connsiteY8" fmla="*/ 652378 h 864287"/>
                <a:gd name="connsiteX9" fmla="*/ 338220 w 833988"/>
                <a:gd name="connsiteY9" fmla="*/ 384880 h 864287"/>
                <a:gd name="connsiteX0" fmla="*/ 338220 w 833988"/>
                <a:gd name="connsiteY0" fmla="*/ 384880 h 864287"/>
                <a:gd name="connsiteX1" fmla="*/ 236 w 833988"/>
                <a:gd name="connsiteY1" fmla="*/ 202286 h 864287"/>
                <a:gd name="connsiteX2" fmla="*/ 373755 w 833988"/>
                <a:gd name="connsiteY2" fmla="*/ 60142 h 864287"/>
                <a:gd name="connsiteX3" fmla="*/ 652300 w 833988"/>
                <a:gd name="connsiteY3" fmla="*/ 36453 h 864287"/>
                <a:gd name="connsiteX4" fmla="*/ 833718 w 833988"/>
                <a:gd name="connsiteY4" fmla="*/ 394355 h 864287"/>
                <a:gd name="connsiteX5" fmla="*/ 724354 w 833988"/>
                <a:gd name="connsiteY5" fmla="*/ 851359 h 864287"/>
                <a:gd name="connsiteX6" fmla="*/ 652299 w 833988"/>
                <a:gd name="connsiteY6" fmla="*/ 633813 h 864287"/>
                <a:gd name="connsiteX7" fmla="*/ 534841 w 833988"/>
                <a:gd name="connsiteY7" fmla="*/ 837146 h 864287"/>
                <a:gd name="connsiteX8" fmla="*/ 554563 w 833988"/>
                <a:gd name="connsiteY8" fmla="*/ 652378 h 864287"/>
                <a:gd name="connsiteX9" fmla="*/ 338220 w 833988"/>
                <a:gd name="connsiteY9" fmla="*/ 384880 h 864287"/>
                <a:gd name="connsiteX0" fmla="*/ 338220 w 833988"/>
                <a:gd name="connsiteY0" fmla="*/ 384880 h 864287"/>
                <a:gd name="connsiteX1" fmla="*/ 236 w 833988"/>
                <a:gd name="connsiteY1" fmla="*/ 202286 h 864287"/>
                <a:gd name="connsiteX2" fmla="*/ 373755 w 833988"/>
                <a:gd name="connsiteY2" fmla="*/ 60142 h 864287"/>
                <a:gd name="connsiteX3" fmla="*/ 652300 w 833988"/>
                <a:gd name="connsiteY3" fmla="*/ 36453 h 864287"/>
                <a:gd name="connsiteX4" fmla="*/ 833718 w 833988"/>
                <a:gd name="connsiteY4" fmla="*/ 394355 h 864287"/>
                <a:gd name="connsiteX5" fmla="*/ 724354 w 833988"/>
                <a:gd name="connsiteY5" fmla="*/ 851359 h 864287"/>
                <a:gd name="connsiteX6" fmla="*/ 652299 w 833988"/>
                <a:gd name="connsiteY6" fmla="*/ 633813 h 864287"/>
                <a:gd name="connsiteX7" fmla="*/ 534841 w 833988"/>
                <a:gd name="connsiteY7" fmla="*/ 837146 h 864287"/>
                <a:gd name="connsiteX8" fmla="*/ 554563 w 833988"/>
                <a:gd name="connsiteY8" fmla="*/ 652378 h 864287"/>
                <a:gd name="connsiteX9" fmla="*/ 338220 w 833988"/>
                <a:gd name="connsiteY9" fmla="*/ 384880 h 864287"/>
                <a:gd name="connsiteX0" fmla="*/ 338220 w 833718"/>
                <a:gd name="connsiteY0" fmla="*/ 384880 h 839923"/>
                <a:gd name="connsiteX1" fmla="*/ 236 w 833718"/>
                <a:gd name="connsiteY1" fmla="*/ 202286 h 839923"/>
                <a:gd name="connsiteX2" fmla="*/ 373755 w 833718"/>
                <a:gd name="connsiteY2" fmla="*/ 60142 h 839923"/>
                <a:gd name="connsiteX3" fmla="*/ 652300 w 833718"/>
                <a:gd name="connsiteY3" fmla="*/ 36453 h 839923"/>
                <a:gd name="connsiteX4" fmla="*/ 833718 w 833718"/>
                <a:gd name="connsiteY4" fmla="*/ 394355 h 839923"/>
                <a:gd name="connsiteX5" fmla="*/ 652299 w 833718"/>
                <a:gd name="connsiteY5" fmla="*/ 633813 h 839923"/>
                <a:gd name="connsiteX6" fmla="*/ 534841 w 833718"/>
                <a:gd name="connsiteY6" fmla="*/ 837146 h 839923"/>
                <a:gd name="connsiteX7" fmla="*/ 554563 w 833718"/>
                <a:gd name="connsiteY7" fmla="*/ 652378 h 839923"/>
                <a:gd name="connsiteX8" fmla="*/ 338220 w 833718"/>
                <a:gd name="connsiteY8" fmla="*/ 384880 h 839923"/>
                <a:gd name="connsiteX0" fmla="*/ 338220 w 836289"/>
                <a:gd name="connsiteY0" fmla="*/ 384880 h 840446"/>
                <a:gd name="connsiteX1" fmla="*/ 236 w 836289"/>
                <a:gd name="connsiteY1" fmla="*/ 202286 h 840446"/>
                <a:gd name="connsiteX2" fmla="*/ 373755 w 836289"/>
                <a:gd name="connsiteY2" fmla="*/ 60142 h 840446"/>
                <a:gd name="connsiteX3" fmla="*/ 652300 w 836289"/>
                <a:gd name="connsiteY3" fmla="*/ 36453 h 840446"/>
                <a:gd name="connsiteX4" fmla="*/ 833718 w 836289"/>
                <a:gd name="connsiteY4" fmla="*/ 394355 h 840446"/>
                <a:gd name="connsiteX5" fmla="*/ 786716 w 836289"/>
                <a:gd name="connsiteY5" fmla="*/ 600262 h 840446"/>
                <a:gd name="connsiteX6" fmla="*/ 652299 w 836289"/>
                <a:gd name="connsiteY6" fmla="*/ 633813 h 840446"/>
                <a:gd name="connsiteX7" fmla="*/ 534841 w 836289"/>
                <a:gd name="connsiteY7" fmla="*/ 837146 h 840446"/>
                <a:gd name="connsiteX8" fmla="*/ 554563 w 836289"/>
                <a:gd name="connsiteY8" fmla="*/ 652378 h 840446"/>
                <a:gd name="connsiteX9" fmla="*/ 338220 w 836289"/>
                <a:gd name="connsiteY9" fmla="*/ 384880 h 840446"/>
                <a:gd name="connsiteX0" fmla="*/ 338220 w 836289"/>
                <a:gd name="connsiteY0" fmla="*/ 384880 h 840446"/>
                <a:gd name="connsiteX1" fmla="*/ 236 w 836289"/>
                <a:gd name="connsiteY1" fmla="*/ 202286 h 840446"/>
                <a:gd name="connsiteX2" fmla="*/ 373755 w 836289"/>
                <a:gd name="connsiteY2" fmla="*/ 60142 h 840446"/>
                <a:gd name="connsiteX3" fmla="*/ 652300 w 836289"/>
                <a:gd name="connsiteY3" fmla="*/ 36453 h 840446"/>
                <a:gd name="connsiteX4" fmla="*/ 833718 w 836289"/>
                <a:gd name="connsiteY4" fmla="*/ 394355 h 840446"/>
                <a:gd name="connsiteX5" fmla="*/ 786716 w 836289"/>
                <a:gd name="connsiteY5" fmla="*/ 600262 h 840446"/>
                <a:gd name="connsiteX6" fmla="*/ 652299 w 836289"/>
                <a:gd name="connsiteY6" fmla="*/ 633813 h 840446"/>
                <a:gd name="connsiteX7" fmla="*/ 534841 w 836289"/>
                <a:gd name="connsiteY7" fmla="*/ 837146 h 840446"/>
                <a:gd name="connsiteX8" fmla="*/ 554563 w 836289"/>
                <a:gd name="connsiteY8" fmla="*/ 652378 h 840446"/>
                <a:gd name="connsiteX9" fmla="*/ 338220 w 836289"/>
                <a:gd name="connsiteY9" fmla="*/ 384880 h 840446"/>
                <a:gd name="connsiteX0" fmla="*/ 338220 w 836289"/>
                <a:gd name="connsiteY0" fmla="*/ 384880 h 840446"/>
                <a:gd name="connsiteX1" fmla="*/ 236 w 836289"/>
                <a:gd name="connsiteY1" fmla="*/ 202286 h 840446"/>
                <a:gd name="connsiteX2" fmla="*/ 373755 w 836289"/>
                <a:gd name="connsiteY2" fmla="*/ 60142 h 840446"/>
                <a:gd name="connsiteX3" fmla="*/ 652300 w 836289"/>
                <a:gd name="connsiteY3" fmla="*/ 36453 h 840446"/>
                <a:gd name="connsiteX4" fmla="*/ 833718 w 836289"/>
                <a:gd name="connsiteY4" fmla="*/ 394355 h 840446"/>
                <a:gd name="connsiteX5" fmla="*/ 786716 w 836289"/>
                <a:gd name="connsiteY5" fmla="*/ 600262 h 840446"/>
                <a:gd name="connsiteX6" fmla="*/ 652299 w 836289"/>
                <a:gd name="connsiteY6" fmla="*/ 633813 h 840446"/>
                <a:gd name="connsiteX7" fmla="*/ 534841 w 836289"/>
                <a:gd name="connsiteY7" fmla="*/ 837146 h 840446"/>
                <a:gd name="connsiteX8" fmla="*/ 554563 w 836289"/>
                <a:gd name="connsiteY8" fmla="*/ 652378 h 840446"/>
                <a:gd name="connsiteX9" fmla="*/ 338220 w 836289"/>
                <a:gd name="connsiteY9" fmla="*/ 384880 h 840446"/>
                <a:gd name="connsiteX0" fmla="*/ 338220 w 836289"/>
                <a:gd name="connsiteY0" fmla="*/ 384880 h 668364"/>
                <a:gd name="connsiteX1" fmla="*/ 236 w 836289"/>
                <a:gd name="connsiteY1" fmla="*/ 202286 h 668364"/>
                <a:gd name="connsiteX2" fmla="*/ 373755 w 836289"/>
                <a:gd name="connsiteY2" fmla="*/ 60142 h 668364"/>
                <a:gd name="connsiteX3" fmla="*/ 652300 w 836289"/>
                <a:gd name="connsiteY3" fmla="*/ 36453 h 668364"/>
                <a:gd name="connsiteX4" fmla="*/ 833718 w 836289"/>
                <a:gd name="connsiteY4" fmla="*/ 394355 h 668364"/>
                <a:gd name="connsiteX5" fmla="*/ 786716 w 836289"/>
                <a:gd name="connsiteY5" fmla="*/ 600262 h 668364"/>
                <a:gd name="connsiteX6" fmla="*/ 652299 w 836289"/>
                <a:gd name="connsiteY6" fmla="*/ 633813 h 668364"/>
                <a:gd name="connsiteX7" fmla="*/ 554563 w 836289"/>
                <a:gd name="connsiteY7" fmla="*/ 652378 h 668364"/>
                <a:gd name="connsiteX8" fmla="*/ 338220 w 836289"/>
                <a:gd name="connsiteY8" fmla="*/ 384880 h 668364"/>
                <a:gd name="connsiteX0" fmla="*/ 338221 w 836290"/>
                <a:gd name="connsiteY0" fmla="*/ 384880 h 634420"/>
                <a:gd name="connsiteX1" fmla="*/ 237 w 836290"/>
                <a:gd name="connsiteY1" fmla="*/ 202286 h 634420"/>
                <a:gd name="connsiteX2" fmla="*/ 373756 w 836290"/>
                <a:gd name="connsiteY2" fmla="*/ 60142 h 634420"/>
                <a:gd name="connsiteX3" fmla="*/ 652301 w 836290"/>
                <a:gd name="connsiteY3" fmla="*/ 36453 h 634420"/>
                <a:gd name="connsiteX4" fmla="*/ 833719 w 836290"/>
                <a:gd name="connsiteY4" fmla="*/ 394355 h 634420"/>
                <a:gd name="connsiteX5" fmla="*/ 786717 w 836290"/>
                <a:gd name="connsiteY5" fmla="*/ 600262 h 634420"/>
                <a:gd name="connsiteX6" fmla="*/ 652300 w 836290"/>
                <a:gd name="connsiteY6" fmla="*/ 633813 h 634420"/>
                <a:gd name="connsiteX7" fmla="*/ 559302 w 836290"/>
                <a:gd name="connsiteY7" fmla="*/ 600262 h 634420"/>
                <a:gd name="connsiteX8" fmla="*/ 338221 w 836290"/>
                <a:gd name="connsiteY8" fmla="*/ 384880 h 634420"/>
                <a:gd name="connsiteX0" fmla="*/ 338221 w 836290"/>
                <a:gd name="connsiteY0" fmla="*/ 384880 h 615692"/>
                <a:gd name="connsiteX1" fmla="*/ 237 w 836290"/>
                <a:gd name="connsiteY1" fmla="*/ 202286 h 615692"/>
                <a:gd name="connsiteX2" fmla="*/ 373756 w 836290"/>
                <a:gd name="connsiteY2" fmla="*/ 60142 h 615692"/>
                <a:gd name="connsiteX3" fmla="*/ 652301 w 836290"/>
                <a:gd name="connsiteY3" fmla="*/ 36453 h 615692"/>
                <a:gd name="connsiteX4" fmla="*/ 833719 w 836290"/>
                <a:gd name="connsiteY4" fmla="*/ 394355 h 615692"/>
                <a:gd name="connsiteX5" fmla="*/ 786717 w 836290"/>
                <a:gd name="connsiteY5" fmla="*/ 600262 h 615692"/>
                <a:gd name="connsiteX6" fmla="*/ 675989 w 836290"/>
                <a:gd name="connsiteY6" fmla="*/ 586434 h 615692"/>
                <a:gd name="connsiteX7" fmla="*/ 559302 w 836290"/>
                <a:gd name="connsiteY7" fmla="*/ 600262 h 615692"/>
                <a:gd name="connsiteX8" fmla="*/ 338221 w 836290"/>
                <a:gd name="connsiteY8" fmla="*/ 384880 h 615692"/>
                <a:gd name="connsiteX0" fmla="*/ 338221 w 836290"/>
                <a:gd name="connsiteY0" fmla="*/ 384880 h 615951"/>
                <a:gd name="connsiteX1" fmla="*/ 237 w 836290"/>
                <a:gd name="connsiteY1" fmla="*/ 202286 h 615951"/>
                <a:gd name="connsiteX2" fmla="*/ 373756 w 836290"/>
                <a:gd name="connsiteY2" fmla="*/ 60142 h 615951"/>
                <a:gd name="connsiteX3" fmla="*/ 652301 w 836290"/>
                <a:gd name="connsiteY3" fmla="*/ 36453 h 615951"/>
                <a:gd name="connsiteX4" fmla="*/ 833719 w 836290"/>
                <a:gd name="connsiteY4" fmla="*/ 394355 h 615951"/>
                <a:gd name="connsiteX5" fmla="*/ 786717 w 836290"/>
                <a:gd name="connsiteY5" fmla="*/ 590786 h 615951"/>
                <a:gd name="connsiteX6" fmla="*/ 675989 w 836290"/>
                <a:gd name="connsiteY6" fmla="*/ 586434 h 615951"/>
                <a:gd name="connsiteX7" fmla="*/ 559302 w 836290"/>
                <a:gd name="connsiteY7" fmla="*/ 600262 h 615951"/>
                <a:gd name="connsiteX8" fmla="*/ 338221 w 836290"/>
                <a:gd name="connsiteY8" fmla="*/ 384880 h 615951"/>
                <a:gd name="connsiteX0" fmla="*/ 338221 w 837635"/>
                <a:gd name="connsiteY0" fmla="*/ 384880 h 621747"/>
                <a:gd name="connsiteX1" fmla="*/ 237 w 837635"/>
                <a:gd name="connsiteY1" fmla="*/ 202286 h 621747"/>
                <a:gd name="connsiteX2" fmla="*/ 373756 w 837635"/>
                <a:gd name="connsiteY2" fmla="*/ 60142 h 621747"/>
                <a:gd name="connsiteX3" fmla="*/ 652301 w 837635"/>
                <a:gd name="connsiteY3" fmla="*/ 36453 h 621747"/>
                <a:gd name="connsiteX4" fmla="*/ 833719 w 837635"/>
                <a:gd name="connsiteY4" fmla="*/ 394355 h 621747"/>
                <a:gd name="connsiteX5" fmla="*/ 786717 w 837635"/>
                <a:gd name="connsiteY5" fmla="*/ 590786 h 621747"/>
                <a:gd name="connsiteX6" fmla="*/ 559302 w 837635"/>
                <a:gd name="connsiteY6" fmla="*/ 600262 h 621747"/>
                <a:gd name="connsiteX7" fmla="*/ 338221 w 837635"/>
                <a:gd name="connsiteY7" fmla="*/ 384880 h 62174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37635" h="621747">
                  <a:moveTo>
                    <a:pt x="338221" y="384880"/>
                  </a:moveTo>
                  <a:cubicBezTo>
                    <a:pt x="245044" y="318551"/>
                    <a:pt x="-8844" y="279309"/>
                    <a:pt x="237" y="202286"/>
                  </a:cubicBezTo>
                  <a:cubicBezTo>
                    <a:pt x="9318" y="125264"/>
                    <a:pt x="327460" y="131211"/>
                    <a:pt x="373756" y="60142"/>
                  </a:cubicBezTo>
                  <a:cubicBezTo>
                    <a:pt x="420052" y="-10927"/>
                    <a:pt x="575641" y="-19249"/>
                    <a:pt x="652301" y="36453"/>
                  </a:cubicBezTo>
                  <a:cubicBezTo>
                    <a:pt x="728961" y="92155"/>
                    <a:pt x="822371" y="305125"/>
                    <a:pt x="833719" y="394355"/>
                  </a:cubicBezTo>
                  <a:cubicBezTo>
                    <a:pt x="845067" y="483585"/>
                    <a:pt x="832453" y="556468"/>
                    <a:pt x="786717" y="590786"/>
                  </a:cubicBezTo>
                  <a:cubicBezTo>
                    <a:pt x="740981" y="625104"/>
                    <a:pt x="634051" y="634580"/>
                    <a:pt x="559302" y="600262"/>
                  </a:cubicBezTo>
                  <a:cubicBezTo>
                    <a:pt x="484553" y="565944"/>
                    <a:pt x="431398" y="451209"/>
                    <a:pt x="338221" y="384880"/>
                  </a:cubicBezTo>
                  <a:close/>
                </a:path>
              </a:pathLst>
            </a:cu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Textfeld 10"/>
            <p:cNvSpPr txBox="1"/>
            <p:nvPr/>
          </p:nvSpPr>
          <p:spPr>
            <a:xfrm>
              <a:off x="2430083" y="2787536"/>
              <a:ext cx="479618" cy="184666"/>
            </a:xfrm>
            <a:prstGeom prst="rect">
              <a:avLst/>
            </a:prstGeom>
            <a:noFill/>
          </p:spPr>
          <p:txBody>
            <a:bodyPr wrap="none" rtlCol="0">
              <a:spAutoFit/>
            </a:bodyPr>
            <a:lstStyle/>
            <a:p>
              <a:r>
                <a:rPr lang="en-US" sz="600" dirty="0" smtClean="0">
                  <a:solidFill>
                    <a:srgbClr val="FF0000"/>
                  </a:solidFill>
                  <a:latin typeface="Arial" panose="020B0604020202020204" pitchFamily="34" charset="0"/>
                  <a:cs typeface="Arial" panose="020B0604020202020204" pitchFamily="34" charset="0"/>
                </a:rPr>
                <a:t>MECOM</a:t>
              </a:r>
              <a:endParaRPr lang="en-US" sz="600" dirty="0">
                <a:solidFill>
                  <a:srgbClr val="FF0000"/>
                </a:solidFill>
                <a:latin typeface="Arial" panose="020B0604020202020204" pitchFamily="34" charset="0"/>
                <a:cs typeface="Arial" panose="020B0604020202020204" pitchFamily="34" charset="0"/>
              </a:endParaRPr>
            </a:p>
          </p:txBody>
        </p:sp>
        <p:sp>
          <p:nvSpPr>
            <p:cNvPr id="42" name="Textfeld 11"/>
            <p:cNvSpPr txBox="1"/>
            <p:nvPr/>
          </p:nvSpPr>
          <p:spPr>
            <a:xfrm>
              <a:off x="1667385" y="2835996"/>
              <a:ext cx="377026" cy="184666"/>
            </a:xfrm>
            <a:prstGeom prst="rect">
              <a:avLst/>
            </a:prstGeom>
            <a:noFill/>
          </p:spPr>
          <p:txBody>
            <a:bodyPr wrap="none" rtlCol="0">
              <a:spAutoFit/>
            </a:bodyPr>
            <a:lstStyle/>
            <a:p>
              <a:r>
                <a:rPr lang="en-US" sz="600" dirty="0" smtClean="0">
                  <a:solidFill>
                    <a:srgbClr val="FF0000"/>
                  </a:solidFill>
                  <a:latin typeface="Arial" panose="020B0604020202020204" pitchFamily="34" charset="0"/>
                  <a:cs typeface="Arial" panose="020B0604020202020204" pitchFamily="34" charset="0"/>
                </a:rPr>
                <a:t>TBX3</a:t>
              </a:r>
              <a:endParaRPr lang="en-US" sz="600" dirty="0">
                <a:solidFill>
                  <a:srgbClr val="FF0000"/>
                </a:solidFill>
                <a:latin typeface="Arial" panose="020B0604020202020204" pitchFamily="34" charset="0"/>
                <a:cs typeface="Arial" panose="020B0604020202020204" pitchFamily="34" charset="0"/>
              </a:endParaRPr>
            </a:p>
          </p:txBody>
        </p:sp>
        <p:sp>
          <p:nvSpPr>
            <p:cNvPr id="43" name="Textfeld 12"/>
            <p:cNvSpPr txBox="1"/>
            <p:nvPr/>
          </p:nvSpPr>
          <p:spPr>
            <a:xfrm>
              <a:off x="1892710" y="3028819"/>
              <a:ext cx="474810" cy="184666"/>
            </a:xfrm>
            <a:prstGeom prst="rect">
              <a:avLst/>
            </a:prstGeom>
            <a:noFill/>
          </p:spPr>
          <p:txBody>
            <a:bodyPr wrap="none" rtlCol="0">
              <a:spAutoFit/>
            </a:bodyPr>
            <a:lstStyle/>
            <a:p>
              <a:r>
                <a:rPr lang="en-US" sz="600" dirty="0" smtClean="0">
                  <a:solidFill>
                    <a:srgbClr val="FF0000"/>
                  </a:solidFill>
                  <a:latin typeface="Arial" panose="020B0604020202020204" pitchFamily="34" charset="0"/>
                  <a:cs typeface="Arial" panose="020B0604020202020204" pitchFamily="34" charset="0"/>
                </a:rPr>
                <a:t>TFAP2A</a:t>
              </a:r>
              <a:endParaRPr lang="en-US" sz="600" dirty="0">
                <a:solidFill>
                  <a:srgbClr val="FF0000"/>
                </a:solidFill>
                <a:latin typeface="Arial" panose="020B0604020202020204" pitchFamily="34" charset="0"/>
                <a:cs typeface="Arial" panose="020B0604020202020204" pitchFamily="34" charset="0"/>
              </a:endParaRPr>
            </a:p>
          </p:txBody>
        </p:sp>
        <p:sp>
          <p:nvSpPr>
            <p:cNvPr id="44" name="Textfeld 13"/>
            <p:cNvSpPr txBox="1"/>
            <p:nvPr/>
          </p:nvSpPr>
          <p:spPr>
            <a:xfrm>
              <a:off x="2268118" y="3308114"/>
              <a:ext cx="445956" cy="184666"/>
            </a:xfrm>
            <a:prstGeom prst="rect">
              <a:avLst/>
            </a:prstGeom>
            <a:noFill/>
          </p:spPr>
          <p:txBody>
            <a:bodyPr wrap="none" rtlCol="0">
              <a:spAutoFit/>
            </a:bodyPr>
            <a:lstStyle/>
            <a:p>
              <a:r>
                <a:rPr lang="en-US" sz="600" dirty="0" smtClean="0">
                  <a:solidFill>
                    <a:srgbClr val="FF0000"/>
                  </a:solidFill>
                  <a:latin typeface="Arial" panose="020B0604020202020204" pitchFamily="34" charset="0"/>
                  <a:cs typeface="Arial" panose="020B0604020202020204" pitchFamily="34" charset="0"/>
                </a:rPr>
                <a:t>HOXB8</a:t>
              </a:r>
              <a:endParaRPr lang="en-US" sz="600" dirty="0">
                <a:solidFill>
                  <a:srgbClr val="FF0000"/>
                </a:solidFill>
                <a:latin typeface="Arial" panose="020B0604020202020204" pitchFamily="34" charset="0"/>
                <a:cs typeface="Arial" panose="020B0604020202020204" pitchFamily="34" charset="0"/>
              </a:endParaRPr>
            </a:p>
          </p:txBody>
        </p:sp>
        <p:sp>
          <p:nvSpPr>
            <p:cNvPr id="45" name="Textfeld 14"/>
            <p:cNvSpPr txBox="1"/>
            <p:nvPr/>
          </p:nvSpPr>
          <p:spPr>
            <a:xfrm>
              <a:off x="2175450" y="3199851"/>
              <a:ext cx="445956" cy="184666"/>
            </a:xfrm>
            <a:prstGeom prst="rect">
              <a:avLst/>
            </a:prstGeom>
            <a:noFill/>
          </p:spPr>
          <p:txBody>
            <a:bodyPr wrap="none" rtlCol="0">
              <a:spAutoFit/>
            </a:bodyPr>
            <a:lstStyle/>
            <a:p>
              <a:r>
                <a:rPr lang="en-US" sz="600" dirty="0" smtClean="0">
                  <a:solidFill>
                    <a:srgbClr val="FF0000"/>
                  </a:solidFill>
                  <a:latin typeface="Arial" panose="020B0604020202020204" pitchFamily="34" charset="0"/>
                  <a:cs typeface="Arial" panose="020B0604020202020204" pitchFamily="34" charset="0"/>
                </a:rPr>
                <a:t>HOXA2</a:t>
              </a:r>
              <a:endParaRPr lang="en-US" sz="600" dirty="0">
                <a:solidFill>
                  <a:srgbClr val="FF0000"/>
                </a:solidFill>
                <a:latin typeface="Arial" panose="020B0604020202020204" pitchFamily="34" charset="0"/>
                <a:cs typeface="Arial" panose="020B0604020202020204" pitchFamily="34" charset="0"/>
              </a:endParaRPr>
            </a:p>
          </p:txBody>
        </p:sp>
        <p:sp>
          <p:nvSpPr>
            <p:cNvPr id="46" name="Textfeld 15"/>
            <p:cNvSpPr txBox="1"/>
            <p:nvPr/>
          </p:nvSpPr>
          <p:spPr>
            <a:xfrm>
              <a:off x="2120280" y="2898721"/>
              <a:ext cx="445956" cy="184666"/>
            </a:xfrm>
            <a:prstGeom prst="rect">
              <a:avLst/>
            </a:prstGeom>
            <a:noFill/>
          </p:spPr>
          <p:txBody>
            <a:bodyPr wrap="none" rtlCol="0">
              <a:spAutoFit/>
            </a:bodyPr>
            <a:lstStyle/>
            <a:p>
              <a:r>
                <a:rPr lang="en-US" sz="600" dirty="0" smtClean="0">
                  <a:solidFill>
                    <a:srgbClr val="FF0000"/>
                  </a:solidFill>
                  <a:latin typeface="Arial" panose="020B0604020202020204" pitchFamily="34" charset="0"/>
                  <a:cs typeface="Arial" panose="020B0604020202020204" pitchFamily="34" charset="0"/>
                </a:rPr>
                <a:t>HOXA5</a:t>
              </a:r>
              <a:endParaRPr lang="en-US" sz="600" dirty="0">
                <a:solidFill>
                  <a:srgbClr val="FF0000"/>
                </a:solidFill>
                <a:latin typeface="Arial" panose="020B0604020202020204" pitchFamily="34" charset="0"/>
                <a:cs typeface="Arial" panose="020B0604020202020204" pitchFamily="34" charset="0"/>
              </a:endParaRPr>
            </a:p>
          </p:txBody>
        </p:sp>
        <p:sp>
          <p:nvSpPr>
            <p:cNvPr id="47" name="Textfeld 16"/>
            <p:cNvSpPr txBox="1"/>
            <p:nvPr/>
          </p:nvSpPr>
          <p:spPr>
            <a:xfrm>
              <a:off x="2267444" y="3081826"/>
              <a:ext cx="445956" cy="184666"/>
            </a:xfrm>
            <a:prstGeom prst="rect">
              <a:avLst/>
            </a:prstGeom>
            <a:noFill/>
          </p:spPr>
          <p:txBody>
            <a:bodyPr wrap="none" rtlCol="0">
              <a:spAutoFit/>
            </a:bodyPr>
            <a:lstStyle/>
            <a:p>
              <a:r>
                <a:rPr lang="en-US" sz="600" dirty="0" smtClean="0">
                  <a:solidFill>
                    <a:srgbClr val="FF0000"/>
                  </a:solidFill>
                  <a:latin typeface="Arial" panose="020B0604020202020204" pitchFamily="34" charset="0"/>
                  <a:cs typeface="Arial" panose="020B0604020202020204" pitchFamily="34" charset="0"/>
                </a:rPr>
                <a:t>HOXA3</a:t>
              </a:r>
              <a:endParaRPr lang="en-US" sz="600" dirty="0">
                <a:solidFill>
                  <a:srgbClr val="FF0000"/>
                </a:solidFill>
                <a:latin typeface="Arial" panose="020B0604020202020204" pitchFamily="34" charset="0"/>
                <a:cs typeface="Arial" panose="020B0604020202020204" pitchFamily="34" charset="0"/>
              </a:endParaRPr>
            </a:p>
          </p:txBody>
        </p:sp>
        <p:sp>
          <p:nvSpPr>
            <p:cNvPr id="48" name="Textfeld 17"/>
            <p:cNvSpPr txBox="1"/>
            <p:nvPr/>
          </p:nvSpPr>
          <p:spPr>
            <a:xfrm>
              <a:off x="1625872" y="1752600"/>
              <a:ext cx="431528" cy="184666"/>
            </a:xfrm>
            <a:prstGeom prst="rect">
              <a:avLst/>
            </a:prstGeom>
            <a:noFill/>
          </p:spPr>
          <p:txBody>
            <a:bodyPr wrap="none" rtlCol="0">
              <a:spAutoFit/>
            </a:bodyPr>
            <a:lstStyle/>
            <a:p>
              <a:r>
                <a:rPr lang="en-US" sz="600" dirty="0" smtClean="0">
                  <a:solidFill>
                    <a:srgbClr val="FF0000"/>
                  </a:solidFill>
                  <a:latin typeface="Arial" panose="020B0604020202020204" pitchFamily="34" charset="0"/>
                  <a:cs typeface="Arial" panose="020B0604020202020204" pitchFamily="34" charset="0"/>
                </a:rPr>
                <a:t>FOXF1</a:t>
              </a:r>
              <a:endParaRPr lang="en-US" sz="600" dirty="0">
                <a:solidFill>
                  <a:srgbClr val="FF0000"/>
                </a:solidFill>
                <a:latin typeface="Arial" panose="020B0604020202020204" pitchFamily="34" charset="0"/>
                <a:cs typeface="Arial" panose="020B0604020202020204" pitchFamily="34" charset="0"/>
              </a:endParaRPr>
            </a:p>
          </p:txBody>
        </p:sp>
        <p:sp>
          <p:nvSpPr>
            <p:cNvPr id="49" name="Textfeld 18"/>
            <p:cNvSpPr txBox="1"/>
            <p:nvPr/>
          </p:nvSpPr>
          <p:spPr>
            <a:xfrm>
              <a:off x="990600" y="1872734"/>
              <a:ext cx="442750" cy="184666"/>
            </a:xfrm>
            <a:prstGeom prst="rect">
              <a:avLst/>
            </a:prstGeom>
            <a:noFill/>
          </p:spPr>
          <p:txBody>
            <a:bodyPr wrap="none" rtlCol="0">
              <a:spAutoFit/>
            </a:bodyPr>
            <a:lstStyle/>
            <a:p>
              <a:r>
                <a:rPr lang="en-US" sz="600" dirty="0" smtClean="0">
                  <a:solidFill>
                    <a:srgbClr val="FF0000"/>
                  </a:solidFill>
                  <a:latin typeface="Arial" panose="020B0604020202020204" pitchFamily="34" charset="0"/>
                  <a:cs typeface="Arial" panose="020B0604020202020204" pitchFamily="34" charset="0"/>
                </a:rPr>
                <a:t>PRRX1</a:t>
              </a:r>
              <a:endParaRPr lang="en-US" sz="600" dirty="0">
                <a:solidFill>
                  <a:srgbClr val="FF0000"/>
                </a:solidFill>
                <a:latin typeface="Arial" panose="020B0604020202020204" pitchFamily="34" charset="0"/>
                <a:cs typeface="Arial" panose="020B0604020202020204" pitchFamily="34" charset="0"/>
              </a:endParaRPr>
            </a:p>
          </p:txBody>
        </p:sp>
        <p:sp>
          <p:nvSpPr>
            <p:cNvPr id="50" name="Textfeld 19"/>
            <p:cNvSpPr txBox="1"/>
            <p:nvPr/>
          </p:nvSpPr>
          <p:spPr>
            <a:xfrm>
              <a:off x="1295400" y="2038840"/>
              <a:ext cx="420308" cy="184666"/>
            </a:xfrm>
            <a:prstGeom prst="rect">
              <a:avLst/>
            </a:prstGeom>
            <a:noFill/>
          </p:spPr>
          <p:txBody>
            <a:bodyPr wrap="none" rtlCol="0">
              <a:spAutoFit/>
            </a:bodyPr>
            <a:lstStyle/>
            <a:p>
              <a:r>
                <a:rPr lang="en-US" sz="600" dirty="0" smtClean="0">
                  <a:solidFill>
                    <a:srgbClr val="FF0000"/>
                  </a:solidFill>
                  <a:latin typeface="Arial" panose="020B0604020202020204" pitchFamily="34" charset="0"/>
                  <a:cs typeface="Arial" panose="020B0604020202020204" pitchFamily="34" charset="0"/>
                </a:rPr>
                <a:t>ZNF25</a:t>
              </a:r>
              <a:endParaRPr lang="en-US" sz="600" dirty="0">
                <a:solidFill>
                  <a:srgbClr val="FF0000"/>
                </a:solidFill>
                <a:latin typeface="Arial" panose="020B0604020202020204" pitchFamily="34" charset="0"/>
                <a:cs typeface="Arial" panose="020B0604020202020204" pitchFamily="34" charset="0"/>
              </a:endParaRPr>
            </a:p>
          </p:txBody>
        </p:sp>
        <p:sp>
          <p:nvSpPr>
            <p:cNvPr id="51" name="Textfeld 20"/>
            <p:cNvSpPr txBox="1"/>
            <p:nvPr/>
          </p:nvSpPr>
          <p:spPr>
            <a:xfrm>
              <a:off x="1442275" y="2141853"/>
              <a:ext cx="377026" cy="184666"/>
            </a:xfrm>
            <a:prstGeom prst="rect">
              <a:avLst/>
            </a:prstGeom>
            <a:noFill/>
          </p:spPr>
          <p:txBody>
            <a:bodyPr wrap="none" rtlCol="0">
              <a:spAutoFit/>
            </a:bodyPr>
            <a:lstStyle/>
            <a:p>
              <a:r>
                <a:rPr lang="en-US" sz="600" dirty="0" smtClean="0">
                  <a:solidFill>
                    <a:srgbClr val="FF0000"/>
                  </a:solidFill>
                  <a:latin typeface="Arial" panose="020B0604020202020204" pitchFamily="34" charset="0"/>
                  <a:cs typeface="Arial" panose="020B0604020202020204" pitchFamily="34" charset="0"/>
                </a:rPr>
                <a:t>EBF1</a:t>
              </a:r>
              <a:endParaRPr lang="en-US" sz="600" dirty="0">
                <a:solidFill>
                  <a:srgbClr val="FF0000"/>
                </a:solidFill>
                <a:latin typeface="Arial" panose="020B0604020202020204" pitchFamily="34" charset="0"/>
                <a:cs typeface="Arial" panose="020B0604020202020204" pitchFamily="34" charset="0"/>
              </a:endParaRPr>
            </a:p>
          </p:txBody>
        </p:sp>
        <p:sp>
          <p:nvSpPr>
            <p:cNvPr id="52" name="Textfeld 21"/>
            <p:cNvSpPr txBox="1"/>
            <p:nvPr/>
          </p:nvSpPr>
          <p:spPr>
            <a:xfrm>
              <a:off x="1409504" y="2294248"/>
              <a:ext cx="359394" cy="184666"/>
            </a:xfrm>
            <a:prstGeom prst="rect">
              <a:avLst/>
            </a:prstGeom>
            <a:noFill/>
          </p:spPr>
          <p:txBody>
            <a:bodyPr wrap="none" rtlCol="0">
              <a:spAutoFit/>
            </a:bodyPr>
            <a:lstStyle/>
            <a:p>
              <a:r>
                <a:rPr lang="en-US" sz="600" dirty="0" smtClean="0">
                  <a:solidFill>
                    <a:srgbClr val="FF0000"/>
                  </a:solidFill>
                  <a:latin typeface="Arial" panose="020B0604020202020204" pitchFamily="34" charset="0"/>
                  <a:cs typeface="Arial" panose="020B0604020202020204" pitchFamily="34" charset="0"/>
                </a:rPr>
                <a:t>NFIA</a:t>
              </a:r>
              <a:endParaRPr lang="en-US" sz="600" dirty="0">
                <a:solidFill>
                  <a:srgbClr val="FF0000"/>
                </a:solidFill>
                <a:latin typeface="Arial" panose="020B0604020202020204" pitchFamily="34" charset="0"/>
                <a:cs typeface="Arial" panose="020B0604020202020204" pitchFamily="34" charset="0"/>
              </a:endParaRPr>
            </a:p>
          </p:txBody>
        </p:sp>
        <p:sp>
          <p:nvSpPr>
            <p:cNvPr id="53" name="Textfeld 22"/>
            <p:cNvSpPr txBox="1"/>
            <p:nvPr/>
          </p:nvSpPr>
          <p:spPr>
            <a:xfrm>
              <a:off x="1371600" y="2536278"/>
              <a:ext cx="436338" cy="184666"/>
            </a:xfrm>
            <a:prstGeom prst="rect">
              <a:avLst/>
            </a:prstGeom>
            <a:noFill/>
          </p:spPr>
          <p:txBody>
            <a:bodyPr wrap="none" rtlCol="0">
              <a:spAutoFit/>
            </a:bodyPr>
            <a:lstStyle/>
            <a:p>
              <a:r>
                <a:rPr lang="en-US" sz="600" dirty="0" smtClean="0">
                  <a:solidFill>
                    <a:srgbClr val="FF0000"/>
                  </a:solidFill>
                  <a:latin typeface="Arial" panose="020B0604020202020204" pitchFamily="34" charset="0"/>
                  <a:cs typeface="Arial" panose="020B0604020202020204" pitchFamily="34" charset="0"/>
                </a:rPr>
                <a:t>ZFPM2</a:t>
              </a:r>
              <a:endParaRPr lang="en-US" sz="600" dirty="0">
                <a:solidFill>
                  <a:srgbClr val="FF0000"/>
                </a:solidFill>
                <a:latin typeface="Arial" panose="020B0604020202020204" pitchFamily="34" charset="0"/>
                <a:cs typeface="Arial" panose="020B0604020202020204" pitchFamily="34" charset="0"/>
              </a:endParaRPr>
            </a:p>
          </p:txBody>
        </p:sp>
        <p:sp>
          <p:nvSpPr>
            <p:cNvPr id="54" name="Textfeld 23"/>
            <p:cNvSpPr txBox="1"/>
            <p:nvPr/>
          </p:nvSpPr>
          <p:spPr>
            <a:xfrm>
              <a:off x="1409896" y="2632214"/>
              <a:ext cx="407484" cy="184666"/>
            </a:xfrm>
            <a:prstGeom prst="rect">
              <a:avLst/>
            </a:prstGeom>
            <a:noFill/>
          </p:spPr>
          <p:txBody>
            <a:bodyPr wrap="none" rtlCol="0">
              <a:spAutoFit/>
            </a:bodyPr>
            <a:lstStyle/>
            <a:p>
              <a:r>
                <a:rPr lang="en-US" sz="600" dirty="0" smtClean="0">
                  <a:solidFill>
                    <a:srgbClr val="FF0000"/>
                  </a:solidFill>
                  <a:latin typeface="Arial" panose="020B0604020202020204" pitchFamily="34" charset="0"/>
                  <a:cs typeface="Arial" panose="020B0604020202020204" pitchFamily="34" charset="0"/>
                </a:rPr>
                <a:t>SNAI2</a:t>
              </a:r>
              <a:endParaRPr lang="en-US" sz="600" dirty="0">
                <a:solidFill>
                  <a:srgbClr val="FF0000"/>
                </a:solidFill>
                <a:latin typeface="Arial" panose="020B0604020202020204" pitchFamily="34" charset="0"/>
                <a:cs typeface="Arial" panose="020B0604020202020204" pitchFamily="34" charset="0"/>
              </a:endParaRPr>
            </a:p>
          </p:txBody>
        </p:sp>
        <p:sp>
          <p:nvSpPr>
            <p:cNvPr id="55" name="Textfeld 24"/>
            <p:cNvSpPr txBox="1"/>
            <p:nvPr/>
          </p:nvSpPr>
          <p:spPr>
            <a:xfrm>
              <a:off x="1363602" y="2852714"/>
              <a:ext cx="373820" cy="184666"/>
            </a:xfrm>
            <a:prstGeom prst="rect">
              <a:avLst/>
            </a:prstGeom>
            <a:noFill/>
          </p:spPr>
          <p:txBody>
            <a:bodyPr wrap="none" rtlCol="0">
              <a:spAutoFit/>
            </a:bodyPr>
            <a:lstStyle/>
            <a:p>
              <a:r>
                <a:rPr lang="en-US" sz="600" dirty="0" smtClean="0">
                  <a:solidFill>
                    <a:srgbClr val="FF0000"/>
                  </a:solidFill>
                  <a:latin typeface="Arial" panose="020B0604020202020204" pitchFamily="34" charset="0"/>
                  <a:cs typeface="Arial" panose="020B0604020202020204" pitchFamily="34" charset="0"/>
                </a:rPr>
                <a:t>LEP1</a:t>
              </a:r>
              <a:endParaRPr lang="en-US" sz="600" dirty="0">
                <a:solidFill>
                  <a:srgbClr val="FF0000"/>
                </a:solidFill>
                <a:latin typeface="Arial" panose="020B0604020202020204" pitchFamily="34" charset="0"/>
                <a:cs typeface="Arial" panose="020B0604020202020204" pitchFamily="34" charset="0"/>
              </a:endParaRPr>
            </a:p>
          </p:txBody>
        </p:sp>
        <p:sp>
          <p:nvSpPr>
            <p:cNvPr id="56" name="Textfeld 25"/>
            <p:cNvSpPr txBox="1"/>
            <p:nvPr/>
          </p:nvSpPr>
          <p:spPr>
            <a:xfrm>
              <a:off x="2130263" y="3138101"/>
              <a:ext cx="450764" cy="184666"/>
            </a:xfrm>
            <a:prstGeom prst="rect">
              <a:avLst/>
            </a:prstGeom>
            <a:noFill/>
          </p:spPr>
          <p:txBody>
            <a:bodyPr wrap="none" rtlCol="0">
              <a:spAutoFit/>
            </a:bodyPr>
            <a:lstStyle/>
            <a:p>
              <a:r>
                <a:rPr lang="en-US" sz="600" dirty="0" smtClean="0">
                  <a:solidFill>
                    <a:srgbClr val="FF0000"/>
                  </a:solidFill>
                  <a:latin typeface="Arial" panose="020B0604020202020204" pitchFamily="34" charset="0"/>
                  <a:cs typeface="Arial" panose="020B0604020202020204" pitchFamily="34" charset="0"/>
                </a:rPr>
                <a:t>HOXC6</a:t>
              </a:r>
              <a:endParaRPr lang="en-US" sz="600" dirty="0">
                <a:solidFill>
                  <a:srgbClr val="FF0000"/>
                </a:solidFill>
                <a:latin typeface="Arial" panose="020B0604020202020204" pitchFamily="34" charset="0"/>
                <a:cs typeface="Arial" panose="020B0604020202020204" pitchFamily="34" charset="0"/>
              </a:endParaRPr>
            </a:p>
          </p:txBody>
        </p:sp>
        <p:sp>
          <p:nvSpPr>
            <p:cNvPr id="57" name="Textfeld 26"/>
            <p:cNvSpPr txBox="1"/>
            <p:nvPr/>
          </p:nvSpPr>
          <p:spPr>
            <a:xfrm>
              <a:off x="2084086" y="2974203"/>
              <a:ext cx="445956" cy="184666"/>
            </a:xfrm>
            <a:prstGeom prst="rect">
              <a:avLst/>
            </a:prstGeom>
            <a:noFill/>
          </p:spPr>
          <p:txBody>
            <a:bodyPr wrap="none" rtlCol="0">
              <a:spAutoFit/>
            </a:bodyPr>
            <a:lstStyle/>
            <a:p>
              <a:r>
                <a:rPr lang="en-US" sz="600" dirty="0" smtClean="0">
                  <a:solidFill>
                    <a:srgbClr val="FF0000"/>
                  </a:solidFill>
                  <a:latin typeface="Arial" panose="020B0604020202020204" pitchFamily="34" charset="0"/>
                  <a:cs typeface="Arial" panose="020B0604020202020204" pitchFamily="34" charset="0"/>
                </a:rPr>
                <a:t>HOXB6</a:t>
              </a:r>
              <a:endParaRPr lang="en-US" sz="600" dirty="0">
                <a:solidFill>
                  <a:srgbClr val="FF0000"/>
                </a:solidFill>
                <a:latin typeface="Arial" panose="020B0604020202020204" pitchFamily="34" charset="0"/>
                <a:cs typeface="Arial" panose="020B0604020202020204" pitchFamily="34" charset="0"/>
              </a:endParaRPr>
            </a:p>
          </p:txBody>
        </p:sp>
      </p:grpSp>
      <p:sp>
        <p:nvSpPr>
          <p:cNvPr id="58" name="Textfeld 31"/>
          <p:cNvSpPr txBox="1"/>
          <p:nvPr/>
        </p:nvSpPr>
        <p:spPr>
          <a:xfrm>
            <a:off x="316503" y="1475601"/>
            <a:ext cx="1055097" cy="276999"/>
          </a:xfrm>
          <a:prstGeom prst="rect">
            <a:avLst/>
          </a:prstGeom>
          <a:noFill/>
        </p:spPr>
        <p:txBody>
          <a:bodyPr wrap="none" rtlCol="0">
            <a:spAutoFit/>
          </a:bodyPr>
          <a:lstStyle/>
          <a:p>
            <a:r>
              <a:rPr lang="en-US" sz="1200" dirty="0" smtClean="0">
                <a:solidFill>
                  <a:srgbClr val="FF0000"/>
                </a:solidFill>
                <a:latin typeface="Arial" panose="020B0604020202020204" pitchFamily="34" charset="0"/>
                <a:cs typeface="Arial" panose="020B0604020202020204" pitchFamily="34" charset="0"/>
              </a:rPr>
              <a:t>UKK specific</a:t>
            </a:r>
            <a:endParaRPr lang="en-US" sz="1200" dirty="0">
              <a:solidFill>
                <a:srgbClr val="FF0000"/>
              </a:solidFill>
              <a:latin typeface="Arial" panose="020B0604020202020204" pitchFamily="34" charset="0"/>
              <a:cs typeface="Arial" panose="020B0604020202020204" pitchFamily="34" charset="0"/>
            </a:endParaRPr>
          </a:p>
        </p:txBody>
      </p:sp>
      <p:grpSp>
        <p:nvGrpSpPr>
          <p:cNvPr id="60" name="Group 59"/>
          <p:cNvGrpSpPr/>
          <p:nvPr/>
        </p:nvGrpSpPr>
        <p:grpSpPr>
          <a:xfrm>
            <a:off x="137165" y="4343400"/>
            <a:ext cx="4434835" cy="4320000"/>
            <a:chOff x="1257300" y="4572000"/>
            <a:chExt cx="4434835" cy="4320000"/>
          </a:xfrm>
        </p:grpSpPr>
        <p:pic>
          <p:nvPicPr>
            <p:cNvPr id="61" name="Grafik 3"/>
            <p:cNvPicPr>
              <a:picLocks noChangeAspect="1"/>
            </p:cNvPicPr>
            <p:nvPr/>
          </p:nvPicPr>
          <p:blipFill>
            <a:blip r:embed="rId3"/>
            <a:stretch>
              <a:fillRect/>
            </a:stretch>
          </p:blipFill>
          <p:spPr>
            <a:xfrm>
              <a:off x="1257300" y="4572000"/>
              <a:ext cx="4434835" cy="4320000"/>
            </a:xfrm>
            <a:prstGeom prst="rect">
              <a:avLst/>
            </a:prstGeom>
          </p:spPr>
        </p:pic>
        <p:sp>
          <p:nvSpPr>
            <p:cNvPr id="62" name="Ellipse 8"/>
            <p:cNvSpPr/>
            <p:nvPr/>
          </p:nvSpPr>
          <p:spPr>
            <a:xfrm>
              <a:off x="2765999" y="5446303"/>
              <a:ext cx="2690334" cy="1640298"/>
            </a:xfrm>
            <a:custGeom>
              <a:avLst/>
              <a:gdLst>
                <a:gd name="connsiteX0" fmla="*/ 0 w 533400"/>
                <a:gd name="connsiteY0" fmla="*/ 495300 h 990600"/>
                <a:gd name="connsiteX1" fmla="*/ 266700 w 533400"/>
                <a:gd name="connsiteY1" fmla="*/ 0 h 990600"/>
                <a:gd name="connsiteX2" fmla="*/ 533400 w 533400"/>
                <a:gd name="connsiteY2" fmla="*/ 495300 h 990600"/>
                <a:gd name="connsiteX3" fmla="*/ 266700 w 533400"/>
                <a:gd name="connsiteY3" fmla="*/ 990600 h 990600"/>
                <a:gd name="connsiteX4" fmla="*/ 0 w 533400"/>
                <a:gd name="connsiteY4" fmla="*/ 495300 h 990600"/>
                <a:gd name="connsiteX0" fmla="*/ 12658 w 546058"/>
                <a:gd name="connsiteY0" fmla="*/ 540687 h 1035987"/>
                <a:gd name="connsiteX1" fmla="*/ 67143 w 546058"/>
                <a:gd name="connsiteY1" fmla="*/ 78552 h 1035987"/>
                <a:gd name="connsiteX2" fmla="*/ 279358 w 546058"/>
                <a:gd name="connsiteY2" fmla="*/ 45387 h 1035987"/>
                <a:gd name="connsiteX3" fmla="*/ 546058 w 546058"/>
                <a:gd name="connsiteY3" fmla="*/ 540687 h 1035987"/>
                <a:gd name="connsiteX4" fmla="*/ 279358 w 546058"/>
                <a:gd name="connsiteY4" fmla="*/ 1035987 h 1035987"/>
                <a:gd name="connsiteX5" fmla="*/ 12658 w 546058"/>
                <a:gd name="connsiteY5" fmla="*/ 540687 h 1035987"/>
                <a:gd name="connsiteX0" fmla="*/ 4363 w 537763"/>
                <a:gd name="connsiteY0" fmla="*/ 540687 h 1087741"/>
                <a:gd name="connsiteX1" fmla="*/ 58848 w 537763"/>
                <a:gd name="connsiteY1" fmla="*/ 78552 h 1087741"/>
                <a:gd name="connsiteX2" fmla="*/ 271063 w 537763"/>
                <a:gd name="connsiteY2" fmla="*/ 45387 h 1087741"/>
                <a:gd name="connsiteX3" fmla="*/ 537763 w 537763"/>
                <a:gd name="connsiteY3" fmla="*/ 540687 h 1087741"/>
                <a:gd name="connsiteX4" fmla="*/ 271063 w 537763"/>
                <a:gd name="connsiteY4" fmla="*/ 1035987 h 1087741"/>
                <a:gd name="connsiteX5" fmla="*/ 148867 w 537763"/>
                <a:gd name="connsiteY5" fmla="*/ 1016642 h 1087741"/>
                <a:gd name="connsiteX6" fmla="*/ 4363 w 537763"/>
                <a:gd name="connsiteY6" fmla="*/ 540687 h 1087741"/>
                <a:gd name="connsiteX0" fmla="*/ 4363 w 447744"/>
                <a:gd name="connsiteY0" fmla="*/ 543064 h 1087858"/>
                <a:gd name="connsiteX1" fmla="*/ 58848 w 447744"/>
                <a:gd name="connsiteY1" fmla="*/ 80929 h 1087858"/>
                <a:gd name="connsiteX2" fmla="*/ 271063 w 447744"/>
                <a:gd name="connsiteY2" fmla="*/ 47764 h 1087858"/>
                <a:gd name="connsiteX3" fmla="*/ 447744 w 447744"/>
                <a:gd name="connsiteY3" fmla="*/ 576228 h 1087858"/>
                <a:gd name="connsiteX4" fmla="*/ 271063 w 447744"/>
                <a:gd name="connsiteY4" fmla="*/ 1038364 h 1087858"/>
                <a:gd name="connsiteX5" fmla="*/ 148867 w 447744"/>
                <a:gd name="connsiteY5" fmla="*/ 1019019 h 1087858"/>
                <a:gd name="connsiteX6" fmla="*/ 4363 w 447744"/>
                <a:gd name="connsiteY6" fmla="*/ 543064 h 1087858"/>
                <a:gd name="connsiteX0" fmla="*/ 4363 w 448014"/>
                <a:gd name="connsiteY0" fmla="*/ 543064 h 1069417"/>
                <a:gd name="connsiteX1" fmla="*/ 58848 w 448014"/>
                <a:gd name="connsiteY1" fmla="*/ 80929 h 1069417"/>
                <a:gd name="connsiteX2" fmla="*/ 271063 w 448014"/>
                <a:gd name="connsiteY2" fmla="*/ 47764 h 1069417"/>
                <a:gd name="connsiteX3" fmla="*/ 447744 w 448014"/>
                <a:gd name="connsiteY3" fmla="*/ 576228 h 1069417"/>
                <a:gd name="connsiteX4" fmla="*/ 338380 w 448014"/>
                <a:gd name="connsiteY4" fmla="*/ 1033232 h 1069417"/>
                <a:gd name="connsiteX5" fmla="*/ 271063 w 448014"/>
                <a:gd name="connsiteY5" fmla="*/ 1038364 h 1069417"/>
                <a:gd name="connsiteX6" fmla="*/ 148867 w 448014"/>
                <a:gd name="connsiteY6" fmla="*/ 1019019 h 1069417"/>
                <a:gd name="connsiteX7" fmla="*/ 4363 w 448014"/>
                <a:gd name="connsiteY7" fmla="*/ 543064 h 1069417"/>
                <a:gd name="connsiteX0" fmla="*/ 4363 w 448014"/>
                <a:gd name="connsiteY0" fmla="*/ 543064 h 1087449"/>
                <a:gd name="connsiteX1" fmla="*/ 58848 w 448014"/>
                <a:gd name="connsiteY1" fmla="*/ 80929 h 1087449"/>
                <a:gd name="connsiteX2" fmla="*/ 271063 w 448014"/>
                <a:gd name="connsiteY2" fmla="*/ 47764 h 1087449"/>
                <a:gd name="connsiteX3" fmla="*/ 447744 w 448014"/>
                <a:gd name="connsiteY3" fmla="*/ 576228 h 1087449"/>
                <a:gd name="connsiteX4" fmla="*/ 338380 w 448014"/>
                <a:gd name="connsiteY4" fmla="*/ 1033232 h 1087449"/>
                <a:gd name="connsiteX5" fmla="*/ 271063 w 448014"/>
                <a:gd name="connsiteY5" fmla="*/ 1081004 h 1087449"/>
                <a:gd name="connsiteX6" fmla="*/ 148867 w 448014"/>
                <a:gd name="connsiteY6" fmla="*/ 1019019 h 1087449"/>
                <a:gd name="connsiteX7" fmla="*/ 4363 w 448014"/>
                <a:gd name="connsiteY7" fmla="*/ 543064 h 1087449"/>
                <a:gd name="connsiteX0" fmla="*/ 4363 w 447804"/>
                <a:gd name="connsiteY0" fmla="*/ 510146 h 1054531"/>
                <a:gd name="connsiteX1" fmla="*/ 58848 w 447804"/>
                <a:gd name="connsiteY1" fmla="*/ 48011 h 1054531"/>
                <a:gd name="connsiteX2" fmla="*/ 271063 w 447804"/>
                <a:gd name="connsiteY2" fmla="*/ 14846 h 1054531"/>
                <a:gd name="connsiteX3" fmla="*/ 352567 w 447804"/>
                <a:gd name="connsiteY3" fmla="*/ 51397 h 1054531"/>
                <a:gd name="connsiteX4" fmla="*/ 447744 w 447804"/>
                <a:gd name="connsiteY4" fmla="*/ 543310 h 1054531"/>
                <a:gd name="connsiteX5" fmla="*/ 338380 w 447804"/>
                <a:gd name="connsiteY5" fmla="*/ 1000314 h 1054531"/>
                <a:gd name="connsiteX6" fmla="*/ 271063 w 447804"/>
                <a:gd name="connsiteY6" fmla="*/ 1048086 h 1054531"/>
                <a:gd name="connsiteX7" fmla="*/ 148867 w 447804"/>
                <a:gd name="connsiteY7" fmla="*/ 986101 h 1054531"/>
                <a:gd name="connsiteX8" fmla="*/ 4363 w 447804"/>
                <a:gd name="connsiteY8" fmla="*/ 510146 h 1054531"/>
                <a:gd name="connsiteX0" fmla="*/ 4363 w 447804"/>
                <a:gd name="connsiteY0" fmla="*/ 988238 h 1532623"/>
                <a:gd name="connsiteX1" fmla="*/ 58848 w 447804"/>
                <a:gd name="connsiteY1" fmla="*/ 526103 h 1532623"/>
                <a:gd name="connsiteX2" fmla="*/ 169953 w 447804"/>
                <a:gd name="connsiteY2" fmla="*/ 55 h 1532623"/>
                <a:gd name="connsiteX3" fmla="*/ 271063 w 447804"/>
                <a:gd name="connsiteY3" fmla="*/ 492938 h 1532623"/>
                <a:gd name="connsiteX4" fmla="*/ 352567 w 447804"/>
                <a:gd name="connsiteY4" fmla="*/ 529489 h 1532623"/>
                <a:gd name="connsiteX5" fmla="*/ 447744 w 447804"/>
                <a:gd name="connsiteY5" fmla="*/ 1021402 h 1532623"/>
                <a:gd name="connsiteX6" fmla="*/ 338380 w 447804"/>
                <a:gd name="connsiteY6" fmla="*/ 1478406 h 1532623"/>
                <a:gd name="connsiteX7" fmla="*/ 271063 w 447804"/>
                <a:gd name="connsiteY7" fmla="*/ 1526178 h 1532623"/>
                <a:gd name="connsiteX8" fmla="*/ 148867 w 447804"/>
                <a:gd name="connsiteY8" fmla="*/ 1464193 h 1532623"/>
                <a:gd name="connsiteX9" fmla="*/ 4363 w 447804"/>
                <a:gd name="connsiteY9" fmla="*/ 988238 h 1532623"/>
                <a:gd name="connsiteX0" fmla="*/ 4363 w 447804"/>
                <a:gd name="connsiteY0" fmla="*/ 997693 h 1542078"/>
                <a:gd name="connsiteX1" fmla="*/ 58848 w 447804"/>
                <a:gd name="connsiteY1" fmla="*/ 535558 h 1542078"/>
                <a:gd name="connsiteX2" fmla="*/ 88142 w 447804"/>
                <a:gd name="connsiteY2" fmla="*/ 176701 h 1542078"/>
                <a:gd name="connsiteX3" fmla="*/ 169953 w 447804"/>
                <a:gd name="connsiteY3" fmla="*/ 9510 h 1542078"/>
                <a:gd name="connsiteX4" fmla="*/ 271063 w 447804"/>
                <a:gd name="connsiteY4" fmla="*/ 502393 h 1542078"/>
                <a:gd name="connsiteX5" fmla="*/ 352567 w 447804"/>
                <a:gd name="connsiteY5" fmla="*/ 538944 h 1542078"/>
                <a:gd name="connsiteX6" fmla="*/ 447744 w 447804"/>
                <a:gd name="connsiteY6" fmla="*/ 1030857 h 1542078"/>
                <a:gd name="connsiteX7" fmla="*/ 338380 w 447804"/>
                <a:gd name="connsiteY7" fmla="*/ 1487861 h 1542078"/>
                <a:gd name="connsiteX8" fmla="*/ 271063 w 447804"/>
                <a:gd name="connsiteY8" fmla="*/ 1535633 h 1542078"/>
                <a:gd name="connsiteX9" fmla="*/ 148867 w 447804"/>
                <a:gd name="connsiteY9" fmla="*/ 1473648 h 1542078"/>
                <a:gd name="connsiteX10" fmla="*/ 4363 w 447804"/>
                <a:gd name="connsiteY10" fmla="*/ 997693 h 1542078"/>
                <a:gd name="connsiteX0" fmla="*/ 12212 w 455653"/>
                <a:gd name="connsiteY0" fmla="*/ 997693 h 1542078"/>
                <a:gd name="connsiteX1" fmla="*/ 14180 w 455653"/>
                <a:gd name="connsiteY1" fmla="*/ 538944 h 1542078"/>
                <a:gd name="connsiteX2" fmla="*/ 66697 w 455653"/>
                <a:gd name="connsiteY2" fmla="*/ 535558 h 1542078"/>
                <a:gd name="connsiteX3" fmla="*/ 95991 w 455653"/>
                <a:gd name="connsiteY3" fmla="*/ 176701 h 1542078"/>
                <a:gd name="connsiteX4" fmla="*/ 177802 w 455653"/>
                <a:gd name="connsiteY4" fmla="*/ 9510 h 1542078"/>
                <a:gd name="connsiteX5" fmla="*/ 278912 w 455653"/>
                <a:gd name="connsiteY5" fmla="*/ 502393 h 1542078"/>
                <a:gd name="connsiteX6" fmla="*/ 360416 w 455653"/>
                <a:gd name="connsiteY6" fmla="*/ 538944 h 1542078"/>
                <a:gd name="connsiteX7" fmla="*/ 455593 w 455653"/>
                <a:gd name="connsiteY7" fmla="*/ 1030857 h 1542078"/>
                <a:gd name="connsiteX8" fmla="*/ 346229 w 455653"/>
                <a:gd name="connsiteY8" fmla="*/ 1487861 h 1542078"/>
                <a:gd name="connsiteX9" fmla="*/ 278912 w 455653"/>
                <a:gd name="connsiteY9" fmla="*/ 1535633 h 1542078"/>
                <a:gd name="connsiteX10" fmla="*/ 156716 w 455653"/>
                <a:gd name="connsiteY10" fmla="*/ 1473648 h 1542078"/>
                <a:gd name="connsiteX11" fmla="*/ 12212 w 455653"/>
                <a:gd name="connsiteY11" fmla="*/ 997693 h 1542078"/>
                <a:gd name="connsiteX0" fmla="*/ 12212 w 455653"/>
                <a:gd name="connsiteY0" fmla="*/ 997693 h 1542078"/>
                <a:gd name="connsiteX1" fmla="*/ 14180 w 455653"/>
                <a:gd name="connsiteY1" fmla="*/ 538944 h 1542078"/>
                <a:gd name="connsiteX2" fmla="*/ 55010 w 455653"/>
                <a:gd name="connsiteY2" fmla="*/ 442676 h 1542078"/>
                <a:gd name="connsiteX3" fmla="*/ 95991 w 455653"/>
                <a:gd name="connsiteY3" fmla="*/ 176701 h 1542078"/>
                <a:gd name="connsiteX4" fmla="*/ 177802 w 455653"/>
                <a:gd name="connsiteY4" fmla="*/ 9510 h 1542078"/>
                <a:gd name="connsiteX5" fmla="*/ 278912 w 455653"/>
                <a:gd name="connsiteY5" fmla="*/ 502393 h 1542078"/>
                <a:gd name="connsiteX6" fmla="*/ 360416 w 455653"/>
                <a:gd name="connsiteY6" fmla="*/ 538944 h 1542078"/>
                <a:gd name="connsiteX7" fmla="*/ 455593 w 455653"/>
                <a:gd name="connsiteY7" fmla="*/ 1030857 h 1542078"/>
                <a:gd name="connsiteX8" fmla="*/ 346229 w 455653"/>
                <a:gd name="connsiteY8" fmla="*/ 1487861 h 1542078"/>
                <a:gd name="connsiteX9" fmla="*/ 278912 w 455653"/>
                <a:gd name="connsiteY9" fmla="*/ 1535633 h 1542078"/>
                <a:gd name="connsiteX10" fmla="*/ 156716 w 455653"/>
                <a:gd name="connsiteY10" fmla="*/ 1473648 h 1542078"/>
                <a:gd name="connsiteX11" fmla="*/ 12212 w 455653"/>
                <a:gd name="connsiteY11" fmla="*/ 997693 h 1542078"/>
                <a:gd name="connsiteX0" fmla="*/ 12212 w 455653"/>
                <a:gd name="connsiteY0" fmla="*/ 988500 h 1532885"/>
                <a:gd name="connsiteX1" fmla="*/ 14180 w 455653"/>
                <a:gd name="connsiteY1" fmla="*/ 529751 h 1532885"/>
                <a:gd name="connsiteX2" fmla="*/ 55010 w 455653"/>
                <a:gd name="connsiteY2" fmla="*/ 433483 h 1532885"/>
                <a:gd name="connsiteX3" fmla="*/ 95991 w 455653"/>
                <a:gd name="connsiteY3" fmla="*/ 167508 h 1532885"/>
                <a:gd name="connsiteX4" fmla="*/ 177802 w 455653"/>
                <a:gd name="connsiteY4" fmla="*/ 317 h 1532885"/>
                <a:gd name="connsiteX5" fmla="*/ 227474 w 455653"/>
                <a:gd name="connsiteY5" fmla="*/ 158220 h 1532885"/>
                <a:gd name="connsiteX6" fmla="*/ 278912 w 455653"/>
                <a:gd name="connsiteY6" fmla="*/ 493200 h 1532885"/>
                <a:gd name="connsiteX7" fmla="*/ 360416 w 455653"/>
                <a:gd name="connsiteY7" fmla="*/ 529751 h 1532885"/>
                <a:gd name="connsiteX8" fmla="*/ 455593 w 455653"/>
                <a:gd name="connsiteY8" fmla="*/ 1021664 h 1532885"/>
                <a:gd name="connsiteX9" fmla="*/ 346229 w 455653"/>
                <a:gd name="connsiteY9" fmla="*/ 1478668 h 1532885"/>
                <a:gd name="connsiteX10" fmla="*/ 278912 w 455653"/>
                <a:gd name="connsiteY10" fmla="*/ 1526440 h 1532885"/>
                <a:gd name="connsiteX11" fmla="*/ 156716 w 455653"/>
                <a:gd name="connsiteY11" fmla="*/ 1464455 h 1532885"/>
                <a:gd name="connsiteX12" fmla="*/ 12212 w 455653"/>
                <a:gd name="connsiteY12" fmla="*/ 988500 h 1532885"/>
                <a:gd name="connsiteX0" fmla="*/ 12212 w 395442"/>
                <a:gd name="connsiteY0" fmla="*/ 988500 h 1532885"/>
                <a:gd name="connsiteX1" fmla="*/ 14180 w 395442"/>
                <a:gd name="connsiteY1" fmla="*/ 529751 h 1532885"/>
                <a:gd name="connsiteX2" fmla="*/ 55010 w 395442"/>
                <a:gd name="connsiteY2" fmla="*/ 433483 h 1532885"/>
                <a:gd name="connsiteX3" fmla="*/ 95991 w 395442"/>
                <a:gd name="connsiteY3" fmla="*/ 167508 h 1532885"/>
                <a:gd name="connsiteX4" fmla="*/ 177802 w 395442"/>
                <a:gd name="connsiteY4" fmla="*/ 317 h 1532885"/>
                <a:gd name="connsiteX5" fmla="*/ 227474 w 395442"/>
                <a:gd name="connsiteY5" fmla="*/ 158220 h 1532885"/>
                <a:gd name="connsiteX6" fmla="*/ 278912 w 395442"/>
                <a:gd name="connsiteY6" fmla="*/ 493200 h 1532885"/>
                <a:gd name="connsiteX7" fmla="*/ 360416 w 395442"/>
                <a:gd name="connsiteY7" fmla="*/ 529751 h 1532885"/>
                <a:gd name="connsiteX8" fmla="*/ 395037 w 395442"/>
                <a:gd name="connsiteY8" fmla="*/ 1181300 h 1532885"/>
                <a:gd name="connsiteX9" fmla="*/ 346229 w 395442"/>
                <a:gd name="connsiteY9" fmla="*/ 1478668 h 1532885"/>
                <a:gd name="connsiteX10" fmla="*/ 278912 w 395442"/>
                <a:gd name="connsiteY10" fmla="*/ 1526440 h 1532885"/>
                <a:gd name="connsiteX11" fmla="*/ 156716 w 395442"/>
                <a:gd name="connsiteY11" fmla="*/ 1464455 h 1532885"/>
                <a:gd name="connsiteX12" fmla="*/ 12212 w 395442"/>
                <a:gd name="connsiteY12" fmla="*/ 988500 h 153288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395442" h="1532885">
                  <a:moveTo>
                    <a:pt x="12212" y="988500"/>
                  </a:moveTo>
                  <a:cubicBezTo>
                    <a:pt x="-11544" y="832716"/>
                    <a:pt x="5099" y="606774"/>
                    <a:pt x="14180" y="529751"/>
                  </a:cubicBezTo>
                  <a:cubicBezTo>
                    <a:pt x="23261" y="452729"/>
                    <a:pt x="45758" y="506241"/>
                    <a:pt x="55010" y="433483"/>
                  </a:cubicBezTo>
                  <a:cubicBezTo>
                    <a:pt x="73356" y="305939"/>
                    <a:pt x="77474" y="255183"/>
                    <a:pt x="95991" y="167508"/>
                  </a:cubicBezTo>
                  <a:cubicBezTo>
                    <a:pt x="114508" y="79833"/>
                    <a:pt x="156862" y="-5875"/>
                    <a:pt x="177802" y="317"/>
                  </a:cubicBezTo>
                  <a:cubicBezTo>
                    <a:pt x="198742" y="6509"/>
                    <a:pt x="210622" y="76073"/>
                    <a:pt x="227474" y="158220"/>
                  </a:cubicBezTo>
                  <a:cubicBezTo>
                    <a:pt x="244326" y="240367"/>
                    <a:pt x="256755" y="431278"/>
                    <a:pt x="278912" y="493200"/>
                  </a:cubicBezTo>
                  <a:cubicBezTo>
                    <a:pt x="301069" y="555122"/>
                    <a:pt x="330969" y="441674"/>
                    <a:pt x="360416" y="529751"/>
                  </a:cubicBezTo>
                  <a:cubicBezTo>
                    <a:pt x="389863" y="617828"/>
                    <a:pt x="397402" y="1040176"/>
                    <a:pt x="395037" y="1181300"/>
                  </a:cubicBezTo>
                  <a:cubicBezTo>
                    <a:pt x="392673" y="1322424"/>
                    <a:pt x="375676" y="1401645"/>
                    <a:pt x="346229" y="1478668"/>
                  </a:cubicBezTo>
                  <a:cubicBezTo>
                    <a:pt x="316782" y="1555691"/>
                    <a:pt x="310497" y="1528809"/>
                    <a:pt x="278912" y="1526440"/>
                  </a:cubicBezTo>
                  <a:cubicBezTo>
                    <a:pt x="247327" y="1524071"/>
                    <a:pt x="201166" y="1547005"/>
                    <a:pt x="156716" y="1464455"/>
                  </a:cubicBezTo>
                  <a:cubicBezTo>
                    <a:pt x="112266" y="1381905"/>
                    <a:pt x="35968" y="1144284"/>
                    <a:pt x="12212" y="988500"/>
                  </a:cubicBezTo>
                  <a:close/>
                </a:path>
              </a:pathLst>
            </a:custGeom>
            <a:noFill/>
            <a:ln>
              <a:solidFill>
                <a:srgbClr val="00009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9" name="Textfeld 28"/>
          <p:cNvSpPr txBox="1"/>
          <p:nvPr/>
        </p:nvSpPr>
        <p:spPr>
          <a:xfrm>
            <a:off x="228600" y="228600"/>
            <a:ext cx="1290738" cy="307777"/>
          </a:xfrm>
          <a:prstGeom prst="rect">
            <a:avLst/>
          </a:prstGeom>
          <a:noFill/>
        </p:spPr>
        <p:txBody>
          <a:bodyPr wrap="none" rtlCol="0">
            <a:spAutoFit/>
          </a:bodyPr>
          <a:lstStyle/>
          <a:p>
            <a:r>
              <a:rPr lang="en-US" sz="1400" dirty="0" smtClean="0">
                <a:latin typeface="Arial" panose="020B0604020202020204" pitchFamily="34" charset="0"/>
                <a:cs typeface="Arial" panose="020B0604020202020204" pitchFamily="34" charset="0"/>
              </a:rPr>
              <a:t>UKK mapping</a:t>
            </a:r>
            <a:endParaRPr lang="en-US" sz="1400" dirty="0">
              <a:latin typeface="Arial" panose="020B0604020202020204" pitchFamily="34" charset="0"/>
              <a:cs typeface="Arial" panose="020B0604020202020204" pitchFamily="34" charset="0"/>
            </a:endParaRPr>
          </a:p>
        </p:txBody>
      </p:sp>
      <p:sp>
        <p:nvSpPr>
          <p:cNvPr id="36" name="Rechteck 35"/>
          <p:cNvSpPr/>
          <p:nvPr/>
        </p:nvSpPr>
        <p:spPr>
          <a:xfrm>
            <a:off x="2618248" y="8623756"/>
            <a:ext cx="1725152" cy="215444"/>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Cut off: Fold change &gt; 5; p &lt; 0:05</a:t>
            </a:r>
            <a:endParaRPr lang="en-US" dirty="0"/>
          </a:p>
        </p:txBody>
      </p:sp>
      <p:sp>
        <p:nvSpPr>
          <p:cNvPr id="63" name="Textfeld 30"/>
          <p:cNvSpPr txBox="1"/>
          <p:nvPr/>
        </p:nvSpPr>
        <p:spPr>
          <a:xfrm>
            <a:off x="3810000" y="4876800"/>
            <a:ext cx="1148071" cy="276999"/>
          </a:xfrm>
          <a:prstGeom prst="rect">
            <a:avLst/>
          </a:prstGeom>
          <a:noFill/>
        </p:spPr>
        <p:txBody>
          <a:bodyPr wrap="none" rtlCol="0">
            <a:spAutoFit/>
          </a:bodyPr>
          <a:lstStyle/>
          <a:p>
            <a:r>
              <a:rPr lang="en-US" sz="1200" dirty="0" smtClean="0">
                <a:solidFill>
                  <a:srgbClr val="000099"/>
                </a:solidFill>
                <a:latin typeface="Arial" panose="020B0604020202020204" pitchFamily="34" charset="0"/>
                <a:cs typeface="Arial" panose="020B0604020202020204" pitchFamily="34" charset="0"/>
              </a:rPr>
              <a:t>UKN1 specific</a:t>
            </a:r>
            <a:endParaRPr lang="en-US" sz="1200" dirty="0">
              <a:solidFill>
                <a:srgbClr val="000099"/>
              </a:solidFill>
              <a:latin typeface="Arial" panose="020B0604020202020204" pitchFamily="34" charset="0"/>
              <a:cs typeface="Arial" panose="020B0604020202020204" pitchFamily="34" charset="0"/>
            </a:endParaRPr>
          </a:p>
        </p:txBody>
      </p:sp>
      <p:sp>
        <p:nvSpPr>
          <p:cNvPr id="30" name="Textfeld 29"/>
          <p:cNvSpPr txBox="1"/>
          <p:nvPr/>
        </p:nvSpPr>
        <p:spPr>
          <a:xfrm>
            <a:off x="276658" y="4035623"/>
            <a:ext cx="1399742" cy="307777"/>
          </a:xfrm>
          <a:prstGeom prst="rect">
            <a:avLst/>
          </a:prstGeom>
          <a:noFill/>
        </p:spPr>
        <p:txBody>
          <a:bodyPr wrap="none" rtlCol="0">
            <a:spAutoFit/>
          </a:bodyPr>
          <a:lstStyle/>
          <a:p>
            <a:r>
              <a:rPr lang="en-US" sz="1400" dirty="0" smtClean="0">
                <a:latin typeface="Arial" panose="020B0604020202020204" pitchFamily="34" charset="0"/>
                <a:cs typeface="Arial" panose="020B0604020202020204" pitchFamily="34" charset="0"/>
              </a:rPr>
              <a:t>UKN1 mapping</a:t>
            </a:r>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321628722"/>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609</TotalTime>
  <Words>1272</Words>
  <Application>Microsoft Office PowerPoint</Application>
  <PresentationFormat>On-screen Show (4:3)</PresentationFormat>
  <Paragraphs>78</Paragraphs>
  <Slides>7</Slides>
  <Notes>0</Notes>
  <HiddenSlides>0</HiddenSlides>
  <MMClips>0</MMClips>
  <ScaleCrop>false</ScaleCrop>
  <HeadingPairs>
    <vt:vector size="4" baseType="variant">
      <vt:variant>
        <vt:lpstr>Theme</vt:lpstr>
      </vt:variant>
      <vt:variant>
        <vt:i4>1</vt:i4>
      </vt:variant>
      <vt:variant>
        <vt:lpstr>Slide Titles</vt:lpstr>
      </vt:variant>
      <vt:variant>
        <vt:i4>7</vt:i4>
      </vt:variant>
    </vt:vector>
  </HeadingPairs>
  <TitlesOfParts>
    <vt:vector size="8"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dministrator</dc:creator>
  <cp:lastModifiedBy>Administrator</cp:lastModifiedBy>
  <cp:revision>1711</cp:revision>
  <cp:lastPrinted>2016-04-27T09:39:13Z</cp:lastPrinted>
  <dcterms:created xsi:type="dcterms:W3CDTF">2015-04-14T16:22:30Z</dcterms:created>
  <dcterms:modified xsi:type="dcterms:W3CDTF">2016-04-28T15:43:57Z</dcterms:modified>
</cp:coreProperties>
</file>